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6" r:id="rId3"/>
    <p:sldId id="267" r:id="rId4"/>
    <p:sldId id="268" r:id="rId5"/>
    <p:sldId id="269" r:id="rId6"/>
    <p:sldId id="281" r:id="rId7"/>
    <p:sldId id="282" r:id="rId8"/>
    <p:sldId id="270" r:id="rId9"/>
    <p:sldId id="271" r:id="rId10"/>
    <p:sldId id="272" r:id="rId11"/>
    <p:sldId id="273" r:id="rId12"/>
    <p:sldId id="277" r:id="rId13"/>
    <p:sldId id="274" r:id="rId14"/>
    <p:sldId id="278" r:id="rId15"/>
    <p:sldId id="279" r:id="rId16"/>
    <p:sldId id="275" r:id="rId17"/>
    <p:sldId id="276" r:id="rId18"/>
  </p:sldIdLst>
  <p:sldSz cx="144002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63" d="100"/>
          <a:sy n="63" d="100"/>
        </p:scale>
        <p:origin x="173" y="-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767462"/>
            <a:ext cx="12240181" cy="375991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672376"/>
            <a:ext cx="10800160" cy="260744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011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744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74987"/>
            <a:ext cx="3105046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74987"/>
            <a:ext cx="9135135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17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169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692444"/>
            <a:ext cx="12420184" cy="44924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227345"/>
            <a:ext cx="12420184" cy="236244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289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874937"/>
            <a:ext cx="6120091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874937"/>
            <a:ext cx="6120091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395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74990"/>
            <a:ext cx="12420184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647443"/>
            <a:ext cx="6091964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3944914"/>
            <a:ext cx="6091964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647443"/>
            <a:ext cx="6121966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3944914"/>
            <a:ext cx="612196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364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361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5097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554968"/>
            <a:ext cx="7290108" cy="767483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855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554968"/>
            <a:ext cx="7290108" cy="767483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592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74990"/>
            <a:ext cx="12420184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874937"/>
            <a:ext cx="12420184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3B05B-25EF-4B0E-96E6-E43D15BC9808}" type="datetimeFigureOut">
              <a:rPr kumimoji="1" lang="ja-JP" altLang="en-US" smtClean="0"/>
              <a:t>2020/12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009783"/>
            <a:ext cx="48600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974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1" name="図 320">
            <a:extLst>
              <a:ext uri="{FF2B5EF4-FFF2-40B4-BE49-F238E27FC236}">
                <a16:creationId xmlns:a16="http://schemas.microsoft.com/office/drawing/2014/main" id="{2CBFB6D9-D9CA-423B-900F-3B8E2CB92E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28512" y="2153898"/>
            <a:ext cx="4569750" cy="4365360"/>
          </a:xfrm>
          <a:prstGeom prst="rect">
            <a:avLst/>
          </a:prstGeom>
        </p:spPr>
      </p:pic>
      <p:pic>
        <p:nvPicPr>
          <p:cNvPr id="320" name="図 319">
            <a:extLst>
              <a:ext uri="{FF2B5EF4-FFF2-40B4-BE49-F238E27FC236}">
                <a16:creationId xmlns:a16="http://schemas.microsoft.com/office/drawing/2014/main" id="{97819A21-F37F-4D5B-BF3D-1509AE7E42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6477" y="2194219"/>
            <a:ext cx="4590061" cy="440596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 (left) and GAPDH (right) for Fig. 1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0" name="グループ化 249">
            <a:extLst>
              <a:ext uri="{FF2B5EF4-FFF2-40B4-BE49-F238E27FC236}">
                <a16:creationId xmlns:a16="http://schemas.microsoft.com/office/drawing/2014/main" id="{2D43B283-3E29-4FEC-BDFE-D91C15BDE6F6}"/>
              </a:ext>
            </a:extLst>
          </p:cNvPr>
          <p:cNvGrpSpPr/>
          <p:nvPr/>
        </p:nvGrpSpPr>
        <p:grpSpPr>
          <a:xfrm>
            <a:off x="1859195" y="2287511"/>
            <a:ext cx="3561185" cy="791592"/>
            <a:chOff x="1866122" y="2287511"/>
            <a:chExt cx="3561185" cy="791592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直線コネクタ 237">
              <a:extLst>
                <a:ext uri="{FF2B5EF4-FFF2-40B4-BE49-F238E27FC236}">
                  <a16:creationId xmlns:a16="http://schemas.microsoft.com/office/drawing/2014/main" id="{F8097A0E-ED0D-4581-9143-48C9779D6315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直線コネクタ 238">
              <a:extLst>
                <a:ext uri="{FF2B5EF4-FFF2-40B4-BE49-F238E27FC236}">
                  <a16:creationId xmlns:a16="http://schemas.microsoft.com/office/drawing/2014/main" id="{9F28034C-CD08-447A-9B0E-45D27222A6C0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直線コネクタ 239">
              <a:extLst>
                <a:ext uri="{FF2B5EF4-FFF2-40B4-BE49-F238E27FC236}">
                  <a16:creationId xmlns:a16="http://schemas.microsoft.com/office/drawing/2014/main" id="{6A4804AB-E26F-4A50-B400-986F811794C1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5297FB1F-A08F-4D13-B642-BCEB351ACD24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5" name="直線コネクタ 244">
              <a:extLst>
                <a:ext uri="{FF2B5EF4-FFF2-40B4-BE49-F238E27FC236}">
                  <a16:creationId xmlns:a16="http://schemas.microsoft.com/office/drawing/2014/main" id="{583FD533-79D4-4916-A568-B21001918C70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線コネクタ 246">
              <a:extLst>
                <a:ext uri="{FF2B5EF4-FFF2-40B4-BE49-F238E27FC236}">
                  <a16:creationId xmlns:a16="http://schemas.microsoft.com/office/drawing/2014/main" id="{4C7B7DDB-FBB9-4632-A7D2-070F4AB63244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6BC7A246-AE89-4A52-BA17-3FDD7CD33AF1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3FBD9852-55C4-469A-A5B9-8323FFFF0470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1" name="グループ化 250">
            <a:extLst>
              <a:ext uri="{FF2B5EF4-FFF2-40B4-BE49-F238E27FC236}">
                <a16:creationId xmlns:a16="http://schemas.microsoft.com/office/drawing/2014/main" id="{AB79B6F5-AB68-4A93-82FA-D33C483DDE91}"/>
              </a:ext>
            </a:extLst>
          </p:cNvPr>
          <p:cNvGrpSpPr/>
          <p:nvPr/>
        </p:nvGrpSpPr>
        <p:grpSpPr>
          <a:xfrm>
            <a:off x="1859195" y="4545802"/>
            <a:ext cx="3561185" cy="791592"/>
            <a:chOff x="1866122" y="2287511"/>
            <a:chExt cx="3561185" cy="791592"/>
          </a:xfrm>
        </p:grpSpPr>
        <p:cxnSp>
          <p:nvCxnSpPr>
            <p:cNvPr id="252" name="直線コネクタ 251">
              <a:extLst>
                <a:ext uri="{FF2B5EF4-FFF2-40B4-BE49-F238E27FC236}">
                  <a16:creationId xmlns:a16="http://schemas.microsoft.com/office/drawing/2014/main" id="{BA36D460-1D1F-4CB9-9A41-329A8775BC4C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線コネクタ 252">
              <a:extLst>
                <a:ext uri="{FF2B5EF4-FFF2-40B4-BE49-F238E27FC236}">
                  <a16:creationId xmlns:a16="http://schemas.microsoft.com/office/drawing/2014/main" id="{479E7CE7-54EE-4170-B5A5-0682B2CF2968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線コネクタ 253">
              <a:extLst>
                <a:ext uri="{FF2B5EF4-FFF2-40B4-BE49-F238E27FC236}">
                  <a16:creationId xmlns:a16="http://schemas.microsoft.com/office/drawing/2014/main" id="{D07C77E6-1C85-4578-B8C2-191F632AE6C5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線コネクタ 254">
              <a:extLst>
                <a:ext uri="{FF2B5EF4-FFF2-40B4-BE49-F238E27FC236}">
                  <a16:creationId xmlns:a16="http://schemas.microsoft.com/office/drawing/2014/main" id="{EBC5F8C9-80E2-449E-9485-BECCC8885B1D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6CBBEEC4-9DEA-4D9E-9C4B-456C71891F53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685742E7-067E-4F2C-8DE7-CAD302E221EB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AC6BB858-130B-46FC-94AF-7D5F939BB1E6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838DAC21-0790-4D9C-B2D8-B1300FA70509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0" name="直線コネクタ 259">
              <a:extLst>
                <a:ext uri="{FF2B5EF4-FFF2-40B4-BE49-F238E27FC236}">
                  <a16:creationId xmlns:a16="http://schemas.microsoft.com/office/drawing/2014/main" id="{385DD23C-4731-4453-898B-BF1720D63BB4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直線コネクタ 260">
              <a:extLst>
                <a:ext uri="{FF2B5EF4-FFF2-40B4-BE49-F238E27FC236}">
                  <a16:creationId xmlns:a16="http://schemas.microsoft.com/office/drawing/2014/main" id="{716D3530-7C0E-463A-982D-297E1781E2F3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44642C10-6550-4258-8512-37A93D5BDD1A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0F146736-BBFE-47C7-BB04-AFC7F60CCFC0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id="{F92A438B-DFF9-4005-95F2-0953ADA7125A}"/>
              </a:ext>
            </a:extLst>
          </p:cNvPr>
          <p:cNvGrpSpPr/>
          <p:nvPr/>
        </p:nvGrpSpPr>
        <p:grpSpPr>
          <a:xfrm>
            <a:off x="9143915" y="2135111"/>
            <a:ext cx="3561185" cy="791592"/>
            <a:chOff x="1866122" y="2287511"/>
            <a:chExt cx="3561185" cy="791592"/>
          </a:xfrm>
        </p:grpSpPr>
        <p:cxnSp>
          <p:nvCxnSpPr>
            <p:cNvPr id="265" name="直線コネクタ 264">
              <a:extLst>
                <a:ext uri="{FF2B5EF4-FFF2-40B4-BE49-F238E27FC236}">
                  <a16:creationId xmlns:a16="http://schemas.microsoft.com/office/drawing/2014/main" id="{7D61B770-538A-44A9-AD33-C4547A6B822F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直線コネクタ 265">
              <a:extLst>
                <a:ext uri="{FF2B5EF4-FFF2-40B4-BE49-F238E27FC236}">
                  <a16:creationId xmlns:a16="http://schemas.microsoft.com/office/drawing/2014/main" id="{9ECF692D-D3EC-4737-8F76-6931A1071856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直線コネクタ 266">
              <a:extLst>
                <a:ext uri="{FF2B5EF4-FFF2-40B4-BE49-F238E27FC236}">
                  <a16:creationId xmlns:a16="http://schemas.microsoft.com/office/drawing/2014/main" id="{1BA6F03D-1D09-407D-ABF3-6AE7E359444A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直線コネクタ 267">
              <a:extLst>
                <a:ext uri="{FF2B5EF4-FFF2-40B4-BE49-F238E27FC236}">
                  <a16:creationId xmlns:a16="http://schemas.microsoft.com/office/drawing/2014/main" id="{C39F1473-875A-4863-8E11-4991A5899160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FB7DC5F1-04A9-4AF8-A845-C0365F54D881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テキスト ボックス 269">
              <a:extLst>
                <a:ext uri="{FF2B5EF4-FFF2-40B4-BE49-F238E27FC236}">
                  <a16:creationId xmlns:a16="http://schemas.microsoft.com/office/drawing/2014/main" id="{1A35C495-A366-45E5-813B-D39A1DC89A1D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FF70691D-AD62-4700-889C-E8E1635AFE33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E082F07F-775A-4480-AB22-14D57EC80E8F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3" name="直線コネクタ 272">
              <a:extLst>
                <a:ext uri="{FF2B5EF4-FFF2-40B4-BE49-F238E27FC236}">
                  <a16:creationId xmlns:a16="http://schemas.microsoft.com/office/drawing/2014/main" id="{68401F94-1175-417E-A44C-1906E1C6A30F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直線コネクタ 273">
              <a:extLst>
                <a:ext uri="{FF2B5EF4-FFF2-40B4-BE49-F238E27FC236}">
                  <a16:creationId xmlns:a16="http://schemas.microsoft.com/office/drawing/2014/main" id="{F1EE45CC-2629-4584-A515-38AAA3567287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0F04EA60-B072-4CFA-9C08-5012D87E3CEF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F3E29F9D-0FCD-4D29-9AB8-89EBBC7B41B6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7" name="グループ化 276">
            <a:extLst>
              <a:ext uri="{FF2B5EF4-FFF2-40B4-BE49-F238E27FC236}">
                <a16:creationId xmlns:a16="http://schemas.microsoft.com/office/drawing/2014/main" id="{D18FDA2A-0F11-44AE-810C-AE54CC396688}"/>
              </a:ext>
            </a:extLst>
          </p:cNvPr>
          <p:cNvGrpSpPr/>
          <p:nvPr/>
        </p:nvGrpSpPr>
        <p:grpSpPr>
          <a:xfrm>
            <a:off x="9143915" y="4393402"/>
            <a:ext cx="3561185" cy="791592"/>
            <a:chOff x="1866122" y="2287511"/>
            <a:chExt cx="3561185" cy="791592"/>
          </a:xfrm>
        </p:grpSpPr>
        <p:cxnSp>
          <p:nvCxnSpPr>
            <p:cNvPr id="278" name="直線コネクタ 277">
              <a:extLst>
                <a:ext uri="{FF2B5EF4-FFF2-40B4-BE49-F238E27FC236}">
                  <a16:creationId xmlns:a16="http://schemas.microsoft.com/office/drawing/2014/main" id="{D3991F73-2255-4C15-900B-7C56D01A0DBA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直線コネクタ 278">
              <a:extLst>
                <a:ext uri="{FF2B5EF4-FFF2-40B4-BE49-F238E27FC236}">
                  <a16:creationId xmlns:a16="http://schemas.microsoft.com/office/drawing/2014/main" id="{5AD754B8-8AAE-4675-987A-93494EE49651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直線コネクタ 279">
              <a:extLst>
                <a:ext uri="{FF2B5EF4-FFF2-40B4-BE49-F238E27FC236}">
                  <a16:creationId xmlns:a16="http://schemas.microsoft.com/office/drawing/2014/main" id="{141B6857-26CC-4EFD-A23E-D1B78A67F7DF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直線コネクタ 280">
              <a:extLst>
                <a:ext uri="{FF2B5EF4-FFF2-40B4-BE49-F238E27FC236}">
                  <a16:creationId xmlns:a16="http://schemas.microsoft.com/office/drawing/2014/main" id="{2C337E22-7854-4DF5-81FB-DD9E0C0337C6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2" name="テキスト ボックス 281">
              <a:extLst>
                <a:ext uri="{FF2B5EF4-FFF2-40B4-BE49-F238E27FC236}">
                  <a16:creationId xmlns:a16="http://schemas.microsoft.com/office/drawing/2014/main" id="{4E7D7931-90BC-4F4E-8C80-95EE261DC0A5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9B128589-DC09-4561-B051-97747217441F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id="{FC94F51E-1DC9-4ACE-80EE-D61B74FCC926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テキスト ボックス 284">
              <a:extLst>
                <a:ext uri="{FF2B5EF4-FFF2-40B4-BE49-F238E27FC236}">
                  <a16:creationId xmlns:a16="http://schemas.microsoft.com/office/drawing/2014/main" id="{D0B80884-9BB4-4315-AC54-B68C844FA4AE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6" name="直線コネクタ 285">
              <a:extLst>
                <a:ext uri="{FF2B5EF4-FFF2-40B4-BE49-F238E27FC236}">
                  <a16:creationId xmlns:a16="http://schemas.microsoft.com/office/drawing/2014/main" id="{DE4D7DF0-260B-41F4-95C5-AF0DA00B3D21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直線コネクタ 286">
              <a:extLst>
                <a:ext uri="{FF2B5EF4-FFF2-40B4-BE49-F238E27FC236}">
                  <a16:creationId xmlns:a16="http://schemas.microsoft.com/office/drawing/2014/main" id="{87F3B474-5607-4A26-9041-603E05A383CE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テキスト ボックス 287">
              <a:extLst>
                <a:ext uri="{FF2B5EF4-FFF2-40B4-BE49-F238E27FC236}">
                  <a16:creationId xmlns:a16="http://schemas.microsoft.com/office/drawing/2014/main" id="{1B89DCBF-85EE-456A-BCE5-99CEEB3570FB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id="{AFC3E630-8284-4D72-BD70-B7A3260DF15C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787424" y="116518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816655" y="116518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698425" y="21057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698425" y="22790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698425" y="244188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698425" y="261518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698425" y="292956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698425" y="323349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698425" y="367850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id="{09A9EDF1-EAB2-43BC-929F-70AF1A47F4CD}"/>
              </a:ext>
            </a:extLst>
          </p:cNvPr>
          <p:cNvSpPr txBox="1"/>
          <p:nvPr/>
        </p:nvSpPr>
        <p:spPr>
          <a:xfrm>
            <a:off x="683621" y="435341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60C2AB98-1F4E-4467-B29C-C370542C9D57}"/>
              </a:ext>
            </a:extLst>
          </p:cNvPr>
          <p:cNvSpPr txBox="1"/>
          <p:nvPr/>
        </p:nvSpPr>
        <p:spPr>
          <a:xfrm>
            <a:off x="683621" y="452671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2DB261D4-6475-4CE9-80AC-1EC096D0BAF4}"/>
              </a:ext>
            </a:extLst>
          </p:cNvPr>
          <p:cNvSpPr txBox="1"/>
          <p:nvPr/>
        </p:nvSpPr>
        <p:spPr>
          <a:xfrm>
            <a:off x="683621" y="46895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02988C49-FDAC-479A-AE5D-9EB9FA4D2D80}"/>
              </a:ext>
            </a:extLst>
          </p:cNvPr>
          <p:cNvSpPr txBox="1"/>
          <p:nvPr/>
        </p:nvSpPr>
        <p:spPr>
          <a:xfrm>
            <a:off x="683621" y="486286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F9B393B2-2B39-434E-8C6F-ED31589686DF}"/>
              </a:ext>
            </a:extLst>
          </p:cNvPr>
          <p:cNvSpPr txBox="1"/>
          <p:nvPr/>
        </p:nvSpPr>
        <p:spPr>
          <a:xfrm>
            <a:off x="683621" y="517724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CC75CCD1-5F49-466B-BAFB-1157D36B6DAD}"/>
              </a:ext>
            </a:extLst>
          </p:cNvPr>
          <p:cNvSpPr txBox="1"/>
          <p:nvPr/>
        </p:nvSpPr>
        <p:spPr>
          <a:xfrm>
            <a:off x="683621" y="548117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20B0F152-085A-4816-BD85-F8DEC8BD8361}"/>
              </a:ext>
            </a:extLst>
          </p:cNvPr>
          <p:cNvSpPr txBox="1"/>
          <p:nvPr/>
        </p:nvSpPr>
        <p:spPr>
          <a:xfrm>
            <a:off x="683621" y="592618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2057C1DE-0720-41F5-A2E9-0C7104E5CA1A}"/>
              </a:ext>
            </a:extLst>
          </p:cNvPr>
          <p:cNvSpPr txBox="1"/>
          <p:nvPr/>
        </p:nvSpPr>
        <p:spPr>
          <a:xfrm>
            <a:off x="7936990" y="208657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32CC782E-7816-4F8F-B928-2F3C4FD14916}"/>
              </a:ext>
            </a:extLst>
          </p:cNvPr>
          <p:cNvSpPr txBox="1"/>
          <p:nvPr/>
        </p:nvSpPr>
        <p:spPr>
          <a:xfrm>
            <a:off x="7936990" y="225987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093DF6B6-BE34-4200-9C38-8D7964BE912E}"/>
              </a:ext>
            </a:extLst>
          </p:cNvPr>
          <p:cNvSpPr txBox="1"/>
          <p:nvPr/>
        </p:nvSpPr>
        <p:spPr>
          <a:xfrm>
            <a:off x="7936990" y="242272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FDE70772-110B-4920-AC56-E3B4E68CE4B4}"/>
              </a:ext>
            </a:extLst>
          </p:cNvPr>
          <p:cNvSpPr txBox="1"/>
          <p:nvPr/>
        </p:nvSpPr>
        <p:spPr>
          <a:xfrm>
            <a:off x="7936990" y="259602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4C8B29D1-1EAF-40F5-BEB8-A16AAB2F50C2}"/>
              </a:ext>
            </a:extLst>
          </p:cNvPr>
          <p:cNvSpPr txBox="1"/>
          <p:nvPr/>
        </p:nvSpPr>
        <p:spPr>
          <a:xfrm>
            <a:off x="7936990" y="29104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8BB1EC64-5D29-44E6-820E-FA00874B5CEA}"/>
              </a:ext>
            </a:extLst>
          </p:cNvPr>
          <p:cNvSpPr txBox="1"/>
          <p:nvPr/>
        </p:nvSpPr>
        <p:spPr>
          <a:xfrm>
            <a:off x="7936990" y="321433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E4E393E9-270C-452E-B8A6-96268D1ECA00}"/>
              </a:ext>
            </a:extLst>
          </p:cNvPr>
          <p:cNvSpPr txBox="1"/>
          <p:nvPr/>
        </p:nvSpPr>
        <p:spPr>
          <a:xfrm>
            <a:off x="7936990" y="365934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DB383343-8DAE-4EEA-A51C-C1E98EDE9AEA}"/>
              </a:ext>
            </a:extLst>
          </p:cNvPr>
          <p:cNvSpPr txBox="1"/>
          <p:nvPr/>
        </p:nvSpPr>
        <p:spPr>
          <a:xfrm>
            <a:off x="7969212" y="43029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031FAE68-F6C0-4CC1-A2D7-B8CADB4A6A49}"/>
              </a:ext>
            </a:extLst>
          </p:cNvPr>
          <p:cNvSpPr txBox="1"/>
          <p:nvPr/>
        </p:nvSpPr>
        <p:spPr>
          <a:xfrm>
            <a:off x="7969212" y="44762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26FFDED8-1EBE-4A0F-9EB8-EEEFDE2FB13A}"/>
              </a:ext>
            </a:extLst>
          </p:cNvPr>
          <p:cNvSpPr txBox="1"/>
          <p:nvPr/>
        </p:nvSpPr>
        <p:spPr>
          <a:xfrm>
            <a:off x="7969212" y="463905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D187293F-AFC2-42E0-A102-30A53F414B7E}"/>
              </a:ext>
            </a:extLst>
          </p:cNvPr>
          <p:cNvSpPr txBox="1"/>
          <p:nvPr/>
        </p:nvSpPr>
        <p:spPr>
          <a:xfrm>
            <a:off x="7969212" y="481235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3AB54719-D9BC-437F-B376-CD31D633F774}"/>
              </a:ext>
            </a:extLst>
          </p:cNvPr>
          <p:cNvSpPr txBox="1"/>
          <p:nvPr/>
        </p:nvSpPr>
        <p:spPr>
          <a:xfrm>
            <a:off x="7969212" y="51267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1D901396-18A6-4136-9DCE-6F42E787FAA1}"/>
              </a:ext>
            </a:extLst>
          </p:cNvPr>
          <p:cNvSpPr txBox="1"/>
          <p:nvPr/>
        </p:nvSpPr>
        <p:spPr>
          <a:xfrm>
            <a:off x="7969212" y="54306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97C9214A-85EF-4ECF-8622-073DCB9D816B}"/>
              </a:ext>
            </a:extLst>
          </p:cNvPr>
          <p:cNvSpPr txBox="1"/>
          <p:nvPr/>
        </p:nvSpPr>
        <p:spPr>
          <a:xfrm>
            <a:off x="7969212" y="587567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5560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589934CA-A247-4D29-BDDA-0072069B24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2043" y="3515701"/>
            <a:ext cx="5737576" cy="276642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4E9A81F-C1A2-481A-AD5A-1C0007CEF3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057" y="3515701"/>
            <a:ext cx="5737576" cy="258876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(left) and p54 (right) for Fig. 4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832514" y="2262464"/>
            <a:ext cx="57242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and p-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7861745" y="2262464"/>
            <a:ext cx="57242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54 and 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42954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61834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8276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0552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4393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81302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38202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3FBE975-AF04-4BED-ACD1-612461832CB0}"/>
              </a:ext>
            </a:extLst>
          </p:cNvPr>
          <p:cNvGrpSpPr/>
          <p:nvPr/>
        </p:nvGrpSpPr>
        <p:grpSpPr>
          <a:xfrm>
            <a:off x="1472339" y="3645257"/>
            <a:ext cx="4556496" cy="1875250"/>
            <a:chOff x="1472339" y="2866029"/>
            <a:chExt cx="4556496" cy="1875250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CC3360FB-6378-44BD-BE1E-FFB4307ACFE8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5AF4E111-1046-4B5D-B083-852A877B61DC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F757E676-466F-4C68-BA64-96E519C24AB9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00B446D-FAC8-4C68-A18D-CA3AABF944A3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69A756A8-47FE-49C7-9ECF-C100F57F2833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03806D9-DA7B-4D33-8BF5-16EF3DFEFFD6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498F2056-603B-4370-9D03-BFE58F131D69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8397F63F-2E0A-4286-873E-06FCA8A8E0CE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0CC8F7B-3395-4DD4-B558-8133C975E068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B374298-D6D1-46C3-AF10-6BA669CEF78D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B5085D0E-CC07-4424-B5B9-E56B2A658A65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EFD6F01-ACFF-4F01-8906-78AD3699F4F1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807B44B6-B15E-4217-8B87-0588E4D0AEC2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65A70F0-984E-4CD5-B23D-E9C1D92ECAAF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8B5444F-C162-4E25-89E5-478E0B15CE44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89B49A12-4E36-4D74-8A57-48FB9D4FC629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21C75ADD-B8B1-464C-9EF6-13EC4F0418B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B74D098D-E88A-4DCC-B329-05F2D89390A8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E4AA5CE8-403E-47DB-9FAC-557470E3338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2C2F929-F94B-49B9-A7E1-446C3759CB3D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33EECE32-DB0D-4938-A986-B02AE92C3486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ABD180EB-FBA7-4BBF-A9A7-D0EA57B7171D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7472961" y="353193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7472961" y="372072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7472961" y="393007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7472961" y="415761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7472961" y="454174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7472961" y="491541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7472961" y="548440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グループ化 122">
            <a:extLst>
              <a:ext uri="{FF2B5EF4-FFF2-40B4-BE49-F238E27FC236}">
                <a16:creationId xmlns:a16="http://schemas.microsoft.com/office/drawing/2014/main" id="{CDB682E0-0B19-4207-8F2C-31E2C5B45E9A}"/>
              </a:ext>
            </a:extLst>
          </p:cNvPr>
          <p:cNvGrpSpPr/>
          <p:nvPr/>
        </p:nvGrpSpPr>
        <p:grpSpPr>
          <a:xfrm>
            <a:off x="8841085" y="3713789"/>
            <a:ext cx="4556496" cy="1875250"/>
            <a:chOff x="1472339" y="2866029"/>
            <a:chExt cx="4556496" cy="1875250"/>
          </a:xfrm>
        </p:grpSpPr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D193AEDF-029F-40DD-8769-E8B3A23C8FEB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ADE955E1-7738-421C-A24B-9E5D19E02385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D36547A-D9CB-4908-86EE-8821F4091B9F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0BEE150-C6EC-4D80-A379-0D759EA9DADF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5271F0C8-405B-4596-B8D4-3479F9714E2E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B0FD5E9B-5D5D-4891-AC3D-3B9FF254E14E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55030C48-459C-424A-973E-130CCE24316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109E9920-5005-4B67-9F14-768046F6163F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C7997C1A-ED28-47CD-B6B3-59C2033A2DEC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BCBCA5D7-7313-40C5-AD3D-5CFA71296F7E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8DA281B4-F597-49FD-A7CB-1F4FA6289904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1FF9CCB3-CDB9-47DA-B43A-6F6C4EF73E4F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DF769565-1F83-4EEC-AF94-F89FD886BEC4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6846242-7174-493F-B4FF-7FA0028D1021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FE429405-FDCE-417D-BE5A-A9752EED2247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3FE56025-1DA4-47DF-AA1A-DDDC258654F3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9911C374-898B-44DC-9B27-6B9BC8843D68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679A45F6-1418-4175-B04A-ED618AE867C9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CE48CE38-C395-4096-BB15-DE35D317E82A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444C2E32-18F9-49FC-8C37-72E6F14D9E4A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737B88B6-608C-4590-917B-81058ABC389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40C77F98-4AE3-40EA-B6C7-A7A929B34806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7E6E5A41-B9C8-495E-9110-70BD66F546D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1E18AD95-CF07-4F50-8D33-440B46F9D58B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6C5112BD-2A35-427B-AB0D-9E77AA89B990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02290F62-C024-4243-A447-D393E1312F53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250103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D3C17FC7-FE34-4748-B49F-CE2D66FEF0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2043" y="3515701"/>
            <a:ext cx="5686800" cy="276642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729AF73-FBB6-4F84-BC72-406212D87C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057" y="3515701"/>
            <a:ext cx="5762964" cy="281718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 (left) and GAPDH (right) for Fig. 5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787424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816655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42954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61834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8276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0552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4393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81302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38202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3FBE975-AF04-4BED-ACD1-612461832CB0}"/>
              </a:ext>
            </a:extLst>
          </p:cNvPr>
          <p:cNvGrpSpPr/>
          <p:nvPr/>
        </p:nvGrpSpPr>
        <p:grpSpPr>
          <a:xfrm>
            <a:off x="1413724" y="4186046"/>
            <a:ext cx="4556496" cy="1875250"/>
            <a:chOff x="1472339" y="2866029"/>
            <a:chExt cx="4556496" cy="1875250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CC3360FB-6378-44BD-BE1E-FFB4307ACFE8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5AF4E111-1046-4B5D-B083-852A877B61DC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F757E676-466F-4C68-BA64-96E519C24AB9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00B446D-FAC8-4C68-A18D-CA3AABF944A3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69A756A8-47FE-49C7-9ECF-C100F57F2833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03806D9-DA7B-4D33-8BF5-16EF3DFEFFD6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498F2056-603B-4370-9D03-BFE58F131D69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8397F63F-2E0A-4286-873E-06FCA8A8E0CE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0CC8F7B-3395-4DD4-B558-8133C975E068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B374298-D6D1-46C3-AF10-6BA669CEF78D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B5085D0E-CC07-4424-B5B9-E56B2A658A65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EFD6F01-ACFF-4F01-8906-78AD3699F4F1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807B44B6-B15E-4217-8B87-0588E4D0AEC2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65A70F0-984E-4CD5-B23D-E9C1D92ECAAF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8B5444F-C162-4E25-89E5-478E0B15CE44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89B49A12-4E36-4D74-8A57-48FB9D4FC629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21C75ADD-B8B1-464C-9EF6-13EC4F0418B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B74D098D-E88A-4DCC-B329-05F2D89390A8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E4AA5CE8-403E-47DB-9FAC-557470E3338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2C2F929-F94B-49B9-A7E1-446C3759CB3D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33EECE32-DB0D-4938-A986-B02AE92C3486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ABD180EB-FBA7-4BBF-A9A7-D0EA57B7171D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7456919" y="342382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7456919" y="361261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7456919" y="382196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7456919" y="404951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7456919" y="44336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7456919" y="48073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7456919" y="537629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グループ化 122">
            <a:extLst>
              <a:ext uri="{FF2B5EF4-FFF2-40B4-BE49-F238E27FC236}">
                <a16:creationId xmlns:a16="http://schemas.microsoft.com/office/drawing/2014/main" id="{CDB682E0-0B19-4207-8F2C-31E2C5B45E9A}"/>
              </a:ext>
            </a:extLst>
          </p:cNvPr>
          <p:cNvGrpSpPr/>
          <p:nvPr/>
        </p:nvGrpSpPr>
        <p:grpSpPr>
          <a:xfrm>
            <a:off x="8759024" y="4117926"/>
            <a:ext cx="4556496" cy="1875250"/>
            <a:chOff x="1472339" y="2866029"/>
            <a:chExt cx="4556496" cy="1875250"/>
          </a:xfrm>
        </p:grpSpPr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D193AEDF-029F-40DD-8769-E8B3A23C8FEB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ADE955E1-7738-421C-A24B-9E5D19E02385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D36547A-D9CB-4908-86EE-8821F4091B9F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0BEE150-C6EC-4D80-A379-0D759EA9DADF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5271F0C8-405B-4596-B8D4-3479F9714E2E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B0FD5E9B-5D5D-4891-AC3D-3B9FF254E14E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55030C48-459C-424A-973E-130CCE24316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109E9920-5005-4B67-9F14-768046F6163F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C7997C1A-ED28-47CD-B6B3-59C2033A2DEC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BCBCA5D7-7313-40C5-AD3D-5CFA71296F7E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8DA281B4-F597-49FD-A7CB-1F4FA6289904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1FF9CCB3-CDB9-47DA-B43A-6F6C4EF73E4F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DF769565-1F83-4EEC-AF94-F89FD886BEC4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6846242-7174-493F-B4FF-7FA0028D1021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FE429405-FDCE-417D-BE5A-A9752EED2247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3FE56025-1DA4-47DF-AA1A-DDDC258654F3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9911C374-898B-44DC-9B27-6B9BC8843D68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679A45F6-1418-4175-B04A-ED618AE867C9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CE48CE38-C395-4096-BB15-DE35D317E82A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444C2E32-18F9-49FC-8C37-72E6F14D9E4A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737B88B6-608C-4590-917B-81058ABC389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40C77F98-4AE3-40EA-B6C7-A7A929B34806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7E6E5A41-B9C8-495E-9110-70BD66F546D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1E18AD95-CF07-4F50-8D33-440B46F9D58B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6C5112BD-2A35-427B-AB0D-9E77AA89B990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02290F62-C024-4243-A447-D393E1312F53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8467565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50D0B30-8D0A-4A83-AAE6-286C720E15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9057" y="3515701"/>
            <a:ext cx="5636026" cy="284256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 (left) and p65 (right) for Fig. 5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787424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816655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56336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7521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9615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18904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57317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99144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62734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7" name="直線コネクタ 236">
            <a:extLst>
              <a:ext uri="{FF2B5EF4-FFF2-40B4-BE49-F238E27FC236}">
                <a16:creationId xmlns:a16="http://schemas.microsoft.com/office/drawing/2014/main" id="{930BCDD1-8BD2-420F-8022-38BC6DAC3995}"/>
              </a:ext>
            </a:extLst>
          </p:cNvPr>
          <p:cNvCxnSpPr>
            <a:cxnSpLocks/>
          </p:cNvCxnSpPr>
          <p:nvPr/>
        </p:nvCxnSpPr>
        <p:spPr>
          <a:xfrm>
            <a:off x="1444119" y="496877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78DB08DA-8BC2-4079-B74B-78E34C46D7D4}"/>
              </a:ext>
            </a:extLst>
          </p:cNvPr>
          <p:cNvSpPr txBox="1"/>
          <p:nvPr/>
        </p:nvSpPr>
        <p:spPr>
          <a:xfrm>
            <a:off x="1449391" y="499592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1" lang="en-US" altLang="ja-JP" b="1" baseline="-1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5EBC005D-728C-4765-92C1-7555ECDE3DD3}"/>
              </a:ext>
            </a:extLst>
          </p:cNvPr>
          <p:cNvSpPr txBox="1"/>
          <p:nvPr/>
        </p:nvSpPr>
        <p:spPr>
          <a:xfrm>
            <a:off x="2979031" y="499592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F63C9915-DD95-4BE2-BA40-050168C26B37}"/>
              </a:ext>
            </a:extLst>
          </p:cNvPr>
          <p:cNvSpPr txBox="1"/>
          <p:nvPr/>
        </p:nvSpPr>
        <p:spPr>
          <a:xfrm>
            <a:off x="2210336" y="499592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CC3360FB-6378-44BD-BE1E-FFB4307ACFE8}"/>
              </a:ext>
            </a:extLst>
          </p:cNvPr>
          <p:cNvCxnSpPr>
            <a:cxnSpLocks/>
          </p:cNvCxnSpPr>
          <p:nvPr/>
        </p:nvCxnSpPr>
        <p:spPr>
          <a:xfrm>
            <a:off x="2216451" y="496877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5AF4E111-1046-4B5D-B083-852A877B61DC}"/>
              </a:ext>
            </a:extLst>
          </p:cNvPr>
          <p:cNvCxnSpPr>
            <a:cxnSpLocks/>
          </p:cNvCxnSpPr>
          <p:nvPr/>
        </p:nvCxnSpPr>
        <p:spPr>
          <a:xfrm>
            <a:off x="2988783" y="496877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F757E676-466F-4C68-BA64-96E519C24AB9}"/>
              </a:ext>
            </a:extLst>
          </p:cNvPr>
          <p:cNvCxnSpPr>
            <a:cxnSpLocks/>
          </p:cNvCxnSpPr>
          <p:nvPr/>
        </p:nvCxnSpPr>
        <p:spPr>
          <a:xfrm>
            <a:off x="3735286" y="4968778"/>
            <a:ext cx="22056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000B446D-FAC8-4C68-A18D-CA3AABF944A3}"/>
              </a:ext>
            </a:extLst>
          </p:cNvPr>
          <p:cNvSpPr txBox="1"/>
          <p:nvPr/>
        </p:nvSpPr>
        <p:spPr>
          <a:xfrm>
            <a:off x="3832677" y="4995928"/>
            <a:ext cx="2010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am2CSK4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CC8F7B-3395-4DD4-B558-8133C975E068}"/>
              </a:ext>
            </a:extLst>
          </p:cNvPr>
          <p:cNvSpPr txBox="1"/>
          <p:nvPr/>
        </p:nvSpPr>
        <p:spPr>
          <a:xfrm>
            <a:off x="141372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EB374298-D6D1-46C3-AF10-6BA669CEF78D}"/>
              </a:ext>
            </a:extLst>
          </p:cNvPr>
          <p:cNvSpPr txBox="1"/>
          <p:nvPr/>
        </p:nvSpPr>
        <p:spPr>
          <a:xfrm>
            <a:off x="1791319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5085D0E-CC07-4424-B5B9-E56B2A658A65}"/>
              </a:ext>
            </a:extLst>
          </p:cNvPr>
          <p:cNvSpPr txBox="1"/>
          <p:nvPr/>
        </p:nvSpPr>
        <p:spPr>
          <a:xfrm>
            <a:off x="216891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EFD6F01-ACFF-4F01-8906-78AD3699F4F1}"/>
              </a:ext>
            </a:extLst>
          </p:cNvPr>
          <p:cNvSpPr txBox="1"/>
          <p:nvPr/>
        </p:nvSpPr>
        <p:spPr>
          <a:xfrm>
            <a:off x="2546509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07B44B6-B15E-4217-8B87-0588E4D0AEC2}"/>
              </a:ext>
            </a:extLst>
          </p:cNvPr>
          <p:cNvSpPr txBox="1"/>
          <p:nvPr/>
        </p:nvSpPr>
        <p:spPr>
          <a:xfrm>
            <a:off x="292410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765A70F0-984E-4CD5-B23D-E9C1D92ECAAF}"/>
              </a:ext>
            </a:extLst>
          </p:cNvPr>
          <p:cNvSpPr txBox="1"/>
          <p:nvPr/>
        </p:nvSpPr>
        <p:spPr>
          <a:xfrm>
            <a:off x="3301699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98B5444F-C162-4E25-89E5-478E0B15CE44}"/>
              </a:ext>
            </a:extLst>
          </p:cNvPr>
          <p:cNvSpPr txBox="1"/>
          <p:nvPr/>
        </p:nvSpPr>
        <p:spPr>
          <a:xfrm>
            <a:off x="367929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9B49A12-4E36-4D74-8A57-48FB9D4FC629}"/>
              </a:ext>
            </a:extLst>
          </p:cNvPr>
          <p:cNvSpPr txBox="1"/>
          <p:nvPr/>
        </p:nvSpPr>
        <p:spPr>
          <a:xfrm>
            <a:off x="4056889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21C75ADD-B8B1-464C-9EF6-13EC4F0418B3}"/>
              </a:ext>
            </a:extLst>
          </p:cNvPr>
          <p:cNvSpPr txBox="1"/>
          <p:nvPr/>
        </p:nvSpPr>
        <p:spPr>
          <a:xfrm>
            <a:off x="443448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B74D098D-E88A-4DCC-B329-05F2D89390A8}"/>
              </a:ext>
            </a:extLst>
          </p:cNvPr>
          <p:cNvSpPr txBox="1"/>
          <p:nvPr/>
        </p:nvSpPr>
        <p:spPr>
          <a:xfrm>
            <a:off x="4812079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E4AA5CE8-403E-47DB-9FAC-557470E33388}"/>
              </a:ext>
            </a:extLst>
          </p:cNvPr>
          <p:cNvSpPr txBox="1"/>
          <p:nvPr/>
        </p:nvSpPr>
        <p:spPr>
          <a:xfrm>
            <a:off x="5189674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72C2F929-F94B-49B9-A7E1-446C3759CB3D}"/>
              </a:ext>
            </a:extLst>
          </p:cNvPr>
          <p:cNvSpPr txBox="1"/>
          <p:nvPr/>
        </p:nvSpPr>
        <p:spPr>
          <a:xfrm>
            <a:off x="5567265" y="393063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3EECE32-DB0D-4938-A986-B02AE92C3486}"/>
              </a:ext>
            </a:extLst>
          </p:cNvPr>
          <p:cNvSpPr txBox="1"/>
          <p:nvPr/>
        </p:nvSpPr>
        <p:spPr>
          <a:xfrm>
            <a:off x="2841840" y="3544601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-R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ABD180EB-FBA7-4BBF-A9A7-D0EA57B7171D}"/>
              </a:ext>
            </a:extLst>
          </p:cNvPr>
          <p:cNvCxnSpPr>
            <a:cxnSpLocks/>
          </p:cNvCxnSpPr>
          <p:nvPr/>
        </p:nvCxnSpPr>
        <p:spPr>
          <a:xfrm>
            <a:off x="1444119" y="3943656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79DD4BCF-8CC4-4E87-9A6D-8DCD1D44BC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09769" y="3515701"/>
            <a:ext cx="3909676" cy="2817180"/>
          </a:xfrm>
          <a:prstGeom prst="rect">
            <a:avLst/>
          </a:prstGeom>
        </p:spPr>
      </p:pic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CC536C24-B536-44CB-B54D-87B207033DEB}"/>
              </a:ext>
            </a:extLst>
          </p:cNvPr>
          <p:cNvSpPr txBox="1"/>
          <p:nvPr/>
        </p:nvSpPr>
        <p:spPr>
          <a:xfrm>
            <a:off x="8152549" y="354849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5FEB36FB-61CB-4BB3-8E27-F08D9D5B7C99}"/>
              </a:ext>
            </a:extLst>
          </p:cNvPr>
          <p:cNvSpPr txBox="1"/>
          <p:nvPr/>
        </p:nvSpPr>
        <p:spPr>
          <a:xfrm>
            <a:off x="8152549" y="373729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1836658-B4EC-4EA5-A9BC-FC93585A5948}"/>
              </a:ext>
            </a:extLst>
          </p:cNvPr>
          <p:cNvSpPr txBox="1"/>
          <p:nvPr/>
        </p:nvSpPr>
        <p:spPr>
          <a:xfrm>
            <a:off x="8152549" y="394663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1DCBEE3-92AF-4CD3-BE10-0E7D9B7EB5A0}"/>
              </a:ext>
            </a:extLst>
          </p:cNvPr>
          <p:cNvSpPr txBox="1"/>
          <p:nvPr/>
        </p:nvSpPr>
        <p:spPr>
          <a:xfrm>
            <a:off x="8152549" y="417418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4B33D841-5032-4E7D-8BB1-E5E678A8C400}"/>
              </a:ext>
            </a:extLst>
          </p:cNvPr>
          <p:cNvSpPr txBox="1"/>
          <p:nvPr/>
        </p:nvSpPr>
        <p:spPr>
          <a:xfrm>
            <a:off x="8152549" y="455830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C944349-368B-42DF-8E5C-BF25A40D7CD4}"/>
              </a:ext>
            </a:extLst>
          </p:cNvPr>
          <p:cNvSpPr txBox="1"/>
          <p:nvPr/>
        </p:nvSpPr>
        <p:spPr>
          <a:xfrm>
            <a:off x="8152549" y="497658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2E019E95-9FF2-477F-80A8-6F66653ECE0F}"/>
              </a:ext>
            </a:extLst>
          </p:cNvPr>
          <p:cNvSpPr txBox="1"/>
          <p:nvPr/>
        </p:nvSpPr>
        <p:spPr>
          <a:xfrm>
            <a:off x="8152549" y="561248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A7EE6FBE-6D37-4081-AFB1-7B1DC7B84471}"/>
              </a:ext>
            </a:extLst>
          </p:cNvPr>
          <p:cNvCxnSpPr>
            <a:cxnSpLocks/>
          </p:cNvCxnSpPr>
          <p:nvPr/>
        </p:nvCxnSpPr>
        <p:spPr>
          <a:xfrm>
            <a:off x="9603094" y="493160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963E3BA0-3135-4732-9BD8-C355B72DEBEC}"/>
              </a:ext>
            </a:extLst>
          </p:cNvPr>
          <p:cNvSpPr txBox="1"/>
          <p:nvPr/>
        </p:nvSpPr>
        <p:spPr>
          <a:xfrm>
            <a:off x="9608366" y="495875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1" lang="en-US" altLang="ja-JP" b="1" baseline="-1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E42E440-35AF-48B9-92F0-799290D1087B}"/>
              </a:ext>
            </a:extLst>
          </p:cNvPr>
          <p:cNvSpPr txBox="1"/>
          <p:nvPr/>
        </p:nvSpPr>
        <p:spPr>
          <a:xfrm>
            <a:off x="11138006" y="495875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C17B2BAD-5AD0-4163-B828-49471661F89E}"/>
              </a:ext>
            </a:extLst>
          </p:cNvPr>
          <p:cNvSpPr txBox="1"/>
          <p:nvPr/>
        </p:nvSpPr>
        <p:spPr>
          <a:xfrm>
            <a:off x="10369311" y="495875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CB108A0F-9400-4DC8-8C85-D6D6587642C4}"/>
              </a:ext>
            </a:extLst>
          </p:cNvPr>
          <p:cNvCxnSpPr>
            <a:cxnSpLocks/>
          </p:cNvCxnSpPr>
          <p:nvPr/>
        </p:nvCxnSpPr>
        <p:spPr>
          <a:xfrm>
            <a:off x="10375426" y="493160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C373163A-7172-4247-A097-86E23B37FF9B}"/>
              </a:ext>
            </a:extLst>
          </p:cNvPr>
          <p:cNvCxnSpPr>
            <a:cxnSpLocks/>
          </p:cNvCxnSpPr>
          <p:nvPr/>
        </p:nvCxnSpPr>
        <p:spPr>
          <a:xfrm>
            <a:off x="11147758" y="493160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E9F7EC60-3119-418E-9627-BD137F3D0345}"/>
              </a:ext>
            </a:extLst>
          </p:cNvPr>
          <p:cNvSpPr txBox="1"/>
          <p:nvPr/>
        </p:nvSpPr>
        <p:spPr>
          <a:xfrm>
            <a:off x="9572699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F1314B83-6E26-4D89-9E6C-B699D3C86BEE}"/>
              </a:ext>
            </a:extLst>
          </p:cNvPr>
          <p:cNvSpPr txBox="1"/>
          <p:nvPr/>
        </p:nvSpPr>
        <p:spPr>
          <a:xfrm>
            <a:off x="9950294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560D8A27-ADA3-4055-BC98-25A34D72F405}"/>
              </a:ext>
            </a:extLst>
          </p:cNvPr>
          <p:cNvSpPr txBox="1"/>
          <p:nvPr/>
        </p:nvSpPr>
        <p:spPr>
          <a:xfrm>
            <a:off x="10327889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BB864463-887C-49C2-BADD-8B4489DFE96B}"/>
              </a:ext>
            </a:extLst>
          </p:cNvPr>
          <p:cNvSpPr txBox="1"/>
          <p:nvPr/>
        </p:nvSpPr>
        <p:spPr>
          <a:xfrm>
            <a:off x="10705484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E35F25C9-F4A5-4D84-B5C0-4DAE512A852E}"/>
              </a:ext>
            </a:extLst>
          </p:cNvPr>
          <p:cNvSpPr txBox="1"/>
          <p:nvPr/>
        </p:nvSpPr>
        <p:spPr>
          <a:xfrm>
            <a:off x="11083079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FC205EF8-0A3C-4E48-A325-56B3C45EED08}"/>
              </a:ext>
            </a:extLst>
          </p:cNvPr>
          <p:cNvSpPr txBox="1"/>
          <p:nvPr/>
        </p:nvSpPr>
        <p:spPr>
          <a:xfrm>
            <a:off x="11460674" y="3893463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F7A2F430-8D61-4E61-B304-C353B57FEDF6}"/>
              </a:ext>
            </a:extLst>
          </p:cNvPr>
          <p:cNvSpPr txBox="1"/>
          <p:nvPr/>
        </p:nvSpPr>
        <p:spPr>
          <a:xfrm>
            <a:off x="9963512" y="3507431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-R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7FB0AE6E-DB6B-442C-BE48-99A6BBA9D19F}"/>
              </a:ext>
            </a:extLst>
          </p:cNvPr>
          <p:cNvCxnSpPr>
            <a:cxnSpLocks/>
          </p:cNvCxnSpPr>
          <p:nvPr/>
        </p:nvCxnSpPr>
        <p:spPr>
          <a:xfrm>
            <a:off x="9603094" y="3893463"/>
            <a:ext cx="21808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79255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(left) and p54 (right) for Fig. 5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062584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and p-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091815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54 and 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59366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7824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99181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2193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60348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9771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54614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7292795" y="35410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7292795" y="372985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7292795" y="39391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7292795" y="41784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7292795" y="462120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7292795" y="50534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7292795" y="563420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96D32F2E-BE9A-4A78-A1AE-060763B90E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9057" y="3515701"/>
            <a:ext cx="5585250" cy="2944080"/>
          </a:xfrm>
          <a:prstGeom prst="rect">
            <a:avLst/>
          </a:prstGeom>
        </p:spPr>
      </p:pic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475AD326-18E7-4CA1-97C9-253EA52D988C}"/>
              </a:ext>
            </a:extLst>
          </p:cNvPr>
          <p:cNvGrpSpPr/>
          <p:nvPr/>
        </p:nvGrpSpPr>
        <p:grpSpPr>
          <a:xfrm>
            <a:off x="1343385" y="3832826"/>
            <a:ext cx="4556496" cy="1875250"/>
            <a:chOff x="1472339" y="2866029"/>
            <a:chExt cx="4556496" cy="1875250"/>
          </a:xfrm>
        </p:grpSpPr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070CFC67-E1F4-4161-A4DB-37511ED10C64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A122F518-B81C-4EFA-8012-B8045E0245CB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A55E4020-2D7D-4D90-B014-7833F1D0D8F3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4F5584EA-2329-45A5-A572-0F82203A7A18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4520F114-EC6D-4851-A4B9-7E4758CC3F7F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9473C025-31A4-466E-BA51-A92696BEB52F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B190C53D-CF98-4DDE-85AE-68071E516FB0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2D640C1-37BE-4788-A523-5145BA670780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749C1D86-9081-4483-87EC-9BA917979297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C656E947-0210-479C-89B6-8EF462A942F8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4D1856CD-7EB8-421F-8286-F36749A6603F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C8977840-6BB7-4CE8-A29B-689EA2875EBC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8D49FC0B-353B-46B1-8A17-1412F4B15964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422794EA-050D-47F7-A93A-F736D422BE6A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67F614C7-8E60-452B-B887-5A8770892A62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ADD6E39B-0177-4E38-9E15-4FA92CE7C2B2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A166DC26-EF42-445E-9D5D-DE4103BF6AB4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B6897629-D700-493A-963E-60FDDDDF4825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8C201A56-D765-4A84-A2B0-04C337788541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3AEF9D39-565F-4366-8314-8CEA3954CF6E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FF9B9B1D-8DEE-49F6-B9EC-BF044685F10E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D1B3AC34-3EA7-4AAE-9708-F80786E3E809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AFCEE9A8-CB18-4BB3-B3B5-55AAC289BEDD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D3310DF6-B452-4D66-9C67-3838E8C177EE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940D1C4E-CBC5-4E83-ACA7-901C20CDE3AB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E037C689-8C43-47F6-AC49-B32FE64EA255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図 8">
            <a:extLst>
              <a:ext uri="{FF2B5EF4-FFF2-40B4-BE49-F238E27FC236}">
                <a16:creationId xmlns:a16="http://schemas.microsoft.com/office/drawing/2014/main" id="{3B8BC7F6-184A-4CDF-9886-29F686101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31046" y="3515701"/>
            <a:ext cx="5610638" cy="2842560"/>
          </a:xfrm>
          <a:prstGeom prst="rect">
            <a:avLst/>
          </a:prstGeom>
        </p:spPr>
      </p:pic>
      <p:grpSp>
        <p:nvGrpSpPr>
          <p:cNvPr id="174" name="グループ化 173">
            <a:extLst>
              <a:ext uri="{FF2B5EF4-FFF2-40B4-BE49-F238E27FC236}">
                <a16:creationId xmlns:a16="http://schemas.microsoft.com/office/drawing/2014/main" id="{1C427852-DEDD-4450-B86C-8E297B901B0B}"/>
              </a:ext>
            </a:extLst>
          </p:cNvPr>
          <p:cNvGrpSpPr/>
          <p:nvPr/>
        </p:nvGrpSpPr>
        <p:grpSpPr>
          <a:xfrm>
            <a:off x="8541353" y="3797656"/>
            <a:ext cx="4556496" cy="1875250"/>
            <a:chOff x="1472339" y="2866029"/>
            <a:chExt cx="4556496" cy="1875250"/>
          </a:xfrm>
        </p:grpSpPr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id="{94F05D35-F315-4324-B8EE-566E1DEBB467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45BB8F06-42F3-4505-A41C-CEE903EAC538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ED82DD9A-1C5E-4A9F-85E3-72823F077271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2EE14885-AE35-42E4-ABBD-B9B36E07D4E9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A5F7C5F8-8274-44E9-8070-1042D97B18C0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6D103B88-D255-4C01-935D-20C270DA40E4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73984D8F-7388-4261-86FC-854DF7945556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3D7F08C9-8C0A-40B0-8D40-1B31DF91D5F5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12C415FB-4862-4A97-A146-9F4E02F89658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98D022B6-280B-47C6-B7A8-220A979B5CB2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5" name="直線コネクタ 184">
              <a:extLst>
                <a:ext uri="{FF2B5EF4-FFF2-40B4-BE49-F238E27FC236}">
                  <a16:creationId xmlns:a16="http://schemas.microsoft.com/office/drawing/2014/main" id="{5C5B0E45-9AE6-47CE-B738-E4C2743D4633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71D1479E-CA0B-435C-860B-0B1C81E1769D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0A4AD2B9-606C-4AA3-8A4F-539F22AAF108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0AC87A0E-858B-4740-AC60-C0556F5CDED3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E1947F6C-1FE9-417C-904F-7B7D1382CC47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F4EDDE1A-E920-41A5-88E6-FC2687D7C4E4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6E0FDB8A-A8DD-40E6-A7DA-097392960F07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78298B02-86CC-4513-80A2-F4E0C959976F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E59FC47F-6278-40BE-AF78-2054F4D7C708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85EC3B89-D443-47A7-B115-2E40974A3AFE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F32F331B-D14D-4BD2-9C34-05E7597EE2CB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BD59FF71-86C9-4BC7-9690-D8E53CBBBEF5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2D577BF3-54DD-4F31-B003-B7B23B1DBB46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384F0B5D-7340-440E-BE19-944FC85F71E0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C6C56E37-8D64-498A-A192-ACD9054B2401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0" name="直線コネクタ 199">
              <a:extLst>
                <a:ext uri="{FF2B5EF4-FFF2-40B4-BE49-F238E27FC236}">
                  <a16:creationId xmlns:a16="http://schemas.microsoft.com/office/drawing/2014/main" id="{AA9B8A39-A68A-42BC-A2BD-0FA8E4C37821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522296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83BEB4-A975-4A1D-83AA-70109F9B1636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 (left) and p65 (right) for Fig. 6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9DE8C31-BF52-41E0-B6D4-0BD67FEB99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8510" y="3496062"/>
            <a:ext cx="5839126" cy="319788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19DC9A9-94C3-4F0E-B7A1-79A75B3188BF}"/>
              </a:ext>
            </a:extLst>
          </p:cNvPr>
          <p:cNvSpPr txBox="1"/>
          <p:nvPr/>
        </p:nvSpPr>
        <p:spPr>
          <a:xfrm>
            <a:off x="116237" y="359366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61278E7-180B-49B0-A44D-560CD42E6D9F}"/>
              </a:ext>
            </a:extLst>
          </p:cNvPr>
          <p:cNvSpPr txBox="1"/>
          <p:nvPr/>
        </p:nvSpPr>
        <p:spPr>
          <a:xfrm>
            <a:off x="116237" y="37824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7DE2CD3-B2A7-4164-8D92-F193A3FBD054}"/>
              </a:ext>
            </a:extLst>
          </p:cNvPr>
          <p:cNvSpPr txBox="1"/>
          <p:nvPr/>
        </p:nvSpPr>
        <p:spPr>
          <a:xfrm>
            <a:off x="116237" y="399181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97BACA7-393A-44B1-AE17-8C9C6F06FAD0}"/>
              </a:ext>
            </a:extLst>
          </p:cNvPr>
          <p:cNvSpPr txBox="1"/>
          <p:nvPr/>
        </p:nvSpPr>
        <p:spPr>
          <a:xfrm>
            <a:off x="116237" y="42193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675C008-E48C-47B0-88B6-C9195FD7E8BB}"/>
              </a:ext>
            </a:extLst>
          </p:cNvPr>
          <p:cNvSpPr txBox="1"/>
          <p:nvPr/>
        </p:nvSpPr>
        <p:spPr>
          <a:xfrm>
            <a:off x="116237" y="470961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66DDAFC-202C-4358-A4B1-F513185DC380}"/>
              </a:ext>
            </a:extLst>
          </p:cNvPr>
          <p:cNvSpPr txBox="1"/>
          <p:nvPr/>
        </p:nvSpPr>
        <p:spPr>
          <a:xfrm>
            <a:off x="116237" y="508328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63AD324-32C0-40CE-96C7-1A7EFF4EDA63}"/>
              </a:ext>
            </a:extLst>
          </p:cNvPr>
          <p:cNvSpPr txBox="1"/>
          <p:nvPr/>
        </p:nvSpPr>
        <p:spPr>
          <a:xfrm>
            <a:off x="116237" y="578291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9F658678-1351-4257-B682-10436F4EB35B}"/>
              </a:ext>
            </a:extLst>
          </p:cNvPr>
          <p:cNvGrpSpPr/>
          <p:nvPr/>
        </p:nvGrpSpPr>
        <p:grpSpPr>
          <a:xfrm>
            <a:off x="1651365" y="3628719"/>
            <a:ext cx="4479612" cy="1744621"/>
            <a:chOff x="1651365" y="3628719"/>
            <a:chExt cx="4479612" cy="1744621"/>
          </a:xfrm>
        </p:grpSpPr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9B334650-7F2B-4DB3-B929-621D825E00A3}"/>
                </a:ext>
              </a:extLst>
            </p:cNvPr>
            <p:cNvGrpSpPr/>
            <p:nvPr/>
          </p:nvGrpSpPr>
          <p:grpSpPr>
            <a:xfrm>
              <a:off x="1708515" y="4976858"/>
              <a:ext cx="667746" cy="396482"/>
              <a:chOff x="1635037" y="5107487"/>
              <a:chExt cx="667746" cy="396482"/>
            </a:xfrm>
          </p:grpSpPr>
          <p:cxnSp>
            <p:nvCxnSpPr>
              <p:cNvPr id="14" name="直線コネクタ 13">
                <a:extLst>
                  <a:ext uri="{FF2B5EF4-FFF2-40B4-BE49-F238E27FC236}">
                    <a16:creationId xmlns:a16="http://schemas.microsoft.com/office/drawing/2014/main" id="{F868CA5D-3BE1-4964-9136-90BEE61C64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35037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62DDB383-1968-4435-BB72-6494F3201D6A}"/>
                  </a:ext>
                </a:extLst>
              </p:cNvPr>
              <p:cNvSpPr txBox="1"/>
              <p:nvPr/>
            </p:nvSpPr>
            <p:spPr>
              <a:xfrm>
                <a:off x="1640309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kumimoji="1" lang="en-US" altLang="ja-JP" b="1" baseline="-1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5FA61A5A-00DF-4E4F-83AE-009A50963626}"/>
                </a:ext>
              </a:extLst>
            </p:cNvPr>
            <p:cNvGrpSpPr/>
            <p:nvPr/>
          </p:nvGrpSpPr>
          <p:grpSpPr>
            <a:xfrm>
              <a:off x="2449136" y="4976858"/>
              <a:ext cx="662474" cy="396482"/>
              <a:chOff x="2401254" y="5107487"/>
              <a:chExt cx="662474" cy="396482"/>
            </a:xfrm>
          </p:grpSpPr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BBC386E1-0717-4B13-8370-E4C0FF15194F}"/>
                  </a:ext>
                </a:extLst>
              </p:cNvPr>
              <p:cNvSpPr txBox="1"/>
              <p:nvPr/>
            </p:nvSpPr>
            <p:spPr>
              <a:xfrm>
                <a:off x="2401254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線コネクタ 17">
                <a:extLst>
                  <a:ext uri="{FF2B5EF4-FFF2-40B4-BE49-F238E27FC236}">
                    <a16:creationId xmlns:a16="http://schemas.microsoft.com/office/drawing/2014/main" id="{BF027577-851E-47D7-A97A-9F3A5737CC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7369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62A0166A-C985-47A8-82F7-250F92C1F508}"/>
                </a:ext>
              </a:extLst>
            </p:cNvPr>
            <p:cNvGrpSpPr/>
            <p:nvPr/>
          </p:nvGrpSpPr>
          <p:grpSpPr>
            <a:xfrm>
              <a:off x="3184485" y="4976858"/>
              <a:ext cx="662474" cy="396482"/>
              <a:chOff x="3169949" y="5107487"/>
              <a:chExt cx="662474" cy="396482"/>
            </a:xfrm>
          </p:grpSpPr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4947F4FE-BD9B-45EF-BBEC-8B7AF6C35FC2}"/>
                  </a:ext>
                </a:extLst>
              </p:cNvPr>
              <p:cNvSpPr txBox="1"/>
              <p:nvPr/>
            </p:nvSpPr>
            <p:spPr>
              <a:xfrm>
                <a:off x="3169949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3CB27D23-05D5-4FE8-B1F8-064A80F314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9701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A52FEC6E-E3EF-42BE-BEF4-66B43F487EBB}"/>
                </a:ext>
              </a:extLst>
            </p:cNvPr>
            <p:cNvGrpSpPr/>
            <p:nvPr/>
          </p:nvGrpSpPr>
          <p:grpSpPr>
            <a:xfrm>
              <a:off x="3919834" y="4976858"/>
              <a:ext cx="667746" cy="396482"/>
              <a:chOff x="3926204" y="5107487"/>
              <a:chExt cx="667746" cy="396482"/>
            </a:xfrm>
          </p:grpSpPr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FAC8649A-5771-4AD2-9473-BA3793EB21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6204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BE64A6E4-E218-4E96-B370-997EDBCE9D0B}"/>
                  </a:ext>
                </a:extLst>
              </p:cNvPr>
              <p:cNvSpPr txBox="1"/>
              <p:nvPr/>
            </p:nvSpPr>
            <p:spPr>
              <a:xfrm>
                <a:off x="3931476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kumimoji="1" lang="en-US" altLang="ja-JP" b="1" baseline="-1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6CC10720-BEA2-424F-A0A8-68709849D321}"/>
                </a:ext>
              </a:extLst>
            </p:cNvPr>
            <p:cNvGrpSpPr/>
            <p:nvPr/>
          </p:nvGrpSpPr>
          <p:grpSpPr>
            <a:xfrm>
              <a:off x="4660455" y="4976858"/>
              <a:ext cx="662474" cy="396482"/>
              <a:chOff x="4692421" y="5107487"/>
              <a:chExt cx="662474" cy="396482"/>
            </a:xfrm>
          </p:grpSpPr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A958F053-8333-40CA-9A1C-2C197ADAD7AC}"/>
                  </a:ext>
                </a:extLst>
              </p:cNvPr>
              <p:cNvSpPr txBox="1"/>
              <p:nvPr/>
            </p:nvSpPr>
            <p:spPr>
              <a:xfrm>
                <a:off x="4692421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8F0F10E7-07D5-4320-AA2F-11B7900C92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98536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C6284623-7ACF-4D4C-BB7A-37D0E247442C}"/>
                </a:ext>
              </a:extLst>
            </p:cNvPr>
            <p:cNvGrpSpPr/>
            <p:nvPr/>
          </p:nvGrpSpPr>
          <p:grpSpPr>
            <a:xfrm>
              <a:off x="5395802" y="4976858"/>
              <a:ext cx="662474" cy="396482"/>
              <a:chOff x="5461116" y="5107487"/>
              <a:chExt cx="662474" cy="396482"/>
            </a:xfrm>
          </p:grpSpPr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029AAC14-7AE6-482A-BAD2-7AF827BE1973}"/>
                  </a:ext>
                </a:extLst>
              </p:cNvPr>
              <p:cNvSpPr txBox="1"/>
              <p:nvPr/>
            </p:nvSpPr>
            <p:spPr>
              <a:xfrm>
                <a:off x="5461116" y="5134637"/>
                <a:ext cx="662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9D87F3F4-E9EA-4B8F-A6BA-E79C9EE3E6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0868" y="5107487"/>
                <a:ext cx="64378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6FB8A46-F437-4601-9C83-FABD89F6CDF5}"/>
                </a:ext>
              </a:extLst>
            </p:cNvPr>
            <p:cNvSpPr txBox="1"/>
            <p:nvPr/>
          </p:nvSpPr>
          <p:spPr>
            <a:xfrm>
              <a:off x="1669956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A4E251CD-07FF-4697-9CBD-32FE94224798}"/>
                </a:ext>
              </a:extLst>
            </p:cNvPr>
            <p:cNvSpPr txBox="1"/>
            <p:nvPr/>
          </p:nvSpPr>
          <p:spPr>
            <a:xfrm>
              <a:off x="2037902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F7EBF8F3-FC08-4BD0-BC52-066FF21A0AE3}"/>
                </a:ext>
              </a:extLst>
            </p:cNvPr>
            <p:cNvSpPr txBox="1"/>
            <p:nvPr/>
          </p:nvSpPr>
          <p:spPr>
            <a:xfrm>
              <a:off x="2405848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90C4E9F3-7B89-4C52-BDD5-F3BF7DFD9176}"/>
                </a:ext>
              </a:extLst>
            </p:cNvPr>
            <p:cNvSpPr txBox="1"/>
            <p:nvPr/>
          </p:nvSpPr>
          <p:spPr>
            <a:xfrm>
              <a:off x="2773794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B1B6B87D-6E29-4EEB-BE6B-C3E95E5E5D4A}"/>
                </a:ext>
              </a:extLst>
            </p:cNvPr>
            <p:cNvSpPr txBox="1"/>
            <p:nvPr/>
          </p:nvSpPr>
          <p:spPr>
            <a:xfrm>
              <a:off x="3141740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DC54696B-E488-4ED7-B7D3-B769F23B0FAF}"/>
                </a:ext>
              </a:extLst>
            </p:cNvPr>
            <p:cNvSpPr txBox="1"/>
            <p:nvPr/>
          </p:nvSpPr>
          <p:spPr>
            <a:xfrm>
              <a:off x="3509686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91035C9E-C188-439C-9E8A-16E232EAD0C2}"/>
                </a:ext>
              </a:extLst>
            </p:cNvPr>
            <p:cNvSpPr txBox="1"/>
            <p:nvPr/>
          </p:nvSpPr>
          <p:spPr>
            <a:xfrm>
              <a:off x="3877632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E2A82E0-3227-4530-8B54-A9A773D692A4}"/>
                </a:ext>
              </a:extLst>
            </p:cNvPr>
            <p:cNvSpPr txBox="1"/>
            <p:nvPr/>
          </p:nvSpPr>
          <p:spPr>
            <a:xfrm>
              <a:off x="4245578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D0D83BD1-8B87-4C45-AB2F-D9E00E60D093}"/>
                </a:ext>
              </a:extLst>
            </p:cNvPr>
            <p:cNvSpPr txBox="1"/>
            <p:nvPr/>
          </p:nvSpPr>
          <p:spPr>
            <a:xfrm>
              <a:off x="4613524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E9039757-F8E8-4304-B769-876D9406FAAA}"/>
                </a:ext>
              </a:extLst>
            </p:cNvPr>
            <p:cNvSpPr txBox="1"/>
            <p:nvPr/>
          </p:nvSpPr>
          <p:spPr>
            <a:xfrm>
              <a:off x="4981470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4F1502BD-A297-4021-A361-2B21788F2738}"/>
                </a:ext>
              </a:extLst>
            </p:cNvPr>
            <p:cNvSpPr txBox="1"/>
            <p:nvPr/>
          </p:nvSpPr>
          <p:spPr>
            <a:xfrm>
              <a:off x="5349416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N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78A2FAB-4238-4E1C-878A-5059EFD6A5A1}"/>
                </a:ext>
              </a:extLst>
            </p:cNvPr>
            <p:cNvSpPr txBox="1"/>
            <p:nvPr/>
          </p:nvSpPr>
          <p:spPr>
            <a:xfrm>
              <a:off x="5717363" y="401475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endParaRPr kumimoji="1" lang="ja-JP" altLang="en-US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8ED62BA6-66BC-4160-967A-AD6C2F622A76}"/>
                </a:ext>
              </a:extLst>
            </p:cNvPr>
            <p:cNvSpPr txBox="1"/>
            <p:nvPr/>
          </p:nvSpPr>
          <p:spPr>
            <a:xfrm>
              <a:off x="3049086" y="362871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A40D24DF-3871-4B33-AFCB-0C5132E4F96E}"/>
                </a:ext>
              </a:extLst>
            </p:cNvPr>
            <p:cNvCxnSpPr>
              <a:cxnSpLocks/>
            </p:cNvCxnSpPr>
            <p:nvPr/>
          </p:nvCxnSpPr>
          <p:spPr>
            <a:xfrm>
              <a:off x="1651365" y="402777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3AD906B-4CBF-4E0E-8485-7050099FECF7}"/>
              </a:ext>
            </a:extLst>
          </p:cNvPr>
          <p:cNvSpPr txBox="1"/>
          <p:nvPr/>
        </p:nvSpPr>
        <p:spPr>
          <a:xfrm>
            <a:off x="1025995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DEBA313-AB5E-436C-8CD5-4120590B4F40}"/>
              </a:ext>
            </a:extLst>
          </p:cNvPr>
          <p:cNvSpPr txBox="1"/>
          <p:nvPr/>
        </p:nvSpPr>
        <p:spPr>
          <a:xfrm>
            <a:off x="8091815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772A80B-8285-4DB5-B039-FA3BB0C63D50}"/>
              </a:ext>
            </a:extLst>
          </p:cNvPr>
          <p:cNvSpPr txBox="1"/>
          <p:nvPr/>
        </p:nvSpPr>
        <p:spPr>
          <a:xfrm>
            <a:off x="116237" y="60822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6A6D4AB-6CE0-45F3-810C-8EF5FC25B991}"/>
              </a:ext>
            </a:extLst>
          </p:cNvPr>
          <p:cNvSpPr txBox="1"/>
          <p:nvPr/>
        </p:nvSpPr>
        <p:spPr>
          <a:xfrm>
            <a:off x="116237" y="642244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id="{03F6A8E3-BFE9-4571-92C0-9EA9925003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68832" y="3630776"/>
            <a:ext cx="5737576" cy="2791800"/>
          </a:xfrm>
          <a:prstGeom prst="rect">
            <a:avLst/>
          </a:prstGeom>
        </p:spPr>
      </p:pic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D4BF06B7-3C8B-4991-AEF8-2D0D176F1A22}"/>
              </a:ext>
            </a:extLst>
          </p:cNvPr>
          <p:cNvGrpSpPr/>
          <p:nvPr/>
        </p:nvGrpSpPr>
        <p:grpSpPr>
          <a:xfrm>
            <a:off x="8666664" y="4881063"/>
            <a:ext cx="667746" cy="396482"/>
            <a:chOff x="1635037" y="5107487"/>
            <a:chExt cx="667746" cy="396482"/>
          </a:xfrm>
        </p:grpSpPr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C01DAF9D-155A-4ACD-ABA4-E05BE7316695}"/>
                </a:ext>
              </a:extLst>
            </p:cNvPr>
            <p:cNvCxnSpPr>
              <a:cxnSpLocks/>
            </p:cNvCxnSpPr>
            <p:nvPr/>
          </p:nvCxnSpPr>
          <p:spPr>
            <a:xfrm>
              <a:off x="1635037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D8D2D99E-78AB-499F-830A-8E401F729275}"/>
                </a:ext>
              </a:extLst>
            </p:cNvPr>
            <p:cNvSpPr txBox="1"/>
            <p:nvPr/>
          </p:nvSpPr>
          <p:spPr>
            <a:xfrm>
              <a:off x="164030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0B6BA552-E4F7-41B4-B4FA-D0C39E3FF183}"/>
              </a:ext>
            </a:extLst>
          </p:cNvPr>
          <p:cNvGrpSpPr/>
          <p:nvPr/>
        </p:nvGrpSpPr>
        <p:grpSpPr>
          <a:xfrm>
            <a:off x="9407285" y="4881063"/>
            <a:ext cx="662474" cy="396482"/>
            <a:chOff x="2401254" y="5107487"/>
            <a:chExt cx="662474" cy="396482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52410F7-7CD9-4203-BE68-F33C534D826B}"/>
                </a:ext>
              </a:extLst>
            </p:cNvPr>
            <p:cNvSpPr txBox="1"/>
            <p:nvPr/>
          </p:nvSpPr>
          <p:spPr>
            <a:xfrm>
              <a:off x="2401254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0648D0AF-7333-4715-9CF5-64C89873E907}"/>
                </a:ext>
              </a:extLst>
            </p:cNvPr>
            <p:cNvCxnSpPr>
              <a:cxnSpLocks/>
            </p:cNvCxnSpPr>
            <p:nvPr/>
          </p:nvCxnSpPr>
          <p:spPr>
            <a:xfrm>
              <a:off x="2407369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239E57B2-EB4D-4DE4-A7C7-A4E161D13861}"/>
              </a:ext>
            </a:extLst>
          </p:cNvPr>
          <p:cNvGrpSpPr/>
          <p:nvPr/>
        </p:nvGrpSpPr>
        <p:grpSpPr>
          <a:xfrm>
            <a:off x="10142634" y="4881063"/>
            <a:ext cx="662474" cy="396482"/>
            <a:chOff x="3169949" y="5107487"/>
            <a:chExt cx="662474" cy="396482"/>
          </a:xfrm>
        </p:grpSpPr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4361A61C-E961-4DC5-9D35-7B837365DB2B}"/>
                </a:ext>
              </a:extLst>
            </p:cNvPr>
            <p:cNvSpPr txBox="1"/>
            <p:nvPr/>
          </p:nvSpPr>
          <p:spPr>
            <a:xfrm>
              <a:off x="316994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42664D46-1986-4104-AAAB-ECA3321FDB82}"/>
                </a:ext>
              </a:extLst>
            </p:cNvPr>
            <p:cNvCxnSpPr>
              <a:cxnSpLocks/>
            </p:cNvCxnSpPr>
            <p:nvPr/>
          </p:nvCxnSpPr>
          <p:spPr>
            <a:xfrm>
              <a:off x="3179701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E20C9ECE-10CB-4E86-A5F6-E5CDCDB2622B}"/>
              </a:ext>
            </a:extLst>
          </p:cNvPr>
          <p:cNvGrpSpPr/>
          <p:nvPr/>
        </p:nvGrpSpPr>
        <p:grpSpPr>
          <a:xfrm>
            <a:off x="10877983" y="4881063"/>
            <a:ext cx="667746" cy="396482"/>
            <a:chOff x="3926204" y="5107487"/>
            <a:chExt cx="667746" cy="396482"/>
          </a:xfrm>
        </p:grpSpPr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3F4E6FE6-AA3D-4922-B253-7197CA2D3BFB}"/>
                </a:ext>
              </a:extLst>
            </p:cNvPr>
            <p:cNvCxnSpPr>
              <a:cxnSpLocks/>
            </p:cNvCxnSpPr>
            <p:nvPr/>
          </p:nvCxnSpPr>
          <p:spPr>
            <a:xfrm>
              <a:off x="3926204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32C09A3C-6F38-4545-9131-1DA28083952D}"/>
                </a:ext>
              </a:extLst>
            </p:cNvPr>
            <p:cNvSpPr txBox="1"/>
            <p:nvPr/>
          </p:nvSpPr>
          <p:spPr>
            <a:xfrm>
              <a:off x="393147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69695EF8-E111-4C10-A11B-FF23551429F1}"/>
              </a:ext>
            </a:extLst>
          </p:cNvPr>
          <p:cNvGrpSpPr/>
          <p:nvPr/>
        </p:nvGrpSpPr>
        <p:grpSpPr>
          <a:xfrm>
            <a:off x="11618604" y="4881063"/>
            <a:ext cx="662474" cy="396482"/>
            <a:chOff x="4692421" y="5107487"/>
            <a:chExt cx="662474" cy="396482"/>
          </a:xfrm>
        </p:grpSpPr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C1DE3E59-017D-49C1-9C39-A5B963E4F4E4}"/>
                </a:ext>
              </a:extLst>
            </p:cNvPr>
            <p:cNvSpPr txBox="1"/>
            <p:nvPr/>
          </p:nvSpPr>
          <p:spPr>
            <a:xfrm>
              <a:off x="4692421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D6998373-83E3-4380-B257-7F0B474F24FB}"/>
                </a:ext>
              </a:extLst>
            </p:cNvPr>
            <p:cNvCxnSpPr>
              <a:cxnSpLocks/>
            </p:cNvCxnSpPr>
            <p:nvPr/>
          </p:nvCxnSpPr>
          <p:spPr>
            <a:xfrm>
              <a:off x="4698536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4784183F-77DE-48C4-8982-E29CE7D2A527}"/>
              </a:ext>
            </a:extLst>
          </p:cNvPr>
          <p:cNvGrpSpPr/>
          <p:nvPr/>
        </p:nvGrpSpPr>
        <p:grpSpPr>
          <a:xfrm>
            <a:off x="12353951" y="4881063"/>
            <a:ext cx="662474" cy="396482"/>
            <a:chOff x="5461116" y="5107487"/>
            <a:chExt cx="662474" cy="396482"/>
          </a:xfrm>
        </p:grpSpPr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58680884-1696-474A-A021-AAA9F9AFA661}"/>
                </a:ext>
              </a:extLst>
            </p:cNvPr>
            <p:cNvSpPr txBox="1"/>
            <p:nvPr/>
          </p:nvSpPr>
          <p:spPr>
            <a:xfrm>
              <a:off x="546111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255ECB35-2A93-4013-804C-C5438B1ED584}"/>
                </a:ext>
              </a:extLst>
            </p:cNvPr>
            <p:cNvCxnSpPr>
              <a:cxnSpLocks/>
            </p:cNvCxnSpPr>
            <p:nvPr/>
          </p:nvCxnSpPr>
          <p:spPr>
            <a:xfrm>
              <a:off x="5470868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DA7E7B93-4BB8-423F-B26F-9C43420BCF37}"/>
              </a:ext>
            </a:extLst>
          </p:cNvPr>
          <p:cNvSpPr txBox="1"/>
          <p:nvPr/>
        </p:nvSpPr>
        <p:spPr>
          <a:xfrm>
            <a:off x="8628105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F347C989-E920-47BA-85D3-75770F0CE551}"/>
              </a:ext>
            </a:extLst>
          </p:cNvPr>
          <p:cNvSpPr txBox="1"/>
          <p:nvPr/>
        </p:nvSpPr>
        <p:spPr>
          <a:xfrm>
            <a:off x="8996051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324FB1D-CBEA-4438-A3BE-B68488C791FB}"/>
              </a:ext>
            </a:extLst>
          </p:cNvPr>
          <p:cNvSpPr txBox="1"/>
          <p:nvPr/>
        </p:nvSpPr>
        <p:spPr>
          <a:xfrm>
            <a:off x="9363997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065C3AA4-2FB3-4DA9-8094-B646732CACD2}"/>
              </a:ext>
            </a:extLst>
          </p:cNvPr>
          <p:cNvSpPr txBox="1"/>
          <p:nvPr/>
        </p:nvSpPr>
        <p:spPr>
          <a:xfrm>
            <a:off x="9731943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E4DB85E-63FC-42F6-B4FB-0F6A712527CE}"/>
              </a:ext>
            </a:extLst>
          </p:cNvPr>
          <p:cNvSpPr txBox="1"/>
          <p:nvPr/>
        </p:nvSpPr>
        <p:spPr>
          <a:xfrm>
            <a:off x="10099889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66C1605-55CF-4B85-AFB0-FC81817CF266}"/>
              </a:ext>
            </a:extLst>
          </p:cNvPr>
          <p:cNvSpPr txBox="1"/>
          <p:nvPr/>
        </p:nvSpPr>
        <p:spPr>
          <a:xfrm>
            <a:off x="10467835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ABE38180-5B05-42C3-BA18-5C141C252DB3}"/>
              </a:ext>
            </a:extLst>
          </p:cNvPr>
          <p:cNvSpPr txBox="1"/>
          <p:nvPr/>
        </p:nvSpPr>
        <p:spPr>
          <a:xfrm>
            <a:off x="10835781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A84E43A-C7F2-4233-A8CD-40BB67CDBF16}"/>
              </a:ext>
            </a:extLst>
          </p:cNvPr>
          <p:cNvSpPr txBox="1"/>
          <p:nvPr/>
        </p:nvSpPr>
        <p:spPr>
          <a:xfrm>
            <a:off x="11203727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83520DE-6415-4E1D-969E-A9CEA403DF46}"/>
              </a:ext>
            </a:extLst>
          </p:cNvPr>
          <p:cNvSpPr txBox="1"/>
          <p:nvPr/>
        </p:nvSpPr>
        <p:spPr>
          <a:xfrm>
            <a:off x="11571673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A22F28F-EDB3-41B4-872A-143644E746F8}"/>
              </a:ext>
            </a:extLst>
          </p:cNvPr>
          <p:cNvSpPr txBox="1"/>
          <p:nvPr/>
        </p:nvSpPr>
        <p:spPr>
          <a:xfrm>
            <a:off x="11939619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3C5F638D-6184-42E9-B130-156FB0D28961}"/>
              </a:ext>
            </a:extLst>
          </p:cNvPr>
          <p:cNvSpPr txBox="1"/>
          <p:nvPr/>
        </p:nvSpPr>
        <p:spPr>
          <a:xfrm>
            <a:off x="12307565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92FBF3B-9689-4639-A16B-242B443AB612}"/>
              </a:ext>
            </a:extLst>
          </p:cNvPr>
          <p:cNvSpPr txBox="1"/>
          <p:nvPr/>
        </p:nvSpPr>
        <p:spPr>
          <a:xfrm>
            <a:off x="12675512" y="39712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3494C5B-D23E-401E-8D70-A2BA65AF1104}"/>
              </a:ext>
            </a:extLst>
          </p:cNvPr>
          <p:cNvSpPr txBox="1"/>
          <p:nvPr/>
        </p:nvSpPr>
        <p:spPr>
          <a:xfrm>
            <a:off x="10007235" y="3585175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65686D6E-1F76-4A72-B779-E7401A7E6767}"/>
              </a:ext>
            </a:extLst>
          </p:cNvPr>
          <p:cNvCxnSpPr>
            <a:cxnSpLocks/>
          </p:cNvCxnSpPr>
          <p:nvPr/>
        </p:nvCxnSpPr>
        <p:spPr>
          <a:xfrm>
            <a:off x="8609514" y="3984230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896E332-1A93-4DA2-9129-45D07CE8DCF3}"/>
              </a:ext>
            </a:extLst>
          </p:cNvPr>
          <p:cNvSpPr txBox="1"/>
          <p:nvPr/>
        </p:nvSpPr>
        <p:spPr>
          <a:xfrm>
            <a:off x="7241962" y="36928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63BCB99-D793-41D1-B7D4-E8CF534913B6}"/>
              </a:ext>
            </a:extLst>
          </p:cNvPr>
          <p:cNvSpPr txBox="1"/>
          <p:nvPr/>
        </p:nvSpPr>
        <p:spPr>
          <a:xfrm>
            <a:off x="7241962" y="38546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89E19E9-A7FA-477D-91F8-C8E764933E3A}"/>
              </a:ext>
            </a:extLst>
          </p:cNvPr>
          <p:cNvSpPr txBox="1"/>
          <p:nvPr/>
        </p:nvSpPr>
        <p:spPr>
          <a:xfrm>
            <a:off x="7241962" y="40531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0AFC432B-975E-4707-8BE9-C71896FEAA8D}"/>
              </a:ext>
            </a:extLst>
          </p:cNvPr>
          <p:cNvSpPr txBox="1"/>
          <p:nvPr/>
        </p:nvSpPr>
        <p:spPr>
          <a:xfrm>
            <a:off x="7241962" y="424282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4A9169BD-90A2-4732-9E30-C09075F54352}"/>
              </a:ext>
            </a:extLst>
          </p:cNvPr>
          <p:cNvSpPr txBox="1"/>
          <p:nvPr/>
        </p:nvSpPr>
        <p:spPr>
          <a:xfrm>
            <a:off x="7241962" y="465191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ADCCBFF-BEB1-4079-B40B-2582D96893DE}"/>
              </a:ext>
            </a:extLst>
          </p:cNvPr>
          <p:cNvSpPr txBox="1"/>
          <p:nvPr/>
        </p:nvSpPr>
        <p:spPr>
          <a:xfrm>
            <a:off x="7241962" y="500394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90E593DA-D9ED-4EA3-89E3-DA3948AF82BA}"/>
              </a:ext>
            </a:extLst>
          </p:cNvPr>
          <p:cNvSpPr txBox="1"/>
          <p:nvPr/>
        </p:nvSpPr>
        <p:spPr>
          <a:xfrm>
            <a:off x="7241962" y="56332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7F0940F2-109D-4601-92A7-E9BAF1330573}"/>
              </a:ext>
            </a:extLst>
          </p:cNvPr>
          <p:cNvSpPr txBox="1"/>
          <p:nvPr/>
        </p:nvSpPr>
        <p:spPr>
          <a:xfrm>
            <a:off x="7241962" y="59055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0F25BA2E-D635-4EF6-B752-F4EC7C2B9DDF}"/>
              </a:ext>
            </a:extLst>
          </p:cNvPr>
          <p:cNvSpPr txBox="1"/>
          <p:nvPr/>
        </p:nvSpPr>
        <p:spPr>
          <a:xfrm>
            <a:off x="7241962" y="616996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826777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36531FF-963A-49D6-90E8-EF827B3BD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144" y="3768994"/>
            <a:ext cx="5737576" cy="281718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092EEFE-F33B-489A-A2CA-D69554CCBACF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(left) and p54 (right) for Fig. 6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B168B17-7738-4537-BCDD-0E127369D7D0}"/>
              </a:ext>
            </a:extLst>
          </p:cNvPr>
          <p:cNvSpPr txBox="1"/>
          <p:nvPr/>
        </p:nvSpPr>
        <p:spPr>
          <a:xfrm>
            <a:off x="1062584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and p-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3F4220-CF76-42B9-A57B-8AF2875D8A90}"/>
              </a:ext>
            </a:extLst>
          </p:cNvPr>
          <p:cNvSpPr txBox="1"/>
          <p:nvPr/>
        </p:nvSpPr>
        <p:spPr>
          <a:xfrm>
            <a:off x="8091815" y="2262464"/>
            <a:ext cx="52641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54 and 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CB3BE35-40C1-4D11-9D90-7CDC1A913684}"/>
              </a:ext>
            </a:extLst>
          </p:cNvPr>
          <p:cNvSpPr txBox="1"/>
          <p:nvPr/>
        </p:nvSpPr>
        <p:spPr>
          <a:xfrm>
            <a:off x="228303" y="38441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7A61C81-C687-43AA-86BA-07EBCE702B39}"/>
              </a:ext>
            </a:extLst>
          </p:cNvPr>
          <p:cNvSpPr txBox="1"/>
          <p:nvPr/>
        </p:nvSpPr>
        <p:spPr>
          <a:xfrm>
            <a:off x="228303" y="40079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3BDEBDF-EB97-4A10-80E7-49917F9CD332}"/>
              </a:ext>
            </a:extLst>
          </p:cNvPr>
          <p:cNvSpPr txBox="1"/>
          <p:nvPr/>
        </p:nvSpPr>
        <p:spPr>
          <a:xfrm>
            <a:off x="228303" y="418596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2824F0F-B0A2-4D5D-89B2-8DDBDE32EF8A}"/>
              </a:ext>
            </a:extLst>
          </p:cNvPr>
          <p:cNvSpPr txBox="1"/>
          <p:nvPr/>
        </p:nvSpPr>
        <p:spPr>
          <a:xfrm>
            <a:off x="228303" y="439472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B09568E-1060-4681-A3C1-6AB249E41AA8}"/>
              </a:ext>
            </a:extLst>
          </p:cNvPr>
          <p:cNvSpPr txBox="1"/>
          <p:nvPr/>
        </p:nvSpPr>
        <p:spPr>
          <a:xfrm>
            <a:off x="228303" y="479729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87D2649-2C96-4E26-A7DC-A65D8A4706F2}"/>
              </a:ext>
            </a:extLst>
          </p:cNvPr>
          <p:cNvSpPr txBox="1"/>
          <p:nvPr/>
        </p:nvSpPr>
        <p:spPr>
          <a:xfrm>
            <a:off x="228303" y="516470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9407E42-9125-40BA-9E88-EF1EB1D1ED88}"/>
              </a:ext>
            </a:extLst>
          </p:cNvPr>
          <p:cNvSpPr txBox="1"/>
          <p:nvPr/>
        </p:nvSpPr>
        <p:spPr>
          <a:xfrm>
            <a:off x="228303" y="577664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D6DCE444-5990-4D5C-927B-F01F93C66F59}"/>
              </a:ext>
            </a:extLst>
          </p:cNvPr>
          <p:cNvGrpSpPr/>
          <p:nvPr/>
        </p:nvGrpSpPr>
        <p:grpSpPr>
          <a:xfrm>
            <a:off x="1671939" y="5842490"/>
            <a:ext cx="667746" cy="396482"/>
            <a:chOff x="1635037" y="5107487"/>
            <a:chExt cx="667746" cy="396482"/>
          </a:xfrm>
        </p:grpSpPr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B64067E3-E467-4CCB-930A-3095EB47F5E8}"/>
                </a:ext>
              </a:extLst>
            </p:cNvPr>
            <p:cNvCxnSpPr>
              <a:cxnSpLocks/>
            </p:cNvCxnSpPr>
            <p:nvPr/>
          </p:nvCxnSpPr>
          <p:spPr>
            <a:xfrm>
              <a:off x="1635037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8B123FC5-BA2B-425E-90E7-3545D3635349}"/>
                </a:ext>
              </a:extLst>
            </p:cNvPr>
            <p:cNvSpPr txBox="1"/>
            <p:nvPr/>
          </p:nvSpPr>
          <p:spPr>
            <a:xfrm>
              <a:off x="164030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5530F046-AE3C-4FE2-BF2F-2540587BF46F}"/>
              </a:ext>
            </a:extLst>
          </p:cNvPr>
          <p:cNvGrpSpPr/>
          <p:nvPr/>
        </p:nvGrpSpPr>
        <p:grpSpPr>
          <a:xfrm>
            <a:off x="2412560" y="5842490"/>
            <a:ext cx="662474" cy="396482"/>
            <a:chOff x="2401254" y="5107487"/>
            <a:chExt cx="662474" cy="396482"/>
          </a:xfrm>
        </p:grpSpPr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F8CE2AB-6925-4709-B461-FC559EAE66C8}"/>
                </a:ext>
              </a:extLst>
            </p:cNvPr>
            <p:cNvSpPr txBox="1"/>
            <p:nvPr/>
          </p:nvSpPr>
          <p:spPr>
            <a:xfrm>
              <a:off x="2401254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457B1E18-74AE-475C-A5F1-E738CAA1F849}"/>
                </a:ext>
              </a:extLst>
            </p:cNvPr>
            <p:cNvCxnSpPr>
              <a:cxnSpLocks/>
            </p:cNvCxnSpPr>
            <p:nvPr/>
          </p:nvCxnSpPr>
          <p:spPr>
            <a:xfrm>
              <a:off x="2407369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87AC8FAA-1691-41A9-B1E9-C7346E640C3D}"/>
              </a:ext>
            </a:extLst>
          </p:cNvPr>
          <p:cNvGrpSpPr/>
          <p:nvPr/>
        </p:nvGrpSpPr>
        <p:grpSpPr>
          <a:xfrm>
            <a:off x="3147909" y="5842490"/>
            <a:ext cx="662474" cy="396482"/>
            <a:chOff x="3169949" y="5107487"/>
            <a:chExt cx="662474" cy="396482"/>
          </a:xfrm>
        </p:grpSpPr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FE44CAE7-81FF-4701-BCC7-D2B4EE8229BC}"/>
                </a:ext>
              </a:extLst>
            </p:cNvPr>
            <p:cNvSpPr txBox="1"/>
            <p:nvPr/>
          </p:nvSpPr>
          <p:spPr>
            <a:xfrm>
              <a:off x="316994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87B63DEC-3E18-40E4-B383-4D87B5DE93F2}"/>
                </a:ext>
              </a:extLst>
            </p:cNvPr>
            <p:cNvCxnSpPr>
              <a:cxnSpLocks/>
            </p:cNvCxnSpPr>
            <p:nvPr/>
          </p:nvCxnSpPr>
          <p:spPr>
            <a:xfrm>
              <a:off x="3179701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A9832B98-2CFE-451A-915A-34C2363A65EC}"/>
              </a:ext>
            </a:extLst>
          </p:cNvPr>
          <p:cNvGrpSpPr/>
          <p:nvPr/>
        </p:nvGrpSpPr>
        <p:grpSpPr>
          <a:xfrm>
            <a:off x="3883258" y="5842490"/>
            <a:ext cx="667746" cy="396482"/>
            <a:chOff x="3926204" y="5107487"/>
            <a:chExt cx="667746" cy="396482"/>
          </a:xfrm>
        </p:grpSpPr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980F03B1-F732-467C-8C4B-8F66B16C458B}"/>
                </a:ext>
              </a:extLst>
            </p:cNvPr>
            <p:cNvCxnSpPr>
              <a:cxnSpLocks/>
            </p:cNvCxnSpPr>
            <p:nvPr/>
          </p:nvCxnSpPr>
          <p:spPr>
            <a:xfrm>
              <a:off x="3926204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6BD67097-B533-4333-990C-CF0EF8BD1856}"/>
                </a:ext>
              </a:extLst>
            </p:cNvPr>
            <p:cNvSpPr txBox="1"/>
            <p:nvPr/>
          </p:nvSpPr>
          <p:spPr>
            <a:xfrm>
              <a:off x="393147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40B52AF4-6BC7-4DCA-A604-AF1C3E56FB74}"/>
              </a:ext>
            </a:extLst>
          </p:cNvPr>
          <p:cNvGrpSpPr/>
          <p:nvPr/>
        </p:nvGrpSpPr>
        <p:grpSpPr>
          <a:xfrm>
            <a:off x="4623879" y="5842490"/>
            <a:ext cx="662474" cy="396482"/>
            <a:chOff x="4692421" y="5107487"/>
            <a:chExt cx="662474" cy="396482"/>
          </a:xfrm>
        </p:grpSpPr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C41775C0-53A7-4B5C-9859-EA99B3624EE4}"/>
                </a:ext>
              </a:extLst>
            </p:cNvPr>
            <p:cNvSpPr txBox="1"/>
            <p:nvPr/>
          </p:nvSpPr>
          <p:spPr>
            <a:xfrm>
              <a:off x="4692421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1DA47028-98AF-4081-96DE-8ABF9418CBF8}"/>
                </a:ext>
              </a:extLst>
            </p:cNvPr>
            <p:cNvCxnSpPr>
              <a:cxnSpLocks/>
            </p:cNvCxnSpPr>
            <p:nvPr/>
          </p:nvCxnSpPr>
          <p:spPr>
            <a:xfrm>
              <a:off x="4698536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F0D20896-1D43-4117-8F7E-CC891B8A623D}"/>
              </a:ext>
            </a:extLst>
          </p:cNvPr>
          <p:cNvGrpSpPr/>
          <p:nvPr/>
        </p:nvGrpSpPr>
        <p:grpSpPr>
          <a:xfrm>
            <a:off x="5359226" y="5842490"/>
            <a:ext cx="662474" cy="396482"/>
            <a:chOff x="5461116" y="5107487"/>
            <a:chExt cx="662474" cy="396482"/>
          </a:xfrm>
        </p:grpSpPr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4C06803A-C3DC-4E47-BD80-A457C7CBCAA5}"/>
                </a:ext>
              </a:extLst>
            </p:cNvPr>
            <p:cNvSpPr txBox="1"/>
            <p:nvPr/>
          </p:nvSpPr>
          <p:spPr>
            <a:xfrm>
              <a:off x="546111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633FEFE1-F7F1-42B6-BB48-76605D881ABA}"/>
                </a:ext>
              </a:extLst>
            </p:cNvPr>
            <p:cNvCxnSpPr>
              <a:cxnSpLocks/>
            </p:cNvCxnSpPr>
            <p:nvPr/>
          </p:nvCxnSpPr>
          <p:spPr>
            <a:xfrm>
              <a:off x="5470868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F2F2B40-A333-42D8-909D-CA0126124F87}"/>
              </a:ext>
            </a:extLst>
          </p:cNvPr>
          <p:cNvSpPr txBox="1"/>
          <p:nvPr/>
        </p:nvSpPr>
        <p:spPr>
          <a:xfrm>
            <a:off x="1657764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AB94B44-6EED-462D-B02E-31CE4707AB7A}"/>
              </a:ext>
            </a:extLst>
          </p:cNvPr>
          <p:cNvSpPr txBox="1"/>
          <p:nvPr/>
        </p:nvSpPr>
        <p:spPr>
          <a:xfrm>
            <a:off x="2025710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E41DFD6-9309-4228-9A73-04B92F75B32A}"/>
              </a:ext>
            </a:extLst>
          </p:cNvPr>
          <p:cNvSpPr txBox="1"/>
          <p:nvPr/>
        </p:nvSpPr>
        <p:spPr>
          <a:xfrm>
            <a:off x="2393656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064993D-394D-4DB5-8226-3EA8D95D5EAA}"/>
              </a:ext>
            </a:extLst>
          </p:cNvPr>
          <p:cNvSpPr txBox="1"/>
          <p:nvPr/>
        </p:nvSpPr>
        <p:spPr>
          <a:xfrm>
            <a:off x="2761602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1B76AA9-B58F-4B59-9D38-3E36100A3698}"/>
              </a:ext>
            </a:extLst>
          </p:cNvPr>
          <p:cNvSpPr txBox="1"/>
          <p:nvPr/>
        </p:nvSpPr>
        <p:spPr>
          <a:xfrm>
            <a:off x="3129548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941620A-E995-4DBF-8664-74F3DF2D8E37}"/>
              </a:ext>
            </a:extLst>
          </p:cNvPr>
          <p:cNvSpPr txBox="1"/>
          <p:nvPr/>
        </p:nvSpPr>
        <p:spPr>
          <a:xfrm>
            <a:off x="3497494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319A925-F87A-47D4-B176-F6ACCB4B91F6}"/>
              </a:ext>
            </a:extLst>
          </p:cNvPr>
          <p:cNvSpPr txBox="1"/>
          <p:nvPr/>
        </p:nvSpPr>
        <p:spPr>
          <a:xfrm>
            <a:off x="3865440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6E35119-01BC-4344-A35F-1FB6C5501292}"/>
              </a:ext>
            </a:extLst>
          </p:cNvPr>
          <p:cNvSpPr txBox="1"/>
          <p:nvPr/>
        </p:nvSpPr>
        <p:spPr>
          <a:xfrm>
            <a:off x="4233386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0A87054-F3E8-40B2-8E14-A375C01279A4}"/>
              </a:ext>
            </a:extLst>
          </p:cNvPr>
          <p:cNvSpPr txBox="1"/>
          <p:nvPr/>
        </p:nvSpPr>
        <p:spPr>
          <a:xfrm>
            <a:off x="4601332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4E4A80F-B869-4B66-AE83-CF3A34A91664}"/>
              </a:ext>
            </a:extLst>
          </p:cNvPr>
          <p:cNvSpPr txBox="1"/>
          <p:nvPr/>
        </p:nvSpPr>
        <p:spPr>
          <a:xfrm>
            <a:off x="4969278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9EC26B9-AACA-4DAE-8712-954AF7A1BE66}"/>
              </a:ext>
            </a:extLst>
          </p:cNvPr>
          <p:cNvSpPr txBox="1"/>
          <p:nvPr/>
        </p:nvSpPr>
        <p:spPr>
          <a:xfrm>
            <a:off x="5337224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15E9948-C9B4-46AC-BDDA-4B2F03C16C49}"/>
              </a:ext>
            </a:extLst>
          </p:cNvPr>
          <p:cNvSpPr txBox="1"/>
          <p:nvPr/>
        </p:nvSpPr>
        <p:spPr>
          <a:xfrm>
            <a:off x="5705171" y="545340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80B45F4-BBC4-41DB-963C-EB54C44F4CF8}"/>
              </a:ext>
            </a:extLst>
          </p:cNvPr>
          <p:cNvSpPr txBox="1"/>
          <p:nvPr/>
        </p:nvSpPr>
        <p:spPr>
          <a:xfrm>
            <a:off x="269310" y="5453407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723794B-4DBC-4733-A291-7B85030679B4}"/>
              </a:ext>
            </a:extLst>
          </p:cNvPr>
          <p:cNvSpPr txBox="1"/>
          <p:nvPr/>
        </p:nvSpPr>
        <p:spPr>
          <a:xfrm>
            <a:off x="228303" y="60446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3718605-F788-40B4-B272-6DD88A4829A0}"/>
              </a:ext>
            </a:extLst>
          </p:cNvPr>
          <p:cNvSpPr txBox="1"/>
          <p:nvPr/>
        </p:nvSpPr>
        <p:spPr>
          <a:xfrm>
            <a:off x="228303" y="63097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id="{1BDDE623-8BD2-4C52-BAE6-E27015B3EE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96456" y="3678381"/>
            <a:ext cx="5864514" cy="3147120"/>
          </a:xfrm>
          <a:prstGeom prst="rect">
            <a:avLst/>
          </a:prstGeom>
        </p:spPr>
      </p:pic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8B917B24-9B4B-432C-A293-E85FE740C9F4}"/>
              </a:ext>
            </a:extLst>
          </p:cNvPr>
          <p:cNvGrpSpPr/>
          <p:nvPr/>
        </p:nvGrpSpPr>
        <p:grpSpPr>
          <a:xfrm>
            <a:off x="8788584" y="5582103"/>
            <a:ext cx="667746" cy="396482"/>
            <a:chOff x="1635037" y="5107487"/>
            <a:chExt cx="667746" cy="396482"/>
          </a:xfrm>
        </p:grpSpPr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2CECBBE7-6BA6-4627-B6CF-E05EEA563D47}"/>
                </a:ext>
              </a:extLst>
            </p:cNvPr>
            <p:cNvCxnSpPr>
              <a:cxnSpLocks/>
            </p:cNvCxnSpPr>
            <p:nvPr/>
          </p:nvCxnSpPr>
          <p:spPr>
            <a:xfrm>
              <a:off x="1635037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D86C9C0E-7BB7-4DC6-BEE6-4D7E039EF5B7}"/>
                </a:ext>
              </a:extLst>
            </p:cNvPr>
            <p:cNvSpPr txBox="1"/>
            <p:nvPr/>
          </p:nvSpPr>
          <p:spPr>
            <a:xfrm>
              <a:off x="164030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0CBE2FAD-EAB0-41B8-AB4B-DD11EB966F2A}"/>
              </a:ext>
            </a:extLst>
          </p:cNvPr>
          <p:cNvGrpSpPr/>
          <p:nvPr/>
        </p:nvGrpSpPr>
        <p:grpSpPr>
          <a:xfrm>
            <a:off x="9529205" y="5582103"/>
            <a:ext cx="662474" cy="396482"/>
            <a:chOff x="2401254" y="5107487"/>
            <a:chExt cx="662474" cy="396482"/>
          </a:xfrm>
        </p:grpSpPr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8F973959-6F56-4879-AA56-768DB18C06F9}"/>
                </a:ext>
              </a:extLst>
            </p:cNvPr>
            <p:cNvSpPr txBox="1"/>
            <p:nvPr/>
          </p:nvSpPr>
          <p:spPr>
            <a:xfrm>
              <a:off x="2401254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D209D8B9-FADB-4127-B1AB-1F8729CC502E}"/>
                </a:ext>
              </a:extLst>
            </p:cNvPr>
            <p:cNvCxnSpPr>
              <a:cxnSpLocks/>
            </p:cNvCxnSpPr>
            <p:nvPr/>
          </p:nvCxnSpPr>
          <p:spPr>
            <a:xfrm>
              <a:off x="2407369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253B8DAB-4F2F-4E65-9021-749A012B8E2A}"/>
              </a:ext>
            </a:extLst>
          </p:cNvPr>
          <p:cNvGrpSpPr/>
          <p:nvPr/>
        </p:nvGrpSpPr>
        <p:grpSpPr>
          <a:xfrm>
            <a:off x="10264554" y="5582103"/>
            <a:ext cx="662474" cy="396482"/>
            <a:chOff x="3169949" y="5107487"/>
            <a:chExt cx="662474" cy="396482"/>
          </a:xfrm>
        </p:grpSpPr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5FC1C8A9-E0F6-48B6-9DD7-73D79C7BD83C}"/>
                </a:ext>
              </a:extLst>
            </p:cNvPr>
            <p:cNvSpPr txBox="1"/>
            <p:nvPr/>
          </p:nvSpPr>
          <p:spPr>
            <a:xfrm>
              <a:off x="3169949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80CA4C93-5EAA-4B1E-B955-73B1D22CB1F2}"/>
                </a:ext>
              </a:extLst>
            </p:cNvPr>
            <p:cNvCxnSpPr>
              <a:cxnSpLocks/>
            </p:cNvCxnSpPr>
            <p:nvPr/>
          </p:nvCxnSpPr>
          <p:spPr>
            <a:xfrm>
              <a:off x="3179701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D6F247F5-44A8-4832-9117-F3442A9218E5}"/>
              </a:ext>
            </a:extLst>
          </p:cNvPr>
          <p:cNvGrpSpPr/>
          <p:nvPr/>
        </p:nvGrpSpPr>
        <p:grpSpPr>
          <a:xfrm>
            <a:off x="10999903" y="5582103"/>
            <a:ext cx="667746" cy="396482"/>
            <a:chOff x="3926204" y="5107487"/>
            <a:chExt cx="667746" cy="396482"/>
          </a:xfrm>
        </p:grpSpPr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759A8DC8-15BE-4B75-A17F-020428E316BD}"/>
                </a:ext>
              </a:extLst>
            </p:cNvPr>
            <p:cNvCxnSpPr>
              <a:cxnSpLocks/>
            </p:cNvCxnSpPr>
            <p:nvPr/>
          </p:nvCxnSpPr>
          <p:spPr>
            <a:xfrm>
              <a:off x="3926204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41C69105-E50E-4E21-9D21-230F208BE7D3}"/>
                </a:ext>
              </a:extLst>
            </p:cNvPr>
            <p:cNvSpPr txBox="1"/>
            <p:nvPr/>
          </p:nvSpPr>
          <p:spPr>
            <a:xfrm>
              <a:off x="393147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276123C8-6847-4941-8890-86FA1A6F9D6F}"/>
              </a:ext>
            </a:extLst>
          </p:cNvPr>
          <p:cNvGrpSpPr/>
          <p:nvPr/>
        </p:nvGrpSpPr>
        <p:grpSpPr>
          <a:xfrm>
            <a:off x="11740524" y="5582103"/>
            <a:ext cx="662474" cy="396482"/>
            <a:chOff x="4692421" y="5107487"/>
            <a:chExt cx="662474" cy="396482"/>
          </a:xfrm>
        </p:grpSpPr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C09CB8DE-551F-4E31-BF3D-3C926A920D3D}"/>
                </a:ext>
              </a:extLst>
            </p:cNvPr>
            <p:cNvSpPr txBox="1"/>
            <p:nvPr/>
          </p:nvSpPr>
          <p:spPr>
            <a:xfrm>
              <a:off x="4692421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812E4D50-1EB8-420B-B546-0413A61990E7}"/>
                </a:ext>
              </a:extLst>
            </p:cNvPr>
            <p:cNvCxnSpPr>
              <a:cxnSpLocks/>
            </p:cNvCxnSpPr>
            <p:nvPr/>
          </p:nvCxnSpPr>
          <p:spPr>
            <a:xfrm>
              <a:off x="4698536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7795227C-0232-4114-B800-88C76748E9C4}"/>
              </a:ext>
            </a:extLst>
          </p:cNvPr>
          <p:cNvGrpSpPr/>
          <p:nvPr/>
        </p:nvGrpSpPr>
        <p:grpSpPr>
          <a:xfrm>
            <a:off x="12475871" y="5582103"/>
            <a:ext cx="662474" cy="396482"/>
            <a:chOff x="5461116" y="5107487"/>
            <a:chExt cx="662474" cy="396482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25BDAE62-902C-42AE-B352-52667E9221BF}"/>
                </a:ext>
              </a:extLst>
            </p:cNvPr>
            <p:cNvSpPr txBox="1"/>
            <p:nvPr/>
          </p:nvSpPr>
          <p:spPr>
            <a:xfrm>
              <a:off x="5461116" y="513463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F688C5AC-42A1-4C96-80D7-AD93C519EEE6}"/>
                </a:ext>
              </a:extLst>
            </p:cNvPr>
            <p:cNvCxnSpPr>
              <a:cxnSpLocks/>
            </p:cNvCxnSpPr>
            <p:nvPr/>
          </p:nvCxnSpPr>
          <p:spPr>
            <a:xfrm>
              <a:off x="5470868" y="510748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3960A673-841D-4D33-B52F-D3819E6A0FF2}"/>
              </a:ext>
            </a:extLst>
          </p:cNvPr>
          <p:cNvSpPr txBox="1"/>
          <p:nvPr/>
        </p:nvSpPr>
        <p:spPr>
          <a:xfrm>
            <a:off x="8750025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09FF9E2-F782-4FDA-AB2E-561AFAF37BD4}"/>
              </a:ext>
            </a:extLst>
          </p:cNvPr>
          <p:cNvSpPr txBox="1"/>
          <p:nvPr/>
        </p:nvSpPr>
        <p:spPr>
          <a:xfrm>
            <a:off x="9117971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BE64758-C2E5-4B5C-B89B-07DF4D2D8B10}"/>
              </a:ext>
            </a:extLst>
          </p:cNvPr>
          <p:cNvSpPr txBox="1"/>
          <p:nvPr/>
        </p:nvSpPr>
        <p:spPr>
          <a:xfrm>
            <a:off x="9485917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FC17612-0142-46F5-86D5-240225DEB6C7}"/>
              </a:ext>
            </a:extLst>
          </p:cNvPr>
          <p:cNvSpPr txBox="1"/>
          <p:nvPr/>
        </p:nvSpPr>
        <p:spPr>
          <a:xfrm>
            <a:off x="9853863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0FF56D6-B224-4F6C-9376-23BF1F2A9BB9}"/>
              </a:ext>
            </a:extLst>
          </p:cNvPr>
          <p:cNvSpPr txBox="1"/>
          <p:nvPr/>
        </p:nvSpPr>
        <p:spPr>
          <a:xfrm>
            <a:off x="10221809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5C528E4-1D94-4A60-BD82-CCC35C74505C}"/>
              </a:ext>
            </a:extLst>
          </p:cNvPr>
          <p:cNvSpPr txBox="1"/>
          <p:nvPr/>
        </p:nvSpPr>
        <p:spPr>
          <a:xfrm>
            <a:off x="10589755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214DDCD-DEED-4B3E-97A8-A7A9F905A744}"/>
              </a:ext>
            </a:extLst>
          </p:cNvPr>
          <p:cNvSpPr txBox="1"/>
          <p:nvPr/>
        </p:nvSpPr>
        <p:spPr>
          <a:xfrm>
            <a:off x="10957701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B31BDB4-8756-40C5-A0E1-37FD586EF1C5}"/>
              </a:ext>
            </a:extLst>
          </p:cNvPr>
          <p:cNvSpPr txBox="1"/>
          <p:nvPr/>
        </p:nvSpPr>
        <p:spPr>
          <a:xfrm>
            <a:off x="11325647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60A97F9-4D22-4EBB-9F24-7EEF5DC5C5E8}"/>
              </a:ext>
            </a:extLst>
          </p:cNvPr>
          <p:cNvSpPr txBox="1"/>
          <p:nvPr/>
        </p:nvSpPr>
        <p:spPr>
          <a:xfrm>
            <a:off x="11693593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27178C5-8293-4F6B-9B5A-5492D48F7A20}"/>
              </a:ext>
            </a:extLst>
          </p:cNvPr>
          <p:cNvSpPr txBox="1"/>
          <p:nvPr/>
        </p:nvSpPr>
        <p:spPr>
          <a:xfrm>
            <a:off x="12061539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9EDD951-FC12-47D8-AB99-3830A9F7A6FF}"/>
              </a:ext>
            </a:extLst>
          </p:cNvPr>
          <p:cNvSpPr txBox="1"/>
          <p:nvPr/>
        </p:nvSpPr>
        <p:spPr>
          <a:xfrm>
            <a:off x="12429485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9657AFEE-FADB-402E-A0BF-D7B3F030E51C}"/>
              </a:ext>
            </a:extLst>
          </p:cNvPr>
          <p:cNvSpPr txBox="1"/>
          <p:nvPr/>
        </p:nvSpPr>
        <p:spPr>
          <a:xfrm>
            <a:off x="12797432" y="4397927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</a:t>
            </a:r>
            <a:endParaRPr kumimoji="1" lang="ja-JP" altLang="en-US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95861135-26B4-4329-ABBB-72E23CAB3A6E}"/>
              </a:ext>
            </a:extLst>
          </p:cNvPr>
          <p:cNvSpPr txBox="1"/>
          <p:nvPr/>
        </p:nvSpPr>
        <p:spPr>
          <a:xfrm>
            <a:off x="10129155" y="4011895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AF3828F2-EDAB-42AA-9CFD-EDCAAB78F553}"/>
              </a:ext>
            </a:extLst>
          </p:cNvPr>
          <p:cNvCxnSpPr>
            <a:cxnSpLocks/>
          </p:cNvCxnSpPr>
          <p:nvPr/>
        </p:nvCxnSpPr>
        <p:spPr>
          <a:xfrm>
            <a:off x="8731434" y="4410950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EF45C03C-6C71-4F36-92E1-529A28F23056}"/>
              </a:ext>
            </a:extLst>
          </p:cNvPr>
          <p:cNvSpPr txBox="1"/>
          <p:nvPr/>
        </p:nvSpPr>
        <p:spPr>
          <a:xfrm>
            <a:off x="7181002" y="376239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BABE24A9-4F72-47E0-8A29-155F5595AF1E}"/>
              </a:ext>
            </a:extLst>
          </p:cNvPr>
          <p:cNvSpPr txBox="1"/>
          <p:nvPr/>
        </p:nvSpPr>
        <p:spPr>
          <a:xfrm>
            <a:off x="7181002" y="395404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B0A9A3B-13F9-464D-A9F6-E8F758151434}"/>
              </a:ext>
            </a:extLst>
          </p:cNvPr>
          <p:cNvSpPr txBox="1"/>
          <p:nvPr/>
        </p:nvSpPr>
        <p:spPr>
          <a:xfrm>
            <a:off x="7181002" y="415257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FCFA23D-39D8-4309-B12F-F1077E63A1D5}"/>
              </a:ext>
            </a:extLst>
          </p:cNvPr>
          <p:cNvSpPr txBox="1"/>
          <p:nvPr/>
        </p:nvSpPr>
        <p:spPr>
          <a:xfrm>
            <a:off x="7181002" y="438924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2639E58-BAF3-4ED8-8205-16A7DDCDDCBD}"/>
              </a:ext>
            </a:extLst>
          </p:cNvPr>
          <p:cNvSpPr txBox="1"/>
          <p:nvPr/>
        </p:nvSpPr>
        <p:spPr>
          <a:xfrm>
            <a:off x="7181002" y="485816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3BEF7CE2-0117-486D-8FDB-62A83531B544}"/>
              </a:ext>
            </a:extLst>
          </p:cNvPr>
          <p:cNvSpPr txBox="1"/>
          <p:nvPr/>
        </p:nvSpPr>
        <p:spPr>
          <a:xfrm>
            <a:off x="7181002" y="525291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0DEFECD5-05B9-412F-9431-F6C383887F4D}"/>
              </a:ext>
            </a:extLst>
          </p:cNvPr>
          <p:cNvSpPr txBox="1"/>
          <p:nvPr/>
        </p:nvSpPr>
        <p:spPr>
          <a:xfrm>
            <a:off x="7181002" y="593775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B8AE5E0-7E65-45BD-BDBB-EDA34318DFA6}"/>
              </a:ext>
            </a:extLst>
          </p:cNvPr>
          <p:cNvSpPr txBox="1"/>
          <p:nvPr/>
        </p:nvSpPr>
        <p:spPr>
          <a:xfrm>
            <a:off x="7181002" y="623996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3053B798-71B7-4B07-871F-4F74A5E4364D}"/>
              </a:ext>
            </a:extLst>
          </p:cNvPr>
          <p:cNvSpPr txBox="1"/>
          <p:nvPr/>
        </p:nvSpPr>
        <p:spPr>
          <a:xfrm>
            <a:off x="7181002" y="654285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663409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9D623F57-FED9-43CA-A046-F70A79DC11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1046" y="3515701"/>
            <a:ext cx="5610638" cy="269028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715F2554-7657-4665-A905-33DA505E39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057" y="3515701"/>
            <a:ext cx="5610638" cy="276642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86863" y="8060354"/>
            <a:ext cx="137389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JNK (left) and JNK (right) for Supplemental Fig. 2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429967" y="2262464"/>
            <a:ext cx="45293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and p-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459198" y="2262464"/>
            <a:ext cx="45293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54 and 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59366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7824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99181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2193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60348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9771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54614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7292795" y="35410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7292795" y="372985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7292795" y="39391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7292795" y="41784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7292795" y="462120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7292795" y="50534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7292795" y="563420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B5C3924-F00C-4939-B120-83E55487E4BF}"/>
              </a:ext>
            </a:extLst>
          </p:cNvPr>
          <p:cNvGrpSpPr/>
          <p:nvPr/>
        </p:nvGrpSpPr>
        <p:grpSpPr>
          <a:xfrm>
            <a:off x="1419280" y="3732843"/>
            <a:ext cx="4477669" cy="1951787"/>
            <a:chOff x="1419280" y="3732843"/>
            <a:chExt cx="4477669" cy="1951787"/>
          </a:xfrm>
        </p:grpSpPr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070CFC67-E1F4-4161-A4DB-37511ED10C64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72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A122F518-B81C-4EFA-8012-B8045E0245CB}"/>
                </a:ext>
              </a:extLst>
            </p:cNvPr>
            <p:cNvSpPr txBox="1"/>
            <p:nvPr/>
          </p:nvSpPr>
          <p:spPr>
            <a:xfrm>
              <a:off x="1809435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A55E4020-2D7D-4D90-B014-7833F1D0D8F3}"/>
                </a:ext>
              </a:extLst>
            </p:cNvPr>
            <p:cNvSpPr txBox="1"/>
            <p:nvPr/>
          </p:nvSpPr>
          <p:spPr>
            <a:xfrm>
              <a:off x="4845712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4F5584EA-2329-45A5-A572-0F82203A7A18}"/>
                </a:ext>
              </a:extLst>
            </p:cNvPr>
            <p:cNvSpPr txBox="1"/>
            <p:nvPr/>
          </p:nvSpPr>
          <p:spPr>
            <a:xfrm>
              <a:off x="3327573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4520F114-EC6D-4851-A4B9-7E4758CC3F7F}"/>
                </a:ext>
              </a:extLst>
            </p:cNvPr>
            <p:cNvCxnSpPr>
              <a:cxnSpLocks/>
            </p:cNvCxnSpPr>
            <p:nvPr/>
          </p:nvCxnSpPr>
          <p:spPr>
            <a:xfrm>
              <a:off x="218203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9473C025-31A4-466E-BA51-A92696BEB52F}"/>
                </a:ext>
              </a:extLst>
            </p:cNvPr>
            <p:cNvCxnSpPr>
              <a:cxnSpLocks/>
            </p:cNvCxnSpPr>
            <p:nvPr/>
          </p:nvCxnSpPr>
          <p:spPr>
            <a:xfrm>
              <a:off x="294479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B190C53D-CF98-4DDE-85AE-68071E516FB0}"/>
                </a:ext>
              </a:extLst>
            </p:cNvPr>
            <p:cNvCxnSpPr>
              <a:cxnSpLocks/>
            </p:cNvCxnSpPr>
            <p:nvPr/>
          </p:nvCxnSpPr>
          <p:spPr>
            <a:xfrm>
              <a:off x="370754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2D640C1-37BE-4788-A523-5145BA670780}"/>
                </a:ext>
              </a:extLst>
            </p:cNvPr>
            <p:cNvSpPr txBox="1"/>
            <p:nvPr/>
          </p:nvSpPr>
          <p:spPr>
            <a:xfrm>
              <a:off x="143030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4D1856CD-7EB8-421F-8286-F36749A6603F}"/>
                </a:ext>
              </a:extLst>
            </p:cNvPr>
            <p:cNvCxnSpPr>
              <a:cxnSpLocks/>
            </p:cNvCxnSpPr>
            <p:nvPr/>
          </p:nvCxnSpPr>
          <p:spPr>
            <a:xfrm>
              <a:off x="447030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C8977840-6BB7-4CE8-A29B-689EA2875EBC}"/>
                </a:ext>
              </a:extLst>
            </p:cNvPr>
            <p:cNvCxnSpPr>
              <a:cxnSpLocks/>
            </p:cNvCxnSpPr>
            <p:nvPr/>
          </p:nvCxnSpPr>
          <p:spPr>
            <a:xfrm>
              <a:off x="5233057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782C3539-5751-425E-825B-F62C72B4513D}"/>
                </a:ext>
              </a:extLst>
            </p:cNvPr>
            <p:cNvCxnSpPr>
              <a:cxnSpLocks/>
            </p:cNvCxnSpPr>
            <p:nvPr/>
          </p:nvCxnSpPr>
          <p:spPr>
            <a:xfrm>
              <a:off x="2938810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279211FF-A7FA-418A-A84E-E77463279FD2}"/>
                </a:ext>
              </a:extLst>
            </p:cNvPr>
            <p:cNvCxnSpPr>
              <a:cxnSpLocks/>
            </p:cNvCxnSpPr>
            <p:nvPr/>
          </p:nvCxnSpPr>
          <p:spPr>
            <a:xfrm>
              <a:off x="4456949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7504351A-BA88-4857-9D81-6C8CCE21A779}"/>
                </a:ext>
              </a:extLst>
            </p:cNvPr>
            <p:cNvCxnSpPr>
              <a:cxnSpLocks/>
            </p:cNvCxnSpPr>
            <p:nvPr/>
          </p:nvCxnSpPr>
          <p:spPr>
            <a:xfrm>
              <a:off x="141928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7AF2BA1B-AF87-415B-8A4F-BFC6B3D4CE90}"/>
                </a:ext>
              </a:extLst>
            </p:cNvPr>
            <p:cNvSpPr txBox="1"/>
            <p:nvPr/>
          </p:nvSpPr>
          <p:spPr>
            <a:xfrm>
              <a:off x="218389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C11606D0-88F3-40C6-A47C-82DCA81D5038}"/>
                </a:ext>
              </a:extLst>
            </p:cNvPr>
            <p:cNvSpPr txBox="1"/>
            <p:nvPr/>
          </p:nvSpPr>
          <p:spPr>
            <a:xfrm>
              <a:off x="293747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8782039E-055D-4F07-9899-C591AB8CD1E0}"/>
                </a:ext>
              </a:extLst>
            </p:cNvPr>
            <p:cNvSpPr txBox="1"/>
            <p:nvPr/>
          </p:nvSpPr>
          <p:spPr>
            <a:xfrm>
              <a:off x="369106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196E1C65-7A95-4419-BAF3-2264A8551F4F}"/>
                </a:ext>
              </a:extLst>
            </p:cNvPr>
            <p:cNvSpPr txBox="1"/>
            <p:nvPr/>
          </p:nvSpPr>
          <p:spPr>
            <a:xfrm>
              <a:off x="444464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5FCE392-79F9-4F43-9557-31591BF6E2BA}"/>
                </a:ext>
              </a:extLst>
            </p:cNvPr>
            <p:cNvSpPr txBox="1"/>
            <p:nvPr/>
          </p:nvSpPr>
          <p:spPr>
            <a:xfrm>
              <a:off x="519823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1F70AE34-F065-421A-AB64-FB1F4B28B571}"/>
                </a:ext>
              </a:extLst>
            </p:cNvPr>
            <p:cNvSpPr txBox="1"/>
            <p:nvPr/>
          </p:nvSpPr>
          <p:spPr>
            <a:xfrm>
              <a:off x="2559309" y="3732843"/>
              <a:ext cx="21630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P600125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20FD5913-141D-4501-BFA7-1B4928FDF52B}"/>
              </a:ext>
            </a:extLst>
          </p:cNvPr>
          <p:cNvGrpSpPr/>
          <p:nvPr/>
        </p:nvGrpSpPr>
        <p:grpSpPr>
          <a:xfrm>
            <a:off x="8604777" y="3749056"/>
            <a:ext cx="4477669" cy="1951787"/>
            <a:chOff x="1419280" y="3732843"/>
            <a:chExt cx="4477669" cy="1951787"/>
          </a:xfrm>
        </p:grpSpPr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2BDD551A-041C-4103-9095-A47010962321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72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767578A9-2477-492E-9830-1EC0C3D22A08}"/>
                </a:ext>
              </a:extLst>
            </p:cNvPr>
            <p:cNvSpPr txBox="1"/>
            <p:nvPr/>
          </p:nvSpPr>
          <p:spPr>
            <a:xfrm>
              <a:off x="1809435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15238D0C-4DB5-4A66-A2B9-B6C8DEEE00A6}"/>
                </a:ext>
              </a:extLst>
            </p:cNvPr>
            <p:cNvSpPr txBox="1"/>
            <p:nvPr/>
          </p:nvSpPr>
          <p:spPr>
            <a:xfrm>
              <a:off x="4845712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9599E8C8-2B56-4A35-BFCC-A4E37494B41A}"/>
                </a:ext>
              </a:extLst>
            </p:cNvPr>
            <p:cNvSpPr txBox="1"/>
            <p:nvPr/>
          </p:nvSpPr>
          <p:spPr>
            <a:xfrm>
              <a:off x="3327573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C154DEB5-4883-41F0-84AF-A5A3A9A06761}"/>
                </a:ext>
              </a:extLst>
            </p:cNvPr>
            <p:cNvCxnSpPr>
              <a:cxnSpLocks/>
            </p:cNvCxnSpPr>
            <p:nvPr/>
          </p:nvCxnSpPr>
          <p:spPr>
            <a:xfrm>
              <a:off x="218203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3EC7A855-F486-4AC0-9C4B-873D64704E8B}"/>
                </a:ext>
              </a:extLst>
            </p:cNvPr>
            <p:cNvCxnSpPr>
              <a:cxnSpLocks/>
            </p:cNvCxnSpPr>
            <p:nvPr/>
          </p:nvCxnSpPr>
          <p:spPr>
            <a:xfrm>
              <a:off x="294479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A41E7995-9A86-4C4E-9792-02D81B7D391C}"/>
                </a:ext>
              </a:extLst>
            </p:cNvPr>
            <p:cNvCxnSpPr>
              <a:cxnSpLocks/>
            </p:cNvCxnSpPr>
            <p:nvPr/>
          </p:nvCxnSpPr>
          <p:spPr>
            <a:xfrm>
              <a:off x="370754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67C3B3B9-D998-45B4-8AC5-0F843C94BC1A}"/>
                </a:ext>
              </a:extLst>
            </p:cNvPr>
            <p:cNvSpPr txBox="1"/>
            <p:nvPr/>
          </p:nvSpPr>
          <p:spPr>
            <a:xfrm>
              <a:off x="143030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32478D02-0F93-4A47-A24E-9723F53CAF6D}"/>
                </a:ext>
              </a:extLst>
            </p:cNvPr>
            <p:cNvCxnSpPr>
              <a:cxnSpLocks/>
            </p:cNvCxnSpPr>
            <p:nvPr/>
          </p:nvCxnSpPr>
          <p:spPr>
            <a:xfrm>
              <a:off x="447030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4747C5A9-C55F-406D-8BAE-DAEC68875CC8}"/>
                </a:ext>
              </a:extLst>
            </p:cNvPr>
            <p:cNvCxnSpPr>
              <a:cxnSpLocks/>
            </p:cNvCxnSpPr>
            <p:nvPr/>
          </p:nvCxnSpPr>
          <p:spPr>
            <a:xfrm>
              <a:off x="5233057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3B9D529E-A074-4BED-9C3B-B6E205311895}"/>
                </a:ext>
              </a:extLst>
            </p:cNvPr>
            <p:cNvCxnSpPr>
              <a:cxnSpLocks/>
            </p:cNvCxnSpPr>
            <p:nvPr/>
          </p:nvCxnSpPr>
          <p:spPr>
            <a:xfrm>
              <a:off x="2938810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7324991C-4732-467A-A8D2-384683D643B8}"/>
                </a:ext>
              </a:extLst>
            </p:cNvPr>
            <p:cNvCxnSpPr>
              <a:cxnSpLocks/>
            </p:cNvCxnSpPr>
            <p:nvPr/>
          </p:nvCxnSpPr>
          <p:spPr>
            <a:xfrm>
              <a:off x="4456949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3CF7EFAD-19EC-4656-ABFA-C9AA0752A03E}"/>
                </a:ext>
              </a:extLst>
            </p:cNvPr>
            <p:cNvCxnSpPr>
              <a:cxnSpLocks/>
            </p:cNvCxnSpPr>
            <p:nvPr/>
          </p:nvCxnSpPr>
          <p:spPr>
            <a:xfrm>
              <a:off x="141928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378F31FF-ADCB-4A59-8FE7-5A3725232318}"/>
                </a:ext>
              </a:extLst>
            </p:cNvPr>
            <p:cNvSpPr txBox="1"/>
            <p:nvPr/>
          </p:nvSpPr>
          <p:spPr>
            <a:xfrm>
              <a:off x="218389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5F516289-EDAB-4063-B1FF-AE22B03D2E62}"/>
                </a:ext>
              </a:extLst>
            </p:cNvPr>
            <p:cNvSpPr txBox="1"/>
            <p:nvPr/>
          </p:nvSpPr>
          <p:spPr>
            <a:xfrm>
              <a:off x="293747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7285E7A4-446B-4B53-AEC6-E947CBEEF269}"/>
                </a:ext>
              </a:extLst>
            </p:cNvPr>
            <p:cNvSpPr txBox="1"/>
            <p:nvPr/>
          </p:nvSpPr>
          <p:spPr>
            <a:xfrm>
              <a:off x="369106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7F6341B5-158C-4F1F-B739-66F6A35EB8EB}"/>
                </a:ext>
              </a:extLst>
            </p:cNvPr>
            <p:cNvSpPr txBox="1"/>
            <p:nvPr/>
          </p:nvSpPr>
          <p:spPr>
            <a:xfrm>
              <a:off x="444464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7BC6D8BE-C81A-4293-9466-3F78124D94EE}"/>
                </a:ext>
              </a:extLst>
            </p:cNvPr>
            <p:cNvSpPr txBox="1"/>
            <p:nvPr/>
          </p:nvSpPr>
          <p:spPr>
            <a:xfrm>
              <a:off x="519823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1BAA743-8CAB-412A-AB2C-B45B1103FA20}"/>
                </a:ext>
              </a:extLst>
            </p:cNvPr>
            <p:cNvSpPr txBox="1"/>
            <p:nvPr/>
          </p:nvSpPr>
          <p:spPr>
            <a:xfrm>
              <a:off x="2559309" y="3732843"/>
              <a:ext cx="21630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P600125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096055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D644999E-A66F-46E7-9F01-EF59C34E48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8405" y="3515701"/>
            <a:ext cx="5712188" cy="246186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AABE0355-1004-43A6-BDB6-AB83DE088F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057" y="3515701"/>
            <a:ext cx="5712188" cy="246186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86863" y="8060354"/>
            <a:ext cx="137389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c-Jun (left) and c-Jun (right) for Supplemental Fig. 2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429967" y="2262464"/>
            <a:ext cx="45293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c-Jun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459198" y="2262464"/>
            <a:ext cx="45293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45719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6459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8553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0282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4124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73149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28683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B5C3924-F00C-4939-B120-83E55487E4BF}"/>
              </a:ext>
            </a:extLst>
          </p:cNvPr>
          <p:cNvGrpSpPr/>
          <p:nvPr/>
        </p:nvGrpSpPr>
        <p:grpSpPr>
          <a:xfrm>
            <a:off x="1528464" y="3732843"/>
            <a:ext cx="4477669" cy="1951787"/>
            <a:chOff x="1419280" y="3732843"/>
            <a:chExt cx="4477669" cy="1951787"/>
          </a:xfrm>
        </p:grpSpPr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070CFC67-E1F4-4161-A4DB-37511ED10C64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72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A122F518-B81C-4EFA-8012-B8045E0245CB}"/>
                </a:ext>
              </a:extLst>
            </p:cNvPr>
            <p:cNvSpPr txBox="1"/>
            <p:nvPr/>
          </p:nvSpPr>
          <p:spPr>
            <a:xfrm>
              <a:off x="1809435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A55E4020-2D7D-4D90-B014-7833F1D0D8F3}"/>
                </a:ext>
              </a:extLst>
            </p:cNvPr>
            <p:cNvSpPr txBox="1"/>
            <p:nvPr/>
          </p:nvSpPr>
          <p:spPr>
            <a:xfrm>
              <a:off x="4845712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4F5584EA-2329-45A5-A572-0F82203A7A18}"/>
                </a:ext>
              </a:extLst>
            </p:cNvPr>
            <p:cNvSpPr txBox="1"/>
            <p:nvPr/>
          </p:nvSpPr>
          <p:spPr>
            <a:xfrm>
              <a:off x="3327573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4520F114-EC6D-4851-A4B9-7E4758CC3F7F}"/>
                </a:ext>
              </a:extLst>
            </p:cNvPr>
            <p:cNvCxnSpPr>
              <a:cxnSpLocks/>
            </p:cNvCxnSpPr>
            <p:nvPr/>
          </p:nvCxnSpPr>
          <p:spPr>
            <a:xfrm>
              <a:off x="218203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9473C025-31A4-466E-BA51-A92696BEB52F}"/>
                </a:ext>
              </a:extLst>
            </p:cNvPr>
            <p:cNvCxnSpPr>
              <a:cxnSpLocks/>
            </p:cNvCxnSpPr>
            <p:nvPr/>
          </p:nvCxnSpPr>
          <p:spPr>
            <a:xfrm>
              <a:off x="294479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B190C53D-CF98-4DDE-85AE-68071E516FB0}"/>
                </a:ext>
              </a:extLst>
            </p:cNvPr>
            <p:cNvCxnSpPr>
              <a:cxnSpLocks/>
            </p:cNvCxnSpPr>
            <p:nvPr/>
          </p:nvCxnSpPr>
          <p:spPr>
            <a:xfrm>
              <a:off x="370754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2D640C1-37BE-4788-A523-5145BA670780}"/>
                </a:ext>
              </a:extLst>
            </p:cNvPr>
            <p:cNvSpPr txBox="1"/>
            <p:nvPr/>
          </p:nvSpPr>
          <p:spPr>
            <a:xfrm>
              <a:off x="143030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4D1856CD-7EB8-421F-8286-F36749A6603F}"/>
                </a:ext>
              </a:extLst>
            </p:cNvPr>
            <p:cNvCxnSpPr>
              <a:cxnSpLocks/>
            </p:cNvCxnSpPr>
            <p:nvPr/>
          </p:nvCxnSpPr>
          <p:spPr>
            <a:xfrm>
              <a:off x="447030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C8977840-6BB7-4CE8-A29B-689EA2875EBC}"/>
                </a:ext>
              </a:extLst>
            </p:cNvPr>
            <p:cNvCxnSpPr>
              <a:cxnSpLocks/>
            </p:cNvCxnSpPr>
            <p:nvPr/>
          </p:nvCxnSpPr>
          <p:spPr>
            <a:xfrm>
              <a:off x="5233057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782C3539-5751-425E-825B-F62C72B4513D}"/>
                </a:ext>
              </a:extLst>
            </p:cNvPr>
            <p:cNvCxnSpPr>
              <a:cxnSpLocks/>
            </p:cNvCxnSpPr>
            <p:nvPr/>
          </p:nvCxnSpPr>
          <p:spPr>
            <a:xfrm>
              <a:off x="2938810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279211FF-A7FA-418A-A84E-E77463279FD2}"/>
                </a:ext>
              </a:extLst>
            </p:cNvPr>
            <p:cNvCxnSpPr>
              <a:cxnSpLocks/>
            </p:cNvCxnSpPr>
            <p:nvPr/>
          </p:nvCxnSpPr>
          <p:spPr>
            <a:xfrm>
              <a:off x="4456949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7504351A-BA88-4857-9D81-6C8CCE21A779}"/>
                </a:ext>
              </a:extLst>
            </p:cNvPr>
            <p:cNvCxnSpPr>
              <a:cxnSpLocks/>
            </p:cNvCxnSpPr>
            <p:nvPr/>
          </p:nvCxnSpPr>
          <p:spPr>
            <a:xfrm>
              <a:off x="141928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7AF2BA1B-AF87-415B-8A4F-BFC6B3D4CE90}"/>
                </a:ext>
              </a:extLst>
            </p:cNvPr>
            <p:cNvSpPr txBox="1"/>
            <p:nvPr/>
          </p:nvSpPr>
          <p:spPr>
            <a:xfrm>
              <a:off x="218389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C11606D0-88F3-40C6-A47C-82DCA81D5038}"/>
                </a:ext>
              </a:extLst>
            </p:cNvPr>
            <p:cNvSpPr txBox="1"/>
            <p:nvPr/>
          </p:nvSpPr>
          <p:spPr>
            <a:xfrm>
              <a:off x="293747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8782039E-055D-4F07-9899-C591AB8CD1E0}"/>
                </a:ext>
              </a:extLst>
            </p:cNvPr>
            <p:cNvSpPr txBox="1"/>
            <p:nvPr/>
          </p:nvSpPr>
          <p:spPr>
            <a:xfrm>
              <a:off x="369106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196E1C65-7A95-4419-BAF3-2264A8551F4F}"/>
                </a:ext>
              </a:extLst>
            </p:cNvPr>
            <p:cNvSpPr txBox="1"/>
            <p:nvPr/>
          </p:nvSpPr>
          <p:spPr>
            <a:xfrm>
              <a:off x="444464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5FCE392-79F9-4F43-9557-31591BF6E2BA}"/>
                </a:ext>
              </a:extLst>
            </p:cNvPr>
            <p:cNvSpPr txBox="1"/>
            <p:nvPr/>
          </p:nvSpPr>
          <p:spPr>
            <a:xfrm>
              <a:off x="519823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1F70AE34-F065-421A-AB64-FB1F4B28B571}"/>
                </a:ext>
              </a:extLst>
            </p:cNvPr>
            <p:cNvSpPr txBox="1"/>
            <p:nvPr/>
          </p:nvSpPr>
          <p:spPr>
            <a:xfrm>
              <a:off x="2559309" y="3732843"/>
              <a:ext cx="21630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P600125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20FD5913-141D-4501-BFA7-1B4928FDF52B}"/>
              </a:ext>
            </a:extLst>
          </p:cNvPr>
          <p:cNvGrpSpPr/>
          <p:nvPr/>
        </p:nvGrpSpPr>
        <p:grpSpPr>
          <a:xfrm>
            <a:off x="8700313" y="3749056"/>
            <a:ext cx="4477669" cy="1951787"/>
            <a:chOff x="1419280" y="3732843"/>
            <a:chExt cx="4477669" cy="1951787"/>
          </a:xfrm>
        </p:grpSpPr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2BDD551A-041C-4103-9095-A47010962321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72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767578A9-2477-492E-9830-1EC0C3D22A08}"/>
                </a:ext>
              </a:extLst>
            </p:cNvPr>
            <p:cNvSpPr txBox="1"/>
            <p:nvPr/>
          </p:nvSpPr>
          <p:spPr>
            <a:xfrm>
              <a:off x="1809435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15238D0C-4DB5-4A66-A2B9-B6C8DEEE00A6}"/>
                </a:ext>
              </a:extLst>
            </p:cNvPr>
            <p:cNvSpPr txBox="1"/>
            <p:nvPr/>
          </p:nvSpPr>
          <p:spPr>
            <a:xfrm>
              <a:off x="4845712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9599E8C8-2B56-4A35-BFCC-A4E37494B41A}"/>
                </a:ext>
              </a:extLst>
            </p:cNvPr>
            <p:cNvSpPr txBox="1"/>
            <p:nvPr/>
          </p:nvSpPr>
          <p:spPr>
            <a:xfrm>
              <a:off x="3327573" y="5315298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C154DEB5-4883-41F0-84AF-A5A3A9A06761}"/>
                </a:ext>
              </a:extLst>
            </p:cNvPr>
            <p:cNvCxnSpPr>
              <a:cxnSpLocks/>
            </p:cNvCxnSpPr>
            <p:nvPr/>
          </p:nvCxnSpPr>
          <p:spPr>
            <a:xfrm>
              <a:off x="218203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3EC7A855-F486-4AC0-9C4B-873D64704E8B}"/>
                </a:ext>
              </a:extLst>
            </p:cNvPr>
            <p:cNvCxnSpPr>
              <a:cxnSpLocks/>
            </p:cNvCxnSpPr>
            <p:nvPr/>
          </p:nvCxnSpPr>
          <p:spPr>
            <a:xfrm>
              <a:off x="294479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A41E7995-9A86-4C4E-9792-02D81B7D391C}"/>
                </a:ext>
              </a:extLst>
            </p:cNvPr>
            <p:cNvCxnSpPr>
              <a:cxnSpLocks/>
            </p:cNvCxnSpPr>
            <p:nvPr/>
          </p:nvCxnSpPr>
          <p:spPr>
            <a:xfrm>
              <a:off x="3707545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67C3B3B9-D998-45B4-8AC5-0F843C94BC1A}"/>
                </a:ext>
              </a:extLst>
            </p:cNvPr>
            <p:cNvSpPr txBox="1"/>
            <p:nvPr/>
          </p:nvSpPr>
          <p:spPr>
            <a:xfrm>
              <a:off x="143030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32478D02-0F93-4A47-A24E-9723F53CAF6D}"/>
                </a:ext>
              </a:extLst>
            </p:cNvPr>
            <p:cNvCxnSpPr>
              <a:cxnSpLocks/>
            </p:cNvCxnSpPr>
            <p:nvPr/>
          </p:nvCxnSpPr>
          <p:spPr>
            <a:xfrm>
              <a:off x="447030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4747C5A9-C55F-406D-8BAE-DAEC68875CC8}"/>
                </a:ext>
              </a:extLst>
            </p:cNvPr>
            <p:cNvCxnSpPr>
              <a:cxnSpLocks/>
            </p:cNvCxnSpPr>
            <p:nvPr/>
          </p:nvCxnSpPr>
          <p:spPr>
            <a:xfrm>
              <a:off x="5233057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3B9D529E-A074-4BED-9C3B-B6E205311895}"/>
                </a:ext>
              </a:extLst>
            </p:cNvPr>
            <p:cNvCxnSpPr>
              <a:cxnSpLocks/>
            </p:cNvCxnSpPr>
            <p:nvPr/>
          </p:nvCxnSpPr>
          <p:spPr>
            <a:xfrm>
              <a:off x="2938810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7324991C-4732-467A-A8D2-384683D643B8}"/>
                </a:ext>
              </a:extLst>
            </p:cNvPr>
            <p:cNvCxnSpPr>
              <a:cxnSpLocks/>
            </p:cNvCxnSpPr>
            <p:nvPr/>
          </p:nvCxnSpPr>
          <p:spPr>
            <a:xfrm>
              <a:off x="4456949" y="5252978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3CF7EFAD-19EC-4656-ABFA-C9AA0752A03E}"/>
                </a:ext>
              </a:extLst>
            </p:cNvPr>
            <p:cNvCxnSpPr>
              <a:cxnSpLocks/>
            </p:cNvCxnSpPr>
            <p:nvPr/>
          </p:nvCxnSpPr>
          <p:spPr>
            <a:xfrm>
              <a:off x="1419280" y="4366842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378F31FF-ADCB-4A59-8FE7-5A3725232318}"/>
                </a:ext>
              </a:extLst>
            </p:cNvPr>
            <p:cNvSpPr txBox="1"/>
            <p:nvPr/>
          </p:nvSpPr>
          <p:spPr>
            <a:xfrm>
              <a:off x="218389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5F516289-EDAB-4063-B1FF-AE22B03D2E62}"/>
                </a:ext>
              </a:extLst>
            </p:cNvPr>
            <p:cNvSpPr txBox="1"/>
            <p:nvPr/>
          </p:nvSpPr>
          <p:spPr>
            <a:xfrm>
              <a:off x="293747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7285E7A4-446B-4B53-AEC6-E947CBEEF269}"/>
                </a:ext>
              </a:extLst>
            </p:cNvPr>
            <p:cNvSpPr txBox="1"/>
            <p:nvPr/>
          </p:nvSpPr>
          <p:spPr>
            <a:xfrm>
              <a:off x="369106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7F6341B5-158C-4F1F-B739-66F6A35EB8EB}"/>
                </a:ext>
              </a:extLst>
            </p:cNvPr>
            <p:cNvSpPr txBox="1"/>
            <p:nvPr/>
          </p:nvSpPr>
          <p:spPr>
            <a:xfrm>
              <a:off x="4444648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7BC6D8BE-C81A-4293-9466-3F78124D94EE}"/>
                </a:ext>
              </a:extLst>
            </p:cNvPr>
            <p:cNvSpPr txBox="1"/>
            <p:nvPr/>
          </p:nvSpPr>
          <p:spPr>
            <a:xfrm>
              <a:off x="5198233" y="4040452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1BAA743-8CAB-412A-AB2C-B45B1103FA20}"/>
                </a:ext>
              </a:extLst>
            </p:cNvPr>
            <p:cNvSpPr txBox="1"/>
            <p:nvPr/>
          </p:nvSpPr>
          <p:spPr>
            <a:xfrm>
              <a:off x="2559309" y="3732843"/>
              <a:ext cx="21630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P600125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3111344-88F2-4D21-8611-9C8095A99457}"/>
              </a:ext>
            </a:extLst>
          </p:cNvPr>
          <p:cNvSpPr txBox="1"/>
          <p:nvPr/>
        </p:nvSpPr>
        <p:spPr>
          <a:xfrm>
            <a:off x="7283587" y="347311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8F4151D-A035-4BBB-ABED-DBF7743DC5B4}"/>
              </a:ext>
            </a:extLst>
          </p:cNvPr>
          <p:cNvSpPr txBox="1"/>
          <p:nvPr/>
        </p:nvSpPr>
        <p:spPr>
          <a:xfrm>
            <a:off x="7283587" y="366191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BC035C9-940C-42B8-8DAD-655ABA4A894F}"/>
              </a:ext>
            </a:extLst>
          </p:cNvPr>
          <p:cNvSpPr txBox="1"/>
          <p:nvPr/>
        </p:nvSpPr>
        <p:spPr>
          <a:xfrm>
            <a:off x="7283587" y="38712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5F0D940-1F83-4C02-B843-538EC60EDBF5}"/>
              </a:ext>
            </a:extLst>
          </p:cNvPr>
          <p:cNvSpPr txBox="1"/>
          <p:nvPr/>
        </p:nvSpPr>
        <p:spPr>
          <a:xfrm>
            <a:off x="7283587" y="404421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36321EE-6BC2-450B-BDF2-425ABC358773}"/>
              </a:ext>
            </a:extLst>
          </p:cNvPr>
          <p:cNvSpPr txBox="1"/>
          <p:nvPr/>
        </p:nvSpPr>
        <p:spPr>
          <a:xfrm>
            <a:off x="7283587" y="44283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1CD18CD8-28CC-4FFE-9825-A63950CFFD80}"/>
              </a:ext>
            </a:extLst>
          </p:cNvPr>
          <p:cNvSpPr txBox="1"/>
          <p:nvPr/>
        </p:nvSpPr>
        <p:spPr>
          <a:xfrm>
            <a:off x="7283587" y="474741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3B5F3CE-A62B-425C-B9B8-D938C139134D}"/>
              </a:ext>
            </a:extLst>
          </p:cNvPr>
          <p:cNvSpPr txBox="1"/>
          <p:nvPr/>
        </p:nvSpPr>
        <p:spPr>
          <a:xfrm>
            <a:off x="7283587" y="530276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8554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C099DCEE-6ED2-41A9-B06E-BEC6D6D42F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3853" y="2673704"/>
            <a:ext cx="4650990" cy="410140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7F62D00-586E-4815-A29F-6E791364EE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2424" y="2519173"/>
            <a:ext cx="4549440" cy="4426274"/>
          </a:xfrm>
          <a:prstGeom prst="rect">
            <a:avLst/>
          </a:prstGeom>
        </p:spPr>
      </p:pic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5CE8341E-2CF5-4536-9BB7-69A1D0CE480F}"/>
              </a:ext>
            </a:extLst>
          </p:cNvPr>
          <p:cNvGrpSpPr/>
          <p:nvPr/>
        </p:nvGrpSpPr>
        <p:grpSpPr>
          <a:xfrm>
            <a:off x="1859195" y="3588342"/>
            <a:ext cx="3561185" cy="810921"/>
            <a:chOff x="1859195" y="3588342"/>
            <a:chExt cx="3561185" cy="810921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/>
            <p:nvPr/>
          </p:nvCxnSpPr>
          <p:spPr>
            <a:xfrm>
              <a:off x="185919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直線コネクタ 237">
              <a:extLst>
                <a:ext uri="{FF2B5EF4-FFF2-40B4-BE49-F238E27FC236}">
                  <a16:creationId xmlns:a16="http://schemas.microsoft.com/office/drawing/2014/main" id="{F8097A0E-ED0D-4581-9143-48C9779D6315}"/>
                </a:ext>
              </a:extLst>
            </p:cNvPr>
            <p:cNvCxnSpPr/>
            <p:nvPr/>
          </p:nvCxnSpPr>
          <p:spPr>
            <a:xfrm>
              <a:off x="276737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直線コネクタ 238">
              <a:extLst>
                <a:ext uri="{FF2B5EF4-FFF2-40B4-BE49-F238E27FC236}">
                  <a16:creationId xmlns:a16="http://schemas.microsoft.com/office/drawing/2014/main" id="{9F28034C-CD08-447A-9B0E-45D27222A6C0}"/>
                </a:ext>
              </a:extLst>
            </p:cNvPr>
            <p:cNvCxnSpPr/>
            <p:nvPr/>
          </p:nvCxnSpPr>
          <p:spPr>
            <a:xfrm>
              <a:off x="367555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直線コネクタ 239">
              <a:extLst>
                <a:ext uri="{FF2B5EF4-FFF2-40B4-BE49-F238E27FC236}">
                  <a16:creationId xmlns:a16="http://schemas.microsoft.com/office/drawing/2014/main" id="{6A4804AB-E26F-4A50-B400-986F811794C1}"/>
                </a:ext>
              </a:extLst>
            </p:cNvPr>
            <p:cNvCxnSpPr/>
            <p:nvPr/>
          </p:nvCxnSpPr>
          <p:spPr>
            <a:xfrm>
              <a:off x="458373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94195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75831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85013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5297FB1F-A08F-4D13-B642-BCEB351ACD24}"/>
                </a:ext>
              </a:extLst>
            </p:cNvPr>
            <p:cNvSpPr txBox="1"/>
            <p:nvPr/>
          </p:nvSpPr>
          <p:spPr>
            <a:xfrm>
              <a:off x="466649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5" name="直線コネクタ 244">
              <a:extLst>
                <a:ext uri="{FF2B5EF4-FFF2-40B4-BE49-F238E27FC236}">
                  <a16:creationId xmlns:a16="http://schemas.microsoft.com/office/drawing/2014/main" id="{583FD533-79D4-4916-A568-B21001918C70}"/>
                </a:ext>
              </a:extLst>
            </p:cNvPr>
            <p:cNvCxnSpPr>
              <a:cxnSpLocks/>
            </p:cNvCxnSpPr>
            <p:nvPr/>
          </p:nvCxnSpPr>
          <p:spPr>
            <a:xfrm>
              <a:off x="185919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線コネクタ 246">
              <a:extLst>
                <a:ext uri="{FF2B5EF4-FFF2-40B4-BE49-F238E27FC236}">
                  <a16:creationId xmlns:a16="http://schemas.microsoft.com/office/drawing/2014/main" id="{4C7B7DDB-FBB9-4632-A7D2-070F4AB63244}"/>
                </a:ext>
              </a:extLst>
            </p:cNvPr>
            <p:cNvCxnSpPr>
              <a:cxnSpLocks/>
            </p:cNvCxnSpPr>
            <p:nvPr/>
          </p:nvCxnSpPr>
          <p:spPr>
            <a:xfrm>
              <a:off x="367555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6BC7A246-AE89-4A52-BA17-3FDD7CD33AF1}"/>
                </a:ext>
              </a:extLst>
            </p:cNvPr>
            <p:cNvSpPr txBox="1"/>
            <p:nvPr/>
          </p:nvSpPr>
          <p:spPr>
            <a:xfrm>
              <a:off x="240037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3FBD9852-55C4-469A-A5B9-8323FFFF0470}"/>
                </a:ext>
              </a:extLst>
            </p:cNvPr>
            <p:cNvSpPr txBox="1"/>
            <p:nvPr/>
          </p:nvSpPr>
          <p:spPr>
            <a:xfrm>
              <a:off x="421673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F6452F5D-2054-4066-852D-59ECC71F4F9A}"/>
              </a:ext>
            </a:extLst>
          </p:cNvPr>
          <p:cNvGrpSpPr/>
          <p:nvPr/>
        </p:nvGrpSpPr>
        <p:grpSpPr>
          <a:xfrm>
            <a:off x="1926101" y="5870625"/>
            <a:ext cx="3561185" cy="810921"/>
            <a:chOff x="2011595" y="3740742"/>
            <a:chExt cx="3561185" cy="810921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4411CC5C-7CF3-4AC7-85A2-93414957E5C2}"/>
                </a:ext>
              </a:extLst>
            </p:cNvPr>
            <p:cNvCxnSpPr/>
            <p:nvPr/>
          </p:nvCxnSpPr>
          <p:spPr>
            <a:xfrm>
              <a:off x="201159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6A4DF880-213F-443A-A961-60DDE0BAD23B}"/>
                </a:ext>
              </a:extLst>
            </p:cNvPr>
            <p:cNvCxnSpPr/>
            <p:nvPr/>
          </p:nvCxnSpPr>
          <p:spPr>
            <a:xfrm>
              <a:off x="291977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FBCA6001-82BF-4BA3-A35D-E07943B3D1FC}"/>
                </a:ext>
              </a:extLst>
            </p:cNvPr>
            <p:cNvCxnSpPr/>
            <p:nvPr/>
          </p:nvCxnSpPr>
          <p:spPr>
            <a:xfrm>
              <a:off x="382795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6B28DDD3-20B1-4DB0-BCF7-B6626C011441}"/>
                </a:ext>
              </a:extLst>
            </p:cNvPr>
            <p:cNvCxnSpPr/>
            <p:nvPr/>
          </p:nvCxnSpPr>
          <p:spPr>
            <a:xfrm>
              <a:off x="473613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506129D4-BD5B-4536-9AB6-4E1A3A20EACF}"/>
                </a:ext>
              </a:extLst>
            </p:cNvPr>
            <p:cNvSpPr txBox="1"/>
            <p:nvPr/>
          </p:nvSpPr>
          <p:spPr>
            <a:xfrm>
              <a:off x="209435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2C58CB27-CD53-420A-9A89-6CCA9C21F0F8}"/>
                </a:ext>
              </a:extLst>
            </p:cNvPr>
            <p:cNvSpPr txBox="1"/>
            <p:nvPr/>
          </p:nvSpPr>
          <p:spPr>
            <a:xfrm>
              <a:off x="391071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F8711AFE-8B9A-4EBC-B25F-EA58C031DC34}"/>
                </a:ext>
              </a:extLst>
            </p:cNvPr>
            <p:cNvSpPr txBox="1"/>
            <p:nvPr/>
          </p:nvSpPr>
          <p:spPr>
            <a:xfrm>
              <a:off x="300253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F69C5841-E78F-4A03-AA6F-CC607E6C428B}"/>
                </a:ext>
              </a:extLst>
            </p:cNvPr>
            <p:cNvSpPr txBox="1"/>
            <p:nvPr/>
          </p:nvSpPr>
          <p:spPr>
            <a:xfrm>
              <a:off x="481889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1E547734-C7B2-46E6-AA7E-C55EC19655BC}"/>
                </a:ext>
              </a:extLst>
            </p:cNvPr>
            <p:cNvCxnSpPr>
              <a:cxnSpLocks/>
            </p:cNvCxnSpPr>
            <p:nvPr/>
          </p:nvCxnSpPr>
          <p:spPr>
            <a:xfrm>
              <a:off x="201159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D7EE87AC-2117-474F-9A41-AB08FC2116C0}"/>
                </a:ext>
              </a:extLst>
            </p:cNvPr>
            <p:cNvCxnSpPr>
              <a:cxnSpLocks/>
            </p:cNvCxnSpPr>
            <p:nvPr/>
          </p:nvCxnSpPr>
          <p:spPr>
            <a:xfrm>
              <a:off x="382795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EF94FC45-68CA-43AC-943A-5098F02D9C26}"/>
                </a:ext>
              </a:extLst>
            </p:cNvPr>
            <p:cNvSpPr txBox="1"/>
            <p:nvPr/>
          </p:nvSpPr>
          <p:spPr>
            <a:xfrm>
              <a:off x="255277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328F481B-D583-443F-A428-13E1E52F3B05}"/>
                </a:ext>
              </a:extLst>
            </p:cNvPr>
            <p:cNvSpPr txBox="1"/>
            <p:nvPr/>
          </p:nvSpPr>
          <p:spPr>
            <a:xfrm>
              <a:off x="436913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17B02FB5-A22B-4061-8D33-05E62A54BFC3}"/>
              </a:ext>
            </a:extLst>
          </p:cNvPr>
          <p:cNvGrpSpPr/>
          <p:nvPr/>
        </p:nvGrpSpPr>
        <p:grpSpPr>
          <a:xfrm>
            <a:off x="9025712" y="3673835"/>
            <a:ext cx="3561185" cy="810921"/>
            <a:chOff x="1859195" y="3588342"/>
            <a:chExt cx="3561185" cy="810921"/>
          </a:xfrm>
        </p:grpSpPr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672567C2-B505-40BE-AD27-F33A205AFE95}"/>
                </a:ext>
              </a:extLst>
            </p:cNvPr>
            <p:cNvCxnSpPr/>
            <p:nvPr/>
          </p:nvCxnSpPr>
          <p:spPr>
            <a:xfrm>
              <a:off x="185919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D91D0396-9978-468E-9EE9-8DFB2A5D1C94}"/>
                </a:ext>
              </a:extLst>
            </p:cNvPr>
            <p:cNvCxnSpPr/>
            <p:nvPr/>
          </p:nvCxnSpPr>
          <p:spPr>
            <a:xfrm>
              <a:off x="276737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9B88EAEE-30DA-487F-AE2F-9F7B81D0D3B5}"/>
                </a:ext>
              </a:extLst>
            </p:cNvPr>
            <p:cNvCxnSpPr/>
            <p:nvPr/>
          </p:nvCxnSpPr>
          <p:spPr>
            <a:xfrm>
              <a:off x="367555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93EC6EFE-3F15-4D54-A6F1-6108A0B603BF}"/>
                </a:ext>
              </a:extLst>
            </p:cNvPr>
            <p:cNvCxnSpPr/>
            <p:nvPr/>
          </p:nvCxnSpPr>
          <p:spPr>
            <a:xfrm>
              <a:off x="458373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3CF08704-7741-4D4B-9D49-B862C2432AAD}"/>
                </a:ext>
              </a:extLst>
            </p:cNvPr>
            <p:cNvSpPr txBox="1"/>
            <p:nvPr/>
          </p:nvSpPr>
          <p:spPr>
            <a:xfrm>
              <a:off x="194195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39EE0FA5-1611-4967-BEDF-963B1271DEB6}"/>
                </a:ext>
              </a:extLst>
            </p:cNvPr>
            <p:cNvSpPr txBox="1"/>
            <p:nvPr/>
          </p:nvSpPr>
          <p:spPr>
            <a:xfrm>
              <a:off x="375831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FC266A8-FF8B-4A67-8AE8-C8F85DFFC45E}"/>
                </a:ext>
              </a:extLst>
            </p:cNvPr>
            <p:cNvSpPr txBox="1"/>
            <p:nvPr/>
          </p:nvSpPr>
          <p:spPr>
            <a:xfrm>
              <a:off x="285013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F1887FD-AA38-47CE-803D-194FA0D437D4}"/>
                </a:ext>
              </a:extLst>
            </p:cNvPr>
            <p:cNvSpPr txBox="1"/>
            <p:nvPr/>
          </p:nvSpPr>
          <p:spPr>
            <a:xfrm>
              <a:off x="466649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C42EA644-657E-44B0-BC84-AFA93455C66A}"/>
                </a:ext>
              </a:extLst>
            </p:cNvPr>
            <p:cNvCxnSpPr>
              <a:cxnSpLocks/>
            </p:cNvCxnSpPr>
            <p:nvPr/>
          </p:nvCxnSpPr>
          <p:spPr>
            <a:xfrm>
              <a:off x="185919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FC6E04A8-3C21-4910-AB47-887E0AE94602}"/>
                </a:ext>
              </a:extLst>
            </p:cNvPr>
            <p:cNvCxnSpPr>
              <a:cxnSpLocks/>
            </p:cNvCxnSpPr>
            <p:nvPr/>
          </p:nvCxnSpPr>
          <p:spPr>
            <a:xfrm>
              <a:off x="367555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C5635A26-B3A4-4E0E-8709-00463CD8ACFE}"/>
                </a:ext>
              </a:extLst>
            </p:cNvPr>
            <p:cNvSpPr txBox="1"/>
            <p:nvPr/>
          </p:nvSpPr>
          <p:spPr>
            <a:xfrm>
              <a:off x="240037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16FB5F8-1EE2-446F-89C4-11C13186FC5F}"/>
                </a:ext>
              </a:extLst>
            </p:cNvPr>
            <p:cNvSpPr txBox="1"/>
            <p:nvPr/>
          </p:nvSpPr>
          <p:spPr>
            <a:xfrm>
              <a:off x="421673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ADE12FF5-38AE-440A-B784-1719BE8387B9}"/>
              </a:ext>
            </a:extLst>
          </p:cNvPr>
          <p:cNvGrpSpPr/>
          <p:nvPr/>
        </p:nvGrpSpPr>
        <p:grpSpPr>
          <a:xfrm>
            <a:off x="9059165" y="5956118"/>
            <a:ext cx="3561185" cy="810921"/>
            <a:chOff x="2011595" y="3740742"/>
            <a:chExt cx="3561185" cy="810921"/>
          </a:xfrm>
        </p:grpSpPr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7F138701-BE7F-4313-AC72-09A755080672}"/>
                </a:ext>
              </a:extLst>
            </p:cNvPr>
            <p:cNvCxnSpPr/>
            <p:nvPr/>
          </p:nvCxnSpPr>
          <p:spPr>
            <a:xfrm>
              <a:off x="201159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59666CD7-6437-4BC6-A589-A3CF8EF321EE}"/>
                </a:ext>
              </a:extLst>
            </p:cNvPr>
            <p:cNvCxnSpPr/>
            <p:nvPr/>
          </p:nvCxnSpPr>
          <p:spPr>
            <a:xfrm>
              <a:off x="291977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4BF8ADF-2DDB-40E4-B538-96494CEF3412}"/>
                </a:ext>
              </a:extLst>
            </p:cNvPr>
            <p:cNvCxnSpPr/>
            <p:nvPr/>
          </p:nvCxnSpPr>
          <p:spPr>
            <a:xfrm>
              <a:off x="382795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E29457C0-42C2-44B1-91FD-A5A3C6A06A0D}"/>
                </a:ext>
              </a:extLst>
            </p:cNvPr>
            <p:cNvCxnSpPr/>
            <p:nvPr/>
          </p:nvCxnSpPr>
          <p:spPr>
            <a:xfrm>
              <a:off x="473613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4BCD0B5-025F-483D-8248-7735EE9D2EED}"/>
                </a:ext>
              </a:extLst>
            </p:cNvPr>
            <p:cNvSpPr txBox="1"/>
            <p:nvPr/>
          </p:nvSpPr>
          <p:spPr>
            <a:xfrm>
              <a:off x="209435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3C2AA698-82F6-4029-AD40-D1091C242493}"/>
                </a:ext>
              </a:extLst>
            </p:cNvPr>
            <p:cNvSpPr txBox="1"/>
            <p:nvPr/>
          </p:nvSpPr>
          <p:spPr>
            <a:xfrm>
              <a:off x="391071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43D47641-587D-4C49-97EB-A100334E049B}"/>
                </a:ext>
              </a:extLst>
            </p:cNvPr>
            <p:cNvSpPr txBox="1"/>
            <p:nvPr/>
          </p:nvSpPr>
          <p:spPr>
            <a:xfrm>
              <a:off x="300253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AD68A5A8-3961-4087-954B-65F6E6D4F84E}"/>
                </a:ext>
              </a:extLst>
            </p:cNvPr>
            <p:cNvSpPr txBox="1"/>
            <p:nvPr/>
          </p:nvSpPr>
          <p:spPr>
            <a:xfrm>
              <a:off x="481889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1C241859-C657-4770-B13B-F84ABECBB91C}"/>
                </a:ext>
              </a:extLst>
            </p:cNvPr>
            <p:cNvCxnSpPr>
              <a:cxnSpLocks/>
            </p:cNvCxnSpPr>
            <p:nvPr/>
          </p:nvCxnSpPr>
          <p:spPr>
            <a:xfrm>
              <a:off x="201159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0647BF9B-A93B-4D80-97F0-C507924F9571}"/>
                </a:ext>
              </a:extLst>
            </p:cNvPr>
            <p:cNvCxnSpPr>
              <a:cxnSpLocks/>
            </p:cNvCxnSpPr>
            <p:nvPr/>
          </p:nvCxnSpPr>
          <p:spPr>
            <a:xfrm>
              <a:off x="382795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CE530815-AC10-4B9F-8A51-F3C9DC32AE2D}"/>
                </a:ext>
              </a:extLst>
            </p:cNvPr>
            <p:cNvSpPr txBox="1"/>
            <p:nvPr/>
          </p:nvSpPr>
          <p:spPr>
            <a:xfrm>
              <a:off x="255277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7CF4448A-B3C7-4B3E-9BCE-B7FFC8521F19}"/>
                </a:ext>
              </a:extLst>
            </p:cNvPr>
            <p:cNvSpPr txBox="1"/>
            <p:nvPr/>
          </p:nvSpPr>
          <p:spPr>
            <a:xfrm>
              <a:off x="436913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193A05A-2407-4BFF-A0EF-39B247E1EF55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 (left) and p65 (right) for Fig. 1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E8C29B5-24CD-4F74-90E4-EEFA2D4AC98B}"/>
              </a:ext>
            </a:extLst>
          </p:cNvPr>
          <p:cNvSpPr txBox="1"/>
          <p:nvPr/>
        </p:nvSpPr>
        <p:spPr>
          <a:xfrm>
            <a:off x="1787424" y="116518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A115AAA-837C-425B-A25F-610912ACF972}"/>
              </a:ext>
            </a:extLst>
          </p:cNvPr>
          <p:cNvSpPr txBox="1"/>
          <p:nvPr/>
        </p:nvSpPr>
        <p:spPr>
          <a:xfrm>
            <a:off x="8816655" y="116518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E56C022-4804-41EE-A5AF-AFA3CD5DCC20}"/>
              </a:ext>
            </a:extLst>
          </p:cNvPr>
          <p:cNvSpPr txBox="1"/>
          <p:nvPr/>
        </p:nvSpPr>
        <p:spPr>
          <a:xfrm>
            <a:off x="7786342" y="26081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3723199-84C0-4336-9025-A47F9EF2637E}"/>
              </a:ext>
            </a:extLst>
          </p:cNvPr>
          <p:cNvSpPr txBox="1"/>
          <p:nvPr/>
        </p:nvSpPr>
        <p:spPr>
          <a:xfrm>
            <a:off x="7786342" y="27814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7B55771B-64C2-4704-90E7-122C18B140B5}"/>
              </a:ext>
            </a:extLst>
          </p:cNvPr>
          <p:cNvSpPr txBox="1"/>
          <p:nvPr/>
        </p:nvSpPr>
        <p:spPr>
          <a:xfrm>
            <a:off x="7786342" y="294434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E1406DC-F264-4D3F-8A26-E5FA3B9B6318}"/>
              </a:ext>
            </a:extLst>
          </p:cNvPr>
          <p:cNvSpPr txBox="1"/>
          <p:nvPr/>
        </p:nvSpPr>
        <p:spPr>
          <a:xfrm>
            <a:off x="7786342" y="311764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7A1E2BA-B07D-4098-B260-9E6A8AA1E1DF}"/>
              </a:ext>
            </a:extLst>
          </p:cNvPr>
          <p:cNvSpPr txBox="1"/>
          <p:nvPr/>
        </p:nvSpPr>
        <p:spPr>
          <a:xfrm>
            <a:off x="7786342" y="343202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F7F67B6-708F-4871-B553-728EAD8776E2}"/>
              </a:ext>
            </a:extLst>
          </p:cNvPr>
          <p:cNvSpPr txBox="1"/>
          <p:nvPr/>
        </p:nvSpPr>
        <p:spPr>
          <a:xfrm>
            <a:off x="7786342" y="37359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C13BBCCE-1B6F-4C8A-8820-17EBF0DEF494}"/>
              </a:ext>
            </a:extLst>
          </p:cNvPr>
          <p:cNvSpPr txBox="1"/>
          <p:nvPr/>
        </p:nvSpPr>
        <p:spPr>
          <a:xfrm>
            <a:off x="7786342" y="41809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CCDE24D-7CA7-4F6B-AAB0-81D2D2A44672}"/>
              </a:ext>
            </a:extLst>
          </p:cNvPr>
          <p:cNvSpPr txBox="1"/>
          <p:nvPr/>
        </p:nvSpPr>
        <p:spPr>
          <a:xfrm>
            <a:off x="7788393" y="46853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8E21288-A68E-49A9-BEB6-F0D102E6CCA3}"/>
              </a:ext>
            </a:extLst>
          </p:cNvPr>
          <p:cNvSpPr txBox="1"/>
          <p:nvPr/>
        </p:nvSpPr>
        <p:spPr>
          <a:xfrm>
            <a:off x="7788393" y="48586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3E358CE-8BCC-438E-9425-858C6CBBFBB4}"/>
              </a:ext>
            </a:extLst>
          </p:cNvPr>
          <p:cNvSpPr txBox="1"/>
          <p:nvPr/>
        </p:nvSpPr>
        <p:spPr>
          <a:xfrm>
            <a:off x="7788393" y="502151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AFD0029-8E57-434C-8BB8-C9FE2EE93D69}"/>
              </a:ext>
            </a:extLst>
          </p:cNvPr>
          <p:cNvSpPr txBox="1"/>
          <p:nvPr/>
        </p:nvSpPr>
        <p:spPr>
          <a:xfrm>
            <a:off x="7788393" y="519481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8B854AD4-637E-42D4-A139-ADA85E8734B2}"/>
              </a:ext>
            </a:extLst>
          </p:cNvPr>
          <p:cNvSpPr txBox="1"/>
          <p:nvPr/>
        </p:nvSpPr>
        <p:spPr>
          <a:xfrm>
            <a:off x="7788393" y="550919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C3F8586-A4DC-4C20-B4E6-C8E4FF6E1F61}"/>
              </a:ext>
            </a:extLst>
          </p:cNvPr>
          <p:cNvSpPr txBox="1"/>
          <p:nvPr/>
        </p:nvSpPr>
        <p:spPr>
          <a:xfrm>
            <a:off x="7788393" y="581312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B994964-9795-449D-8920-037CF5B36CAF}"/>
              </a:ext>
            </a:extLst>
          </p:cNvPr>
          <p:cNvSpPr txBox="1"/>
          <p:nvPr/>
        </p:nvSpPr>
        <p:spPr>
          <a:xfrm>
            <a:off x="7788393" y="62581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8A9722F-442C-4BF6-BCD0-F5426A58BC11}"/>
              </a:ext>
            </a:extLst>
          </p:cNvPr>
          <p:cNvSpPr txBox="1"/>
          <p:nvPr/>
        </p:nvSpPr>
        <p:spPr>
          <a:xfrm>
            <a:off x="688050" y="245498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73EE42E1-EED2-4444-BB3F-1637F9206B10}"/>
              </a:ext>
            </a:extLst>
          </p:cNvPr>
          <p:cNvSpPr txBox="1"/>
          <p:nvPr/>
        </p:nvSpPr>
        <p:spPr>
          <a:xfrm>
            <a:off x="688050" y="262828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5BB27B33-FFD6-44EB-89E2-4B6201ECDEEA}"/>
              </a:ext>
            </a:extLst>
          </p:cNvPr>
          <p:cNvSpPr txBox="1"/>
          <p:nvPr/>
        </p:nvSpPr>
        <p:spPr>
          <a:xfrm>
            <a:off x="688050" y="279113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BF3A4CB-60AF-48FF-A3A5-744D38922260}"/>
              </a:ext>
            </a:extLst>
          </p:cNvPr>
          <p:cNvSpPr txBox="1"/>
          <p:nvPr/>
        </p:nvSpPr>
        <p:spPr>
          <a:xfrm>
            <a:off x="688050" y="29644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E2812C8-E306-48C5-8054-69E017C64D01}"/>
              </a:ext>
            </a:extLst>
          </p:cNvPr>
          <p:cNvSpPr txBox="1"/>
          <p:nvPr/>
        </p:nvSpPr>
        <p:spPr>
          <a:xfrm>
            <a:off x="688050" y="327881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B43FA46-99ED-4660-8DA5-2A70DCB75ADE}"/>
              </a:ext>
            </a:extLst>
          </p:cNvPr>
          <p:cNvSpPr txBox="1"/>
          <p:nvPr/>
        </p:nvSpPr>
        <p:spPr>
          <a:xfrm>
            <a:off x="688050" y="358274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D9DED85C-CAA7-4D1A-8BFF-B050FB7F01D1}"/>
              </a:ext>
            </a:extLst>
          </p:cNvPr>
          <p:cNvSpPr txBox="1"/>
          <p:nvPr/>
        </p:nvSpPr>
        <p:spPr>
          <a:xfrm>
            <a:off x="688050" y="402775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FFE26170-4D75-4465-BC96-FBD2EE30FDA8}"/>
              </a:ext>
            </a:extLst>
          </p:cNvPr>
          <p:cNvSpPr txBox="1"/>
          <p:nvPr/>
        </p:nvSpPr>
        <p:spPr>
          <a:xfrm>
            <a:off x="713229" y="47542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86BE6F7C-DAC1-47F9-BE79-BD30F0031D20}"/>
              </a:ext>
            </a:extLst>
          </p:cNvPr>
          <p:cNvSpPr txBox="1"/>
          <p:nvPr/>
        </p:nvSpPr>
        <p:spPr>
          <a:xfrm>
            <a:off x="713229" y="49275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51EC313D-30FD-407B-8DA3-2F4FD540EBE3}"/>
              </a:ext>
            </a:extLst>
          </p:cNvPr>
          <p:cNvSpPr txBox="1"/>
          <p:nvPr/>
        </p:nvSpPr>
        <p:spPr>
          <a:xfrm>
            <a:off x="713229" y="509038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EFD6E18-7FBA-4F0F-9612-D1266818BF1D}"/>
              </a:ext>
            </a:extLst>
          </p:cNvPr>
          <p:cNvSpPr txBox="1"/>
          <p:nvPr/>
        </p:nvSpPr>
        <p:spPr>
          <a:xfrm>
            <a:off x="713229" y="526368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0E096AB-2D04-4B1A-AC6F-DFC315AA6588}"/>
              </a:ext>
            </a:extLst>
          </p:cNvPr>
          <p:cNvSpPr txBox="1"/>
          <p:nvPr/>
        </p:nvSpPr>
        <p:spPr>
          <a:xfrm>
            <a:off x="713229" y="557806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EE7BC1FD-70C8-40FF-8E3F-72E195C69BB4}"/>
              </a:ext>
            </a:extLst>
          </p:cNvPr>
          <p:cNvSpPr txBox="1"/>
          <p:nvPr/>
        </p:nvSpPr>
        <p:spPr>
          <a:xfrm>
            <a:off x="713229" y="588199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335A9171-2E66-4D1F-8F2E-1DDA575A196D}"/>
              </a:ext>
            </a:extLst>
          </p:cNvPr>
          <p:cNvSpPr txBox="1"/>
          <p:nvPr/>
        </p:nvSpPr>
        <p:spPr>
          <a:xfrm>
            <a:off x="713229" y="632700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98833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ABA39CA4-7AC5-4B6B-968F-E0547345C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6475" y="2452379"/>
            <a:ext cx="4508821" cy="412171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BFEC10F-D6D5-4528-80BA-F5C67B91A2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32696" y="2604080"/>
            <a:ext cx="4508821" cy="4142016"/>
          </a:xfrm>
          <a:prstGeom prst="rect">
            <a:avLst/>
          </a:prstGeom>
        </p:spPr>
      </p:pic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5CE8341E-2CF5-4536-9BB7-69A1D0CE480F}"/>
              </a:ext>
            </a:extLst>
          </p:cNvPr>
          <p:cNvGrpSpPr/>
          <p:nvPr/>
        </p:nvGrpSpPr>
        <p:grpSpPr>
          <a:xfrm>
            <a:off x="2127643" y="3747733"/>
            <a:ext cx="3561185" cy="810921"/>
            <a:chOff x="1859195" y="3588342"/>
            <a:chExt cx="3561185" cy="810921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/>
            <p:nvPr/>
          </p:nvCxnSpPr>
          <p:spPr>
            <a:xfrm>
              <a:off x="185919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直線コネクタ 237">
              <a:extLst>
                <a:ext uri="{FF2B5EF4-FFF2-40B4-BE49-F238E27FC236}">
                  <a16:creationId xmlns:a16="http://schemas.microsoft.com/office/drawing/2014/main" id="{F8097A0E-ED0D-4581-9143-48C9779D6315}"/>
                </a:ext>
              </a:extLst>
            </p:cNvPr>
            <p:cNvCxnSpPr/>
            <p:nvPr/>
          </p:nvCxnSpPr>
          <p:spPr>
            <a:xfrm>
              <a:off x="276737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直線コネクタ 238">
              <a:extLst>
                <a:ext uri="{FF2B5EF4-FFF2-40B4-BE49-F238E27FC236}">
                  <a16:creationId xmlns:a16="http://schemas.microsoft.com/office/drawing/2014/main" id="{9F28034C-CD08-447A-9B0E-45D27222A6C0}"/>
                </a:ext>
              </a:extLst>
            </p:cNvPr>
            <p:cNvCxnSpPr/>
            <p:nvPr/>
          </p:nvCxnSpPr>
          <p:spPr>
            <a:xfrm>
              <a:off x="367555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直線コネクタ 239">
              <a:extLst>
                <a:ext uri="{FF2B5EF4-FFF2-40B4-BE49-F238E27FC236}">
                  <a16:creationId xmlns:a16="http://schemas.microsoft.com/office/drawing/2014/main" id="{6A4804AB-E26F-4A50-B400-986F811794C1}"/>
                </a:ext>
              </a:extLst>
            </p:cNvPr>
            <p:cNvCxnSpPr/>
            <p:nvPr/>
          </p:nvCxnSpPr>
          <p:spPr>
            <a:xfrm>
              <a:off x="458373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94195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75831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85013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5297FB1F-A08F-4D13-B642-BCEB351ACD24}"/>
                </a:ext>
              </a:extLst>
            </p:cNvPr>
            <p:cNvSpPr txBox="1"/>
            <p:nvPr/>
          </p:nvSpPr>
          <p:spPr>
            <a:xfrm>
              <a:off x="466649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5" name="直線コネクタ 244">
              <a:extLst>
                <a:ext uri="{FF2B5EF4-FFF2-40B4-BE49-F238E27FC236}">
                  <a16:creationId xmlns:a16="http://schemas.microsoft.com/office/drawing/2014/main" id="{583FD533-79D4-4916-A568-B21001918C70}"/>
                </a:ext>
              </a:extLst>
            </p:cNvPr>
            <p:cNvCxnSpPr>
              <a:cxnSpLocks/>
            </p:cNvCxnSpPr>
            <p:nvPr/>
          </p:nvCxnSpPr>
          <p:spPr>
            <a:xfrm>
              <a:off x="185919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線コネクタ 246">
              <a:extLst>
                <a:ext uri="{FF2B5EF4-FFF2-40B4-BE49-F238E27FC236}">
                  <a16:creationId xmlns:a16="http://schemas.microsoft.com/office/drawing/2014/main" id="{4C7B7DDB-FBB9-4632-A7D2-070F4AB63244}"/>
                </a:ext>
              </a:extLst>
            </p:cNvPr>
            <p:cNvCxnSpPr>
              <a:cxnSpLocks/>
            </p:cNvCxnSpPr>
            <p:nvPr/>
          </p:nvCxnSpPr>
          <p:spPr>
            <a:xfrm>
              <a:off x="367555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6BC7A246-AE89-4A52-BA17-3FDD7CD33AF1}"/>
                </a:ext>
              </a:extLst>
            </p:cNvPr>
            <p:cNvSpPr txBox="1"/>
            <p:nvPr/>
          </p:nvSpPr>
          <p:spPr>
            <a:xfrm>
              <a:off x="240037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3FBD9852-55C4-469A-A5B9-8323FFFF0470}"/>
                </a:ext>
              </a:extLst>
            </p:cNvPr>
            <p:cNvSpPr txBox="1"/>
            <p:nvPr/>
          </p:nvSpPr>
          <p:spPr>
            <a:xfrm>
              <a:off x="421673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F6452F5D-2054-4066-852D-59ECC71F4F9A}"/>
              </a:ext>
            </a:extLst>
          </p:cNvPr>
          <p:cNvGrpSpPr/>
          <p:nvPr/>
        </p:nvGrpSpPr>
        <p:grpSpPr>
          <a:xfrm>
            <a:off x="2186159" y="5853847"/>
            <a:ext cx="3561185" cy="810921"/>
            <a:chOff x="2011595" y="3740742"/>
            <a:chExt cx="3561185" cy="810921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4411CC5C-7CF3-4AC7-85A2-93414957E5C2}"/>
                </a:ext>
              </a:extLst>
            </p:cNvPr>
            <p:cNvCxnSpPr/>
            <p:nvPr/>
          </p:nvCxnSpPr>
          <p:spPr>
            <a:xfrm>
              <a:off x="201159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6A4DF880-213F-443A-A961-60DDE0BAD23B}"/>
                </a:ext>
              </a:extLst>
            </p:cNvPr>
            <p:cNvCxnSpPr/>
            <p:nvPr/>
          </p:nvCxnSpPr>
          <p:spPr>
            <a:xfrm>
              <a:off x="291977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FBCA6001-82BF-4BA3-A35D-E07943B3D1FC}"/>
                </a:ext>
              </a:extLst>
            </p:cNvPr>
            <p:cNvCxnSpPr/>
            <p:nvPr/>
          </p:nvCxnSpPr>
          <p:spPr>
            <a:xfrm>
              <a:off x="382795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6B28DDD3-20B1-4DB0-BCF7-B6626C011441}"/>
                </a:ext>
              </a:extLst>
            </p:cNvPr>
            <p:cNvCxnSpPr/>
            <p:nvPr/>
          </p:nvCxnSpPr>
          <p:spPr>
            <a:xfrm>
              <a:off x="473613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506129D4-BD5B-4536-9AB6-4E1A3A20EACF}"/>
                </a:ext>
              </a:extLst>
            </p:cNvPr>
            <p:cNvSpPr txBox="1"/>
            <p:nvPr/>
          </p:nvSpPr>
          <p:spPr>
            <a:xfrm>
              <a:off x="209435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2C58CB27-CD53-420A-9A89-6CCA9C21F0F8}"/>
                </a:ext>
              </a:extLst>
            </p:cNvPr>
            <p:cNvSpPr txBox="1"/>
            <p:nvPr/>
          </p:nvSpPr>
          <p:spPr>
            <a:xfrm>
              <a:off x="391071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F8711AFE-8B9A-4EBC-B25F-EA58C031DC34}"/>
                </a:ext>
              </a:extLst>
            </p:cNvPr>
            <p:cNvSpPr txBox="1"/>
            <p:nvPr/>
          </p:nvSpPr>
          <p:spPr>
            <a:xfrm>
              <a:off x="300253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F69C5841-E78F-4A03-AA6F-CC607E6C428B}"/>
                </a:ext>
              </a:extLst>
            </p:cNvPr>
            <p:cNvSpPr txBox="1"/>
            <p:nvPr/>
          </p:nvSpPr>
          <p:spPr>
            <a:xfrm>
              <a:off x="481889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1E547734-C7B2-46E6-AA7E-C55EC19655BC}"/>
                </a:ext>
              </a:extLst>
            </p:cNvPr>
            <p:cNvCxnSpPr>
              <a:cxnSpLocks/>
            </p:cNvCxnSpPr>
            <p:nvPr/>
          </p:nvCxnSpPr>
          <p:spPr>
            <a:xfrm>
              <a:off x="201159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D7EE87AC-2117-474F-9A41-AB08FC2116C0}"/>
                </a:ext>
              </a:extLst>
            </p:cNvPr>
            <p:cNvCxnSpPr>
              <a:cxnSpLocks/>
            </p:cNvCxnSpPr>
            <p:nvPr/>
          </p:nvCxnSpPr>
          <p:spPr>
            <a:xfrm>
              <a:off x="382795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EF94FC45-68CA-43AC-943A-5098F02D9C26}"/>
                </a:ext>
              </a:extLst>
            </p:cNvPr>
            <p:cNvSpPr txBox="1"/>
            <p:nvPr/>
          </p:nvSpPr>
          <p:spPr>
            <a:xfrm>
              <a:off x="255277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328F481B-D583-443F-A428-13E1E52F3B05}"/>
                </a:ext>
              </a:extLst>
            </p:cNvPr>
            <p:cNvSpPr txBox="1"/>
            <p:nvPr/>
          </p:nvSpPr>
          <p:spPr>
            <a:xfrm>
              <a:off x="436913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17B02FB5-A22B-4061-8D33-05E62A54BFC3}"/>
              </a:ext>
            </a:extLst>
          </p:cNvPr>
          <p:cNvGrpSpPr/>
          <p:nvPr/>
        </p:nvGrpSpPr>
        <p:grpSpPr>
          <a:xfrm>
            <a:off x="9042490" y="3891949"/>
            <a:ext cx="3561185" cy="810921"/>
            <a:chOff x="1859195" y="3588342"/>
            <a:chExt cx="3561185" cy="810921"/>
          </a:xfrm>
        </p:grpSpPr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672567C2-B505-40BE-AD27-F33A205AFE95}"/>
                </a:ext>
              </a:extLst>
            </p:cNvPr>
            <p:cNvCxnSpPr/>
            <p:nvPr/>
          </p:nvCxnSpPr>
          <p:spPr>
            <a:xfrm>
              <a:off x="185919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D91D0396-9978-468E-9EE9-8DFB2A5D1C94}"/>
                </a:ext>
              </a:extLst>
            </p:cNvPr>
            <p:cNvCxnSpPr/>
            <p:nvPr/>
          </p:nvCxnSpPr>
          <p:spPr>
            <a:xfrm>
              <a:off x="276737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9B88EAEE-30DA-487F-AE2F-9F7B81D0D3B5}"/>
                </a:ext>
              </a:extLst>
            </p:cNvPr>
            <p:cNvCxnSpPr/>
            <p:nvPr/>
          </p:nvCxnSpPr>
          <p:spPr>
            <a:xfrm>
              <a:off x="367555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93EC6EFE-3F15-4D54-A6F1-6108A0B603BF}"/>
                </a:ext>
              </a:extLst>
            </p:cNvPr>
            <p:cNvCxnSpPr/>
            <p:nvPr/>
          </p:nvCxnSpPr>
          <p:spPr>
            <a:xfrm>
              <a:off x="4583735" y="35883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3CF08704-7741-4D4B-9D49-B862C2432AAD}"/>
                </a:ext>
              </a:extLst>
            </p:cNvPr>
            <p:cNvSpPr txBox="1"/>
            <p:nvPr/>
          </p:nvSpPr>
          <p:spPr>
            <a:xfrm>
              <a:off x="194195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39EE0FA5-1611-4967-BEDF-963B1271DEB6}"/>
                </a:ext>
              </a:extLst>
            </p:cNvPr>
            <p:cNvSpPr txBox="1"/>
            <p:nvPr/>
          </p:nvSpPr>
          <p:spPr>
            <a:xfrm>
              <a:off x="375831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FC266A8-FF8B-4A67-8AE8-C8F85DFFC45E}"/>
                </a:ext>
              </a:extLst>
            </p:cNvPr>
            <p:cNvSpPr txBox="1"/>
            <p:nvPr/>
          </p:nvSpPr>
          <p:spPr>
            <a:xfrm>
              <a:off x="285013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F1887FD-AA38-47CE-803D-194FA0D437D4}"/>
                </a:ext>
              </a:extLst>
            </p:cNvPr>
            <p:cNvSpPr txBox="1"/>
            <p:nvPr/>
          </p:nvSpPr>
          <p:spPr>
            <a:xfrm>
              <a:off x="4666498" y="35926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C42EA644-657E-44B0-BC84-AFA93455C66A}"/>
                </a:ext>
              </a:extLst>
            </p:cNvPr>
            <p:cNvCxnSpPr>
              <a:cxnSpLocks/>
            </p:cNvCxnSpPr>
            <p:nvPr/>
          </p:nvCxnSpPr>
          <p:spPr>
            <a:xfrm>
              <a:off x="185919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FC6E04A8-3C21-4910-AB47-887E0AE94602}"/>
                </a:ext>
              </a:extLst>
            </p:cNvPr>
            <p:cNvCxnSpPr>
              <a:cxnSpLocks/>
            </p:cNvCxnSpPr>
            <p:nvPr/>
          </p:nvCxnSpPr>
          <p:spPr>
            <a:xfrm>
              <a:off x="3675555" y="40188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C5635A26-B3A4-4E0E-8709-00463CD8ACFE}"/>
                </a:ext>
              </a:extLst>
            </p:cNvPr>
            <p:cNvSpPr txBox="1"/>
            <p:nvPr/>
          </p:nvSpPr>
          <p:spPr>
            <a:xfrm>
              <a:off x="240037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16FB5F8-1EE2-446F-89C4-11C13186FC5F}"/>
                </a:ext>
              </a:extLst>
            </p:cNvPr>
            <p:cNvSpPr txBox="1"/>
            <p:nvPr/>
          </p:nvSpPr>
          <p:spPr>
            <a:xfrm>
              <a:off x="4216730" y="40299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ADE12FF5-38AE-440A-B784-1719BE8387B9}"/>
              </a:ext>
            </a:extLst>
          </p:cNvPr>
          <p:cNvGrpSpPr/>
          <p:nvPr/>
        </p:nvGrpSpPr>
        <p:grpSpPr>
          <a:xfrm>
            <a:off x="9042387" y="6014841"/>
            <a:ext cx="3561185" cy="810921"/>
            <a:chOff x="2011595" y="3740742"/>
            <a:chExt cx="3561185" cy="810921"/>
          </a:xfrm>
        </p:grpSpPr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7F138701-BE7F-4313-AC72-09A755080672}"/>
                </a:ext>
              </a:extLst>
            </p:cNvPr>
            <p:cNvCxnSpPr/>
            <p:nvPr/>
          </p:nvCxnSpPr>
          <p:spPr>
            <a:xfrm>
              <a:off x="201159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59666CD7-6437-4BC6-A589-A3CF8EF321EE}"/>
                </a:ext>
              </a:extLst>
            </p:cNvPr>
            <p:cNvCxnSpPr/>
            <p:nvPr/>
          </p:nvCxnSpPr>
          <p:spPr>
            <a:xfrm>
              <a:off x="291977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4BF8ADF-2DDB-40E4-B538-96494CEF3412}"/>
                </a:ext>
              </a:extLst>
            </p:cNvPr>
            <p:cNvCxnSpPr/>
            <p:nvPr/>
          </p:nvCxnSpPr>
          <p:spPr>
            <a:xfrm>
              <a:off x="382795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E29457C0-42C2-44B1-91FD-A5A3C6A06A0D}"/>
                </a:ext>
              </a:extLst>
            </p:cNvPr>
            <p:cNvCxnSpPr/>
            <p:nvPr/>
          </p:nvCxnSpPr>
          <p:spPr>
            <a:xfrm>
              <a:off x="4736135" y="3740742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4BCD0B5-025F-483D-8248-7735EE9D2EED}"/>
                </a:ext>
              </a:extLst>
            </p:cNvPr>
            <p:cNvSpPr txBox="1"/>
            <p:nvPr/>
          </p:nvSpPr>
          <p:spPr>
            <a:xfrm>
              <a:off x="209435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3C2AA698-82F6-4029-AD40-D1091C242493}"/>
                </a:ext>
              </a:extLst>
            </p:cNvPr>
            <p:cNvSpPr txBox="1"/>
            <p:nvPr/>
          </p:nvSpPr>
          <p:spPr>
            <a:xfrm>
              <a:off x="391071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43D47641-587D-4C49-97EB-A100334E049B}"/>
                </a:ext>
              </a:extLst>
            </p:cNvPr>
            <p:cNvSpPr txBox="1"/>
            <p:nvPr/>
          </p:nvSpPr>
          <p:spPr>
            <a:xfrm>
              <a:off x="300253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AD68A5A8-3961-4087-954B-65F6E6D4F84E}"/>
                </a:ext>
              </a:extLst>
            </p:cNvPr>
            <p:cNvSpPr txBox="1"/>
            <p:nvPr/>
          </p:nvSpPr>
          <p:spPr>
            <a:xfrm>
              <a:off x="4818898" y="3745025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1C241859-C657-4770-B13B-F84ABECBB91C}"/>
                </a:ext>
              </a:extLst>
            </p:cNvPr>
            <p:cNvCxnSpPr>
              <a:cxnSpLocks/>
            </p:cNvCxnSpPr>
            <p:nvPr/>
          </p:nvCxnSpPr>
          <p:spPr>
            <a:xfrm>
              <a:off x="201159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0647BF9B-A93B-4D80-97F0-C507924F9571}"/>
                </a:ext>
              </a:extLst>
            </p:cNvPr>
            <p:cNvCxnSpPr>
              <a:cxnSpLocks/>
            </p:cNvCxnSpPr>
            <p:nvPr/>
          </p:nvCxnSpPr>
          <p:spPr>
            <a:xfrm>
              <a:off x="3827955" y="4171263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CE530815-AC10-4B9F-8A51-F3C9DC32AE2D}"/>
                </a:ext>
              </a:extLst>
            </p:cNvPr>
            <p:cNvSpPr txBox="1"/>
            <p:nvPr/>
          </p:nvSpPr>
          <p:spPr>
            <a:xfrm>
              <a:off x="255277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7CF4448A-B3C7-4B3E-9BCE-B7FFC8521F19}"/>
                </a:ext>
              </a:extLst>
            </p:cNvPr>
            <p:cNvSpPr txBox="1"/>
            <p:nvPr/>
          </p:nvSpPr>
          <p:spPr>
            <a:xfrm>
              <a:off x="4369130" y="418233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193A05A-2407-4BFF-A0EF-39B247E1EF55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JNK (left) and JNK (right) for Fig. 1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E8C29B5-24CD-4F74-90E4-EEFA2D4AC98B}"/>
              </a:ext>
            </a:extLst>
          </p:cNvPr>
          <p:cNvSpPr txBox="1"/>
          <p:nvPr/>
        </p:nvSpPr>
        <p:spPr>
          <a:xfrm>
            <a:off x="1364777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54 and p-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A115AAA-837C-425B-A25F-610912ACF972}"/>
              </a:ext>
            </a:extLst>
          </p:cNvPr>
          <p:cNvSpPr txBox="1"/>
          <p:nvPr/>
        </p:nvSpPr>
        <p:spPr>
          <a:xfrm>
            <a:off x="8394008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54 and p46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CCDE24D-7CA7-4F6B-AAB0-81D2D2A44672}"/>
              </a:ext>
            </a:extLst>
          </p:cNvPr>
          <p:cNvSpPr txBox="1"/>
          <p:nvPr/>
        </p:nvSpPr>
        <p:spPr>
          <a:xfrm>
            <a:off x="7850772" y="46721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8E21288-A68E-49A9-BEB6-F0D102E6CCA3}"/>
              </a:ext>
            </a:extLst>
          </p:cNvPr>
          <p:cNvSpPr txBox="1"/>
          <p:nvPr/>
        </p:nvSpPr>
        <p:spPr>
          <a:xfrm>
            <a:off x="7850772" y="482163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3E358CE-8BCC-438E-9425-858C6CBBFBB4}"/>
              </a:ext>
            </a:extLst>
          </p:cNvPr>
          <p:cNvSpPr txBox="1"/>
          <p:nvPr/>
        </p:nvSpPr>
        <p:spPr>
          <a:xfrm>
            <a:off x="7850772" y="497972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AFD0029-8E57-434C-8BB8-C9FE2EE93D69}"/>
              </a:ext>
            </a:extLst>
          </p:cNvPr>
          <p:cNvSpPr txBox="1"/>
          <p:nvPr/>
        </p:nvSpPr>
        <p:spPr>
          <a:xfrm>
            <a:off x="7850772" y="515302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8B854AD4-637E-42D4-A139-ADA85E8734B2}"/>
              </a:ext>
            </a:extLst>
          </p:cNvPr>
          <p:cNvSpPr txBox="1"/>
          <p:nvPr/>
        </p:nvSpPr>
        <p:spPr>
          <a:xfrm>
            <a:off x="7850772" y="54483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C3F8586-A4DC-4C20-B4E6-C8E4FF6E1F61}"/>
              </a:ext>
            </a:extLst>
          </p:cNvPr>
          <p:cNvSpPr txBox="1"/>
          <p:nvPr/>
        </p:nvSpPr>
        <p:spPr>
          <a:xfrm>
            <a:off x="7850772" y="574752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B994964-9795-449D-8920-037CF5B36CAF}"/>
              </a:ext>
            </a:extLst>
          </p:cNvPr>
          <p:cNvSpPr txBox="1"/>
          <p:nvPr/>
        </p:nvSpPr>
        <p:spPr>
          <a:xfrm>
            <a:off x="7850772" y="61925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FE48A0FC-65EA-4B16-A145-4359B463204B}"/>
              </a:ext>
            </a:extLst>
          </p:cNvPr>
          <p:cNvSpPr txBox="1"/>
          <p:nvPr/>
        </p:nvSpPr>
        <p:spPr>
          <a:xfrm>
            <a:off x="7818614" y="255952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9AC4509-5415-4B0E-80DC-C07F43FD6368}"/>
              </a:ext>
            </a:extLst>
          </p:cNvPr>
          <p:cNvSpPr txBox="1"/>
          <p:nvPr/>
        </p:nvSpPr>
        <p:spPr>
          <a:xfrm>
            <a:off x="7818614" y="27090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6A44E4B-BC7F-4418-9EC1-E5A81E88A7EF}"/>
              </a:ext>
            </a:extLst>
          </p:cNvPr>
          <p:cNvSpPr txBox="1"/>
          <p:nvPr/>
        </p:nvSpPr>
        <p:spPr>
          <a:xfrm>
            <a:off x="7818614" y="286709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4F6393DB-07A1-460D-B9CB-4BE5D57DBA5B}"/>
              </a:ext>
            </a:extLst>
          </p:cNvPr>
          <p:cNvSpPr txBox="1"/>
          <p:nvPr/>
        </p:nvSpPr>
        <p:spPr>
          <a:xfrm>
            <a:off x="7818614" y="304040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1DA1AF80-5957-49C8-9919-ED2EE8B6E6A4}"/>
              </a:ext>
            </a:extLst>
          </p:cNvPr>
          <p:cNvSpPr txBox="1"/>
          <p:nvPr/>
        </p:nvSpPr>
        <p:spPr>
          <a:xfrm>
            <a:off x="7818614" y="333573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4E51D774-C316-41EE-A705-5B15D700EBD4}"/>
              </a:ext>
            </a:extLst>
          </p:cNvPr>
          <p:cNvSpPr txBox="1"/>
          <p:nvPr/>
        </p:nvSpPr>
        <p:spPr>
          <a:xfrm>
            <a:off x="7818614" y="36348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08FB990-A77F-4975-80EB-E46C8380ABCB}"/>
              </a:ext>
            </a:extLst>
          </p:cNvPr>
          <p:cNvSpPr txBox="1"/>
          <p:nvPr/>
        </p:nvSpPr>
        <p:spPr>
          <a:xfrm>
            <a:off x="7818614" y="40799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5368DB26-5F93-41D5-AA75-22A7F61FDFB6}"/>
              </a:ext>
            </a:extLst>
          </p:cNvPr>
          <p:cNvSpPr txBox="1"/>
          <p:nvPr/>
        </p:nvSpPr>
        <p:spPr>
          <a:xfrm>
            <a:off x="889307" y="24169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E82A395E-AD0F-4B31-BA9B-DB6F5EF9AFD5}"/>
              </a:ext>
            </a:extLst>
          </p:cNvPr>
          <p:cNvSpPr txBox="1"/>
          <p:nvPr/>
        </p:nvSpPr>
        <p:spPr>
          <a:xfrm>
            <a:off x="889307" y="256639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511AB015-7C2E-4D2F-8EF3-CFB7A7F066FD}"/>
              </a:ext>
            </a:extLst>
          </p:cNvPr>
          <p:cNvSpPr txBox="1"/>
          <p:nvPr/>
        </p:nvSpPr>
        <p:spPr>
          <a:xfrm>
            <a:off x="889307" y="272448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4791E88-37BA-4A29-A179-06C25D49C83C}"/>
              </a:ext>
            </a:extLst>
          </p:cNvPr>
          <p:cNvSpPr txBox="1"/>
          <p:nvPr/>
        </p:nvSpPr>
        <p:spPr>
          <a:xfrm>
            <a:off x="889307" y="289778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FBB1B8EE-FD88-4D5C-9F38-609DE670D33F}"/>
              </a:ext>
            </a:extLst>
          </p:cNvPr>
          <p:cNvSpPr txBox="1"/>
          <p:nvPr/>
        </p:nvSpPr>
        <p:spPr>
          <a:xfrm>
            <a:off x="889307" y="319311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26A9BD-5394-4259-BAF6-3A7CE390F62F}"/>
              </a:ext>
            </a:extLst>
          </p:cNvPr>
          <p:cNvSpPr txBox="1"/>
          <p:nvPr/>
        </p:nvSpPr>
        <p:spPr>
          <a:xfrm>
            <a:off x="889307" y="349228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E4AC15A0-2323-428A-824F-D16AEAC8273A}"/>
              </a:ext>
            </a:extLst>
          </p:cNvPr>
          <p:cNvSpPr txBox="1"/>
          <p:nvPr/>
        </p:nvSpPr>
        <p:spPr>
          <a:xfrm>
            <a:off x="889307" y="393729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5E41C807-B900-4765-A500-E6144CD5CFD2}"/>
              </a:ext>
            </a:extLst>
          </p:cNvPr>
          <p:cNvSpPr txBox="1"/>
          <p:nvPr/>
        </p:nvSpPr>
        <p:spPr>
          <a:xfrm>
            <a:off x="949428" y="451555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4D4B820E-F8E9-4FC7-A568-9EE9D2B22839}"/>
              </a:ext>
            </a:extLst>
          </p:cNvPr>
          <p:cNvSpPr txBox="1"/>
          <p:nvPr/>
        </p:nvSpPr>
        <p:spPr>
          <a:xfrm>
            <a:off x="949428" y="466504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269DD461-C360-44A2-9F26-B0C75DD74348}"/>
              </a:ext>
            </a:extLst>
          </p:cNvPr>
          <p:cNvSpPr txBox="1"/>
          <p:nvPr/>
        </p:nvSpPr>
        <p:spPr>
          <a:xfrm>
            <a:off x="949428" y="482313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F1B9F560-C2D7-4418-A5F6-3CE41C8BF461}"/>
              </a:ext>
            </a:extLst>
          </p:cNvPr>
          <p:cNvSpPr txBox="1"/>
          <p:nvPr/>
        </p:nvSpPr>
        <p:spPr>
          <a:xfrm>
            <a:off x="949428" y="499643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A264744-FE6F-4023-A16A-2CC53876CD40}"/>
              </a:ext>
            </a:extLst>
          </p:cNvPr>
          <p:cNvSpPr txBox="1"/>
          <p:nvPr/>
        </p:nvSpPr>
        <p:spPr>
          <a:xfrm>
            <a:off x="949428" y="529176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AC7958EA-4A5C-452F-85BD-2733C2FE3F89}"/>
              </a:ext>
            </a:extLst>
          </p:cNvPr>
          <p:cNvSpPr txBox="1"/>
          <p:nvPr/>
        </p:nvSpPr>
        <p:spPr>
          <a:xfrm>
            <a:off x="949428" y="559092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9A4BAD1D-0FDA-45DF-9E06-65C59B948BFD}"/>
              </a:ext>
            </a:extLst>
          </p:cNvPr>
          <p:cNvSpPr txBox="1"/>
          <p:nvPr/>
        </p:nvSpPr>
        <p:spPr>
          <a:xfrm>
            <a:off x="949428" y="603593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569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25D31090-0699-43DD-9538-F881A5FFBF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02173" y="2236489"/>
            <a:ext cx="4529131" cy="416232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5C99374B-220A-4488-82ED-A6CAB3307F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8839" y="2160270"/>
            <a:ext cx="4529131" cy="4081104"/>
          </a:xfrm>
          <a:prstGeom prst="rect">
            <a:avLst/>
          </a:prstGeom>
        </p:spPr>
      </p:pic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193A05A-2407-4BFF-A0EF-39B247E1EF55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38 (left) and p38 (right) for Fig. 1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E8C29B5-24CD-4F74-90E4-EEFA2D4AC98B}"/>
              </a:ext>
            </a:extLst>
          </p:cNvPr>
          <p:cNvSpPr txBox="1"/>
          <p:nvPr/>
        </p:nvSpPr>
        <p:spPr>
          <a:xfrm>
            <a:off x="1364777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A115AAA-837C-425B-A25F-610912ACF972}"/>
              </a:ext>
            </a:extLst>
          </p:cNvPr>
          <p:cNvSpPr txBox="1"/>
          <p:nvPr/>
        </p:nvSpPr>
        <p:spPr>
          <a:xfrm>
            <a:off x="8394008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CCDE24D-7CA7-4F6B-AAB0-81D2D2A44672}"/>
              </a:ext>
            </a:extLst>
          </p:cNvPr>
          <p:cNvSpPr txBox="1"/>
          <p:nvPr/>
        </p:nvSpPr>
        <p:spPr>
          <a:xfrm>
            <a:off x="7681872" y="433434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8E21288-A68E-49A9-BEB6-F0D102E6CCA3}"/>
              </a:ext>
            </a:extLst>
          </p:cNvPr>
          <p:cNvSpPr txBox="1"/>
          <p:nvPr/>
        </p:nvSpPr>
        <p:spPr>
          <a:xfrm>
            <a:off x="7681872" y="448383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3E358CE-8BCC-438E-9425-858C6CBBFBB4}"/>
              </a:ext>
            </a:extLst>
          </p:cNvPr>
          <p:cNvSpPr txBox="1"/>
          <p:nvPr/>
        </p:nvSpPr>
        <p:spPr>
          <a:xfrm>
            <a:off x="7681872" y="464192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AFD0029-8E57-434C-8BB8-C9FE2EE93D69}"/>
              </a:ext>
            </a:extLst>
          </p:cNvPr>
          <p:cNvSpPr txBox="1"/>
          <p:nvPr/>
        </p:nvSpPr>
        <p:spPr>
          <a:xfrm>
            <a:off x="7681872" y="481522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8B854AD4-637E-42D4-A139-ADA85E8734B2}"/>
              </a:ext>
            </a:extLst>
          </p:cNvPr>
          <p:cNvSpPr txBox="1"/>
          <p:nvPr/>
        </p:nvSpPr>
        <p:spPr>
          <a:xfrm>
            <a:off x="7681872" y="511055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C3F8586-A4DC-4C20-B4E6-C8E4FF6E1F61}"/>
              </a:ext>
            </a:extLst>
          </p:cNvPr>
          <p:cNvSpPr txBox="1"/>
          <p:nvPr/>
        </p:nvSpPr>
        <p:spPr>
          <a:xfrm>
            <a:off x="7681872" y="540972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B994964-9795-449D-8920-037CF5B36CAF}"/>
              </a:ext>
            </a:extLst>
          </p:cNvPr>
          <p:cNvSpPr txBox="1"/>
          <p:nvPr/>
        </p:nvSpPr>
        <p:spPr>
          <a:xfrm>
            <a:off x="7681872" y="585472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FE48A0FC-65EA-4B16-A145-4359B463204B}"/>
              </a:ext>
            </a:extLst>
          </p:cNvPr>
          <p:cNvSpPr txBox="1"/>
          <p:nvPr/>
        </p:nvSpPr>
        <p:spPr>
          <a:xfrm>
            <a:off x="7701774" y="221408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9AC4509-5415-4B0E-80DC-C07F43FD6368}"/>
              </a:ext>
            </a:extLst>
          </p:cNvPr>
          <p:cNvSpPr txBox="1"/>
          <p:nvPr/>
        </p:nvSpPr>
        <p:spPr>
          <a:xfrm>
            <a:off x="7701774" y="236357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6A44E4B-BC7F-4418-9EC1-E5A81E88A7EF}"/>
              </a:ext>
            </a:extLst>
          </p:cNvPr>
          <p:cNvSpPr txBox="1"/>
          <p:nvPr/>
        </p:nvSpPr>
        <p:spPr>
          <a:xfrm>
            <a:off x="7701774" y="25216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4F6393DB-07A1-460D-B9CB-4BE5D57DBA5B}"/>
              </a:ext>
            </a:extLst>
          </p:cNvPr>
          <p:cNvSpPr txBox="1"/>
          <p:nvPr/>
        </p:nvSpPr>
        <p:spPr>
          <a:xfrm>
            <a:off x="7701774" y="269496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1DA1AF80-5957-49C8-9919-ED2EE8B6E6A4}"/>
              </a:ext>
            </a:extLst>
          </p:cNvPr>
          <p:cNvSpPr txBox="1"/>
          <p:nvPr/>
        </p:nvSpPr>
        <p:spPr>
          <a:xfrm>
            <a:off x="7701774" y="299029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4E51D774-C316-41EE-A705-5B15D700EBD4}"/>
              </a:ext>
            </a:extLst>
          </p:cNvPr>
          <p:cNvSpPr txBox="1"/>
          <p:nvPr/>
        </p:nvSpPr>
        <p:spPr>
          <a:xfrm>
            <a:off x="7701774" y="32894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08FB990-A77F-4975-80EB-E46C8380ABCB}"/>
              </a:ext>
            </a:extLst>
          </p:cNvPr>
          <p:cNvSpPr txBox="1"/>
          <p:nvPr/>
        </p:nvSpPr>
        <p:spPr>
          <a:xfrm>
            <a:off x="7701774" y="37344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5368DB26-5F93-41D5-AA75-22A7F61FDFB6}"/>
              </a:ext>
            </a:extLst>
          </p:cNvPr>
          <p:cNvSpPr txBox="1"/>
          <p:nvPr/>
        </p:nvSpPr>
        <p:spPr>
          <a:xfrm>
            <a:off x="889307" y="204283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E82A395E-AD0F-4B31-BA9B-DB6F5EF9AFD5}"/>
              </a:ext>
            </a:extLst>
          </p:cNvPr>
          <p:cNvSpPr txBox="1"/>
          <p:nvPr/>
        </p:nvSpPr>
        <p:spPr>
          <a:xfrm>
            <a:off x="889307" y="219232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511AB015-7C2E-4D2F-8EF3-CFB7A7F066FD}"/>
              </a:ext>
            </a:extLst>
          </p:cNvPr>
          <p:cNvSpPr txBox="1"/>
          <p:nvPr/>
        </p:nvSpPr>
        <p:spPr>
          <a:xfrm>
            <a:off x="889307" y="23504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4791E88-37BA-4A29-A179-06C25D49C83C}"/>
              </a:ext>
            </a:extLst>
          </p:cNvPr>
          <p:cNvSpPr txBox="1"/>
          <p:nvPr/>
        </p:nvSpPr>
        <p:spPr>
          <a:xfrm>
            <a:off x="889307" y="252371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FBB1B8EE-FD88-4D5C-9F38-609DE670D33F}"/>
              </a:ext>
            </a:extLst>
          </p:cNvPr>
          <p:cNvSpPr txBox="1"/>
          <p:nvPr/>
        </p:nvSpPr>
        <p:spPr>
          <a:xfrm>
            <a:off x="889307" y="281904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26A9BD-5394-4259-BAF6-3A7CE390F62F}"/>
              </a:ext>
            </a:extLst>
          </p:cNvPr>
          <p:cNvSpPr txBox="1"/>
          <p:nvPr/>
        </p:nvSpPr>
        <p:spPr>
          <a:xfrm>
            <a:off x="889307" y="311820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E4AC15A0-2323-428A-824F-D16AEAC8273A}"/>
              </a:ext>
            </a:extLst>
          </p:cNvPr>
          <p:cNvSpPr txBox="1"/>
          <p:nvPr/>
        </p:nvSpPr>
        <p:spPr>
          <a:xfrm>
            <a:off x="889307" y="356321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5E41C807-B900-4765-A500-E6144CD5CFD2}"/>
              </a:ext>
            </a:extLst>
          </p:cNvPr>
          <p:cNvSpPr txBox="1"/>
          <p:nvPr/>
        </p:nvSpPr>
        <p:spPr>
          <a:xfrm>
            <a:off x="907863" y="414148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4D4B820E-F8E9-4FC7-A568-9EE9D2B22839}"/>
              </a:ext>
            </a:extLst>
          </p:cNvPr>
          <p:cNvSpPr txBox="1"/>
          <p:nvPr/>
        </p:nvSpPr>
        <p:spPr>
          <a:xfrm>
            <a:off x="907863" y="429097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269DD461-C360-44A2-9F26-B0C75DD74348}"/>
              </a:ext>
            </a:extLst>
          </p:cNvPr>
          <p:cNvSpPr txBox="1"/>
          <p:nvPr/>
        </p:nvSpPr>
        <p:spPr>
          <a:xfrm>
            <a:off x="907863" y="444905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F1B9F560-C2D7-4418-A5F6-3CE41C8BF461}"/>
              </a:ext>
            </a:extLst>
          </p:cNvPr>
          <p:cNvSpPr txBox="1"/>
          <p:nvPr/>
        </p:nvSpPr>
        <p:spPr>
          <a:xfrm>
            <a:off x="907863" y="462236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A264744-FE6F-4023-A16A-2CC53876CD40}"/>
              </a:ext>
            </a:extLst>
          </p:cNvPr>
          <p:cNvSpPr txBox="1"/>
          <p:nvPr/>
        </p:nvSpPr>
        <p:spPr>
          <a:xfrm>
            <a:off x="907863" y="491769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AC7958EA-4A5C-452F-85BD-2733C2FE3F89}"/>
              </a:ext>
            </a:extLst>
          </p:cNvPr>
          <p:cNvSpPr txBox="1"/>
          <p:nvPr/>
        </p:nvSpPr>
        <p:spPr>
          <a:xfrm>
            <a:off x="907863" y="52168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9A4BAD1D-0FDA-45DF-9E06-65C59B948BFD}"/>
              </a:ext>
            </a:extLst>
          </p:cNvPr>
          <p:cNvSpPr txBox="1"/>
          <p:nvPr/>
        </p:nvSpPr>
        <p:spPr>
          <a:xfrm>
            <a:off x="907863" y="566186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17FDF30D-4A51-407B-B5DD-A27751EA2A57}"/>
              </a:ext>
            </a:extLst>
          </p:cNvPr>
          <p:cNvGrpSpPr/>
          <p:nvPr/>
        </p:nvGrpSpPr>
        <p:grpSpPr>
          <a:xfrm>
            <a:off x="2131338" y="2113337"/>
            <a:ext cx="3561185" cy="791592"/>
            <a:chOff x="1866122" y="2287511"/>
            <a:chExt cx="3561185" cy="791592"/>
          </a:xfrm>
        </p:grpSpPr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993AD16E-4D86-4132-996B-2C803396206A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178F3FBD-56F0-4A56-B0C0-03BBE98B9B63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E101EA35-9C4A-4BF9-800B-38E867D06DD0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8A74A0BD-84C2-41DB-ABBB-84928F26941A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5C63AB5C-1F31-45E0-9303-A32EC3A8C243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1962EA96-ED1E-4231-9C80-70D49F7948C6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2A4ADBBB-9611-45FA-BA67-3307612FE976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013D37FC-C9B5-4579-AFDB-54B741B64941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FC3C1FE7-B024-4B75-947A-9C06FA0D8037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9CBED270-3704-49B6-BB12-31467082D669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F9365331-20EB-475F-954A-788A15B6C783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F1BB28BD-72AE-475D-8C8A-EEF0149A36BF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394D9393-1ACF-463F-8453-67E3012960B2}"/>
              </a:ext>
            </a:extLst>
          </p:cNvPr>
          <p:cNvGrpSpPr/>
          <p:nvPr/>
        </p:nvGrpSpPr>
        <p:grpSpPr>
          <a:xfrm>
            <a:off x="2153110" y="4186571"/>
            <a:ext cx="3561185" cy="791592"/>
            <a:chOff x="1866122" y="2287511"/>
            <a:chExt cx="3561185" cy="791592"/>
          </a:xfrm>
        </p:grpSpPr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9054AC88-FCD6-4A63-BB04-426ECEEF5C77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0CA37039-49B6-4422-8CAC-62AC054593A0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96E2EC55-8D1F-445C-AA6D-32B92499890A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DD2A59FB-698A-47C2-B2CA-FD2102EB93D3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F31502B-1437-495A-BD05-2F346DC6E770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0262855B-B045-4208-B157-CFA3A627ED06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DC015CDC-1B6F-4A19-B9E9-49FF10A97701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E693601B-5117-4BD1-B9C4-9DAC86832835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B39E2163-530B-4BD8-929F-2073DCEDA54C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B7A4AE7F-6058-4B18-9C35-4A8071FC6147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71C2D34C-66CB-4279-91ED-403017328499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2C11804-9ECC-41EB-8404-113F17C36C0F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6CDDA023-CC61-419C-90F0-17F44509810F}"/>
              </a:ext>
            </a:extLst>
          </p:cNvPr>
          <p:cNvGrpSpPr/>
          <p:nvPr/>
        </p:nvGrpSpPr>
        <p:grpSpPr>
          <a:xfrm>
            <a:off x="8904429" y="2287509"/>
            <a:ext cx="3561185" cy="791592"/>
            <a:chOff x="1866122" y="2287511"/>
            <a:chExt cx="3561185" cy="791592"/>
          </a:xfrm>
        </p:grpSpPr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A973DAB9-F6DF-4C23-8520-091EEAC25538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91CAE359-E0A4-4038-8A87-349DDF88126D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D665EAFC-57C6-43CB-9B91-AC66D73CAB92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BDCAAB8B-C37C-48AE-85BA-494289AF5D58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D9935762-1905-42B6-AF38-FB2FDD6E0421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1E45DDDB-5818-4586-B602-4409F1C27C68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1E3D1C6A-3A43-4B1E-9D34-9C25CFE5496F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91F3B066-911E-4527-9DCF-35A57202F576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34948482-019F-4EF6-802B-48C09843A2BA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9A4D68CD-32C0-4FD8-97FF-DE113DD82F43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BA182DF1-5DD8-44F8-AACC-482CBD4C0196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C5F7E2F8-6782-4E78-BDC0-4FF46C37B2E8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id="{1A95B907-7320-42A8-A343-E906545694EF}"/>
              </a:ext>
            </a:extLst>
          </p:cNvPr>
          <p:cNvGrpSpPr/>
          <p:nvPr/>
        </p:nvGrpSpPr>
        <p:grpSpPr>
          <a:xfrm>
            <a:off x="8871773" y="4415171"/>
            <a:ext cx="3561185" cy="791592"/>
            <a:chOff x="1866122" y="2287511"/>
            <a:chExt cx="3561185" cy="791592"/>
          </a:xfrm>
        </p:grpSpPr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39EA4700-16FA-4421-99A4-3142FBE9EBC3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E243D1A7-902D-4BF7-842B-2A1DC7F2A7F5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09ED43CF-226B-45E3-B6AD-7D6FF5F7DBF4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6D9F6288-A5B0-4FBA-94F7-E6D0235043D3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BBD29E9E-82AD-4E59-97AA-CA7CFDEE67F4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D6242E4A-B357-48C1-A0A8-AFC50E7F295F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15027E43-091F-40E8-9BCE-4F09CAFE54C2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FB0FDA6C-E786-485E-BE79-5BEE1EB31B8B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6C8595C8-E867-4E3D-BC62-B528FB44D2D4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A2C361E5-7BF5-4D7C-B654-CC41E5EEFA02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462FA4CA-25A7-4965-A8C2-6AA6EF9E6313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A56F19CD-29F4-4F66-B0CB-141DDC4114C0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801684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262A3989-276A-4D17-8A04-CE0729DC31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20340" y="2204764"/>
            <a:ext cx="4610371" cy="42638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51F7C1A-A312-4B90-A2D9-5433F6CB41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459" y="2369154"/>
            <a:ext cx="4630680" cy="4243536"/>
          </a:xfrm>
          <a:prstGeom prst="rect">
            <a:avLst/>
          </a:prstGeom>
        </p:spPr>
      </p:pic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193A05A-2407-4BFF-A0EF-39B247E1EF55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c-Jun (left) and c-Jun (right) for Fig. 1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E8C29B5-24CD-4F74-90E4-EEFA2D4AC98B}"/>
              </a:ext>
            </a:extLst>
          </p:cNvPr>
          <p:cNvSpPr txBox="1"/>
          <p:nvPr/>
        </p:nvSpPr>
        <p:spPr>
          <a:xfrm>
            <a:off x="1364777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c-Jun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A115AAA-837C-425B-A25F-610912ACF972}"/>
              </a:ext>
            </a:extLst>
          </p:cNvPr>
          <p:cNvSpPr txBox="1"/>
          <p:nvPr/>
        </p:nvSpPr>
        <p:spPr>
          <a:xfrm>
            <a:off x="8394008" y="1165184"/>
            <a:ext cx="46597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CCDE24D-7CA7-4F6B-AAB0-81D2D2A44672}"/>
              </a:ext>
            </a:extLst>
          </p:cNvPr>
          <p:cNvSpPr txBox="1"/>
          <p:nvPr/>
        </p:nvSpPr>
        <p:spPr>
          <a:xfrm>
            <a:off x="7667584" y="433434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8E21288-A68E-49A9-BEB6-F0D102E6CCA3}"/>
              </a:ext>
            </a:extLst>
          </p:cNvPr>
          <p:cNvSpPr txBox="1"/>
          <p:nvPr/>
        </p:nvSpPr>
        <p:spPr>
          <a:xfrm>
            <a:off x="7667584" y="448383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3E358CE-8BCC-438E-9425-858C6CBBFBB4}"/>
              </a:ext>
            </a:extLst>
          </p:cNvPr>
          <p:cNvSpPr txBox="1"/>
          <p:nvPr/>
        </p:nvSpPr>
        <p:spPr>
          <a:xfrm>
            <a:off x="7667584" y="464192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AFD0029-8E57-434C-8BB8-C9FE2EE93D69}"/>
              </a:ext>
            </a:extLst>
          </p:cNvPr>
          <p:cNvSpPr txBox="1"/>
          <p:nvPr/>
        </p:nvSpPr>
        <p:spPr>
          <a:xfrm>
            <a:off x="7667584" y="481522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8B854AD4-637E-42D4-A139-ADA85E8734B2}"/>
              </a:ext>
            </a:extLst>
          </p:cNvPr>
          <p:cNvSpPr txBox="1"/>
          <p:nvPr/>
        </p:nvSpPr>
        <p:spPr>
          <a:xfrm>
            <a:off x="7667584" y="511055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C3F8586-A4DC-4C20-B4E6-C8E4FF6E1F61}"/>
              </a:ext>
            </a:extLst>
          </p:cNvPr>
          <p:cNvSpPr txBox="1"/>
          <p:nvPr/>
        </p:nvSpPr>
        <p:spPr>
          <a:xfrm>
            <a:off x="7667584" y="540972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B994964-9795-449D-8920-037CF5B36CAF}"/>
              </a:ext>
            </a:extLst>
          </p:cNvPr>
          <p:cNvSpPr txBox="1"/>
          <p:nvPr/>
        </p:nvSpPr>
        <p:spPr>
          <a:xfrm>
            <a:off x="7667584" y="585472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FE48A0FC-65EA-4B16-A145-4359B463204B}"/>
              </a:ext>
            </a:extLst>
          </p:cNvPr>
          <p:cNvSpPr txBox="1"/>
          <p:nvPr/>
        </p:nvSpPr>
        <p:spPr>
          <a:xfrm>
            <a:off x="7630334" y="218550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9AC4509-5415-4B0E-80DC-C07F43FD6368}"/>
              </a:ext>
            </a:extLst>
          </p:cNvPr>
          <p:cNvSpPr txBox="1"/>
          <p:nvPr/>
        </p:nvSpPr>
        <p:spPr>
          <a:xfrm>
            <a:off x="7630334" y="233499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6A44E4B-BC7F-4418-9EC1-E5A81E88A7EF}"/>
              </a:ext>
            </a:extLst>
          </p:cNvPr>
          <p:cNvSpPr txBox="1"/>
          <p:nvPr/>
        </p:nvSpPr>
        <p:spPr>
          <a:xfrm>
            <a:off x="7630334" y="249308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4F6393DB-07A1-460D-B9CB-4BE5D57DBA5B}"/>
              </a:ext>
            </a:extLst>
          </p:cNvPr>
          <p:cNvSpPr txBox="1"/>
          <p:nvPr/>
        </p:nvSpPr>
        <p:spPr>
          <a:xfrm>
            <a:off x="7630334" y="266638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1DA1AF80-5957-49C8-9919-ED2EE8B6E6A4}"/>
              </a:ext>
            </a:extLst>
          </p:cNvPr>
          <p:cNvSpPr txBox="1"/>
          <p:nvPr/>
        </p:nvSpPr>
        <p:spPr>
          <a:xfrm>
            <a:off x="7630334" y="296171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4E51D774-C316-41EE-A705-5B15D700EBD4}"/>
              </a:ext>
            </a:extLst>
          </p:cNvPr>
          <p:cNvSpPr txBox="1"/>
          <p:nvPr/>
        </p:nvSpPr>
        <p:spPr>
          <a:xfrm>
            <a:off x="7630334" y="326088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08FB990-A77F-4975-80EB-E46C8380ABCB}"/>
              </a:ext>
            </a:extLst>
          </p:cNvPr>
          <p:cNvSpPr txBox="1"/>
          <p:nvPr/>
        </p:nvSpPr>
        <p:spPr>
          <a:xfrm>
            <a:off x="7630334" y="370588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5368DB26-5F93-41D5-AA75-22A7F61FDFB6}"/>
              </a:ext>
            </a:extLst>
          </p:cNvPr>
          <p:cNvSpPr txBox="1"/>
          <p:nvPr/>
        </p:nvSpPr>
        <p:spPr>
          <a:xfrm>
            <a:off x="653560" y="234287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E82A395E-AD0F-4B31-BA9B-DB6F5EF9AFD5}"/>
              </a:ext>
            </a:extLst>
          </p:cNvPr>
          <p:cNvSpPr txBox="1"/>
          <p:nvPr/>
        </p:nvSpPr>
        <p:spPr>
          <a:xfrm>
            <a:off x="653560" y="249236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511AB015-7C2E-4D2F-8EF3-CFB7A7F066FD}"/>
              </a:ext>
            </a:extLst>
          </p:cNvPr>
          <p:cNvSpPr txBox="1"/>
          <p:nvPr/>
        </p:nvSpPr>
        <p:spPr>
          <a:xfrm>
            <a:off x="653560" y="265045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4791E88-37BA-4A29-A179-06C25D49C83C}"/>
              </a:ext>
            </a:extLst>
          </p:cNvPr>
          <p:cNvSpPr txBox="1"/>
          <p:nvPr/>
        </p:nvSpPr>
        <p:spPr>
          <a:xfrm>
            <a:off x="653560" y="282375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FBB1B8EE-FD88-4D5C-9F38-609DE670D33F}"/>
              </a:ext>
            </a:extLst>
          </p:cNvPr>
          <p:cNvSpPr txBox="1"/>
          <p:nvPr/>
        </p:nvSpPr>
        <p:spPr>
          <a:xfrm>
            <a:off x="653560" y="311908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26A9BD-5394-4259-BAF6-3A7CE390F62F}"/>
              </a:ext>
            </a:extLst>
          </p:cNvPr>
          <p:cNvSpPr txBox="1"/>
          <p:nvPr/>
        </p:nvSpPr>
        <p:spPr>
          <a:xfrm>
            <a:off x="653560" y="341824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E4AC15A0-2323-428A-824F-D16AEAC8273A}"/>
              </a:ext>
            </a:extLst>
          </p:cNvPr>
          <p:cNvSpPr txBox="1"/>
          <p:nvPr/>
        </p:nvSpPr>
        <p:spPr>
          <a:xfrm>
            <a:off x="653560" y="38632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5E41C807-B900-4765-A500-E6144CD5CFD2}"/>
              </a:ext>
            </a:extLst>
          </p:cNvPr>
          <p:cNvSpPr txBox="1"/>
          <p:nvPr/>
        </p:nvSpPr>
        <p:spPr>
          <a:xfrm>
            <a:off x="650684" y="449153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4D4B820E-F8E9-4FC7-A568-9EE9D2B22839}"/>
              </a:ext>
            </a:extLst>
          </p:cNvPr>
          <p:cNvSpPr txBox="1"/>
          <p:nvPr/>
        </p:nvSpPr>
        <p:spPr>
          <a:xfrm>
            <a:off x="650684" y="464101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269DD461-C360-44A2-9F26-B0C75DD74348}"/>
              </a:ext>
            </a:extLst>
          </p:cNvPr>
          <p:cNvSpPr txBox="1"/>
          <p:nvPr/>
        </p:nvSpPr>
        <p:spPr>
          <a:xfrm>
            <a:off x="650684" y="479910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F1B9F560-C2D7-4418-A5F6-3CE41C8BF461}"/>
              </a:ext>
            </a:extLst>
          </p:cNvPr>
          <p:cNvSpPr txBox="1"/>
          <p:nvPr/>
        </p:nvSpPr>
        <p:spPr>
          <a:xfrm>
            <a:off x="650684" y="497240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A264744-FE6F-4023-A16A-2CC53876CD40}"/>
              </a:ext>
            </a:extLst>
          </p:cNvPr>
          <p:cNvSpPr txBox="1"/>
          <p:nvPr/>
        </p:nvSpPr>
        <p:spPr>
          <a:xfrm>
            <a:off x="650684" y="526773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AC7958EA-4A5C-452F-85BD-2733C2FE3F89}"/>
              </a:ext>
            </a:extLst>
          </p:cNvPr>
          <p:cNvSpPr txBox="1"/>
          <p:nvPr/>
        </p:nvSpPr>
        <p:spPr>
          <a:xfrm>
            <a:off x="650684" y="556690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9A4BAD1D-0FDA-45DF-9E06-65C59B948BFD}"/>
              </a:ext>
            </a:extLst>
          </p:cNvPr>
          <p:cNvSpPr txBox="1"/>
          <p:nvPr/>
        </p:nvSpPr>
        <p:spPr>
          <a:xfrm>
            <a:off x="650684" y="601191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17FDF30D-4A51-407B-B5DD-A27751EA2A57}"/>
              </a:ext>
            </a:extLst>
          </p:cNvPr>
          <p:cNvGrpSpPr/>
          <p:nvPr/>
        </p:nvGrpSpPr>
        <p:grpSpPr>
          <a:xfrm>
            <a:off x="1831301" y="2399087"/>
            <a:ext cx="3561185" cy="791592"/>
            <a:chOff x="1866122" y="2287511"/>
            <a:chExt cx="3561185" cy="791592"/>
          </a:xfrm>
        </p:grpSpPr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993AD16E-4D86-4132-996B-2C803396206A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178F3FBD-56F0-4A56-B0C0-03BBE98B9B63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E101EA35-9C4A-4BF9-800B-38E867D06DD0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8A74A0BD-84C2-41DB-ABBB-84928F26941A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5C63AB5C-1F31-45E0-9303-A32EC3A8C243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1962EA96-ED1E-4231-9C80-70D49F7948C6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2A4ADBBB-9611-45FA-BA67-3307612FE976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013D37FC-C9B5-4579-AFDB-54B741B64941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FC3C1FE7-B024-4B75-947A-9C06FA0D8037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9CBED270-3704-49B6-BB12-31467082D669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F9365331-20EB-475F-954A-788A15B6C783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F1BB28BD-72AE-475D-8C8A-EEF0149A36BF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394D9393-1ACF-463F-8453-67E3012960B2}"/>
              </a:ext>
            </a:extLst>
          </p:cNvPr>
          <p:cNvGrpSpPr/>
          <p:nvPr/>
        </p:nvGrpSpPr>
        <p:grpSpPr>
          <a:xfrm>
            <a:off x="1853073" y="4472321"/>
            <a:ext cx="3561185" cy="791592"/>
            <a:chOff x="1866122" y="2287511"/>
            <a:chExt cx="3561185" cy="791592"/>
          </a:xfrm>
        </p:grpSpPr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9054AC88-FCD6-4A63-BB04-426ECEEF5C77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0CA37039-49B6-4422-8CAC-62AC054593A0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96E2EC55-8D1F-445C-AA6D-32B92499890A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DD2A59FB-698A-47C2-B2CA-FD2102EB93D3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F31502B-1437-495A-BD05-2F346DC6E770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0262855B-B045-4208-B157-CFA3A627ED06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DC015CDC-1B6F-4A19-B9E9-49FF10A97701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E693601B-5117-4BD1-B9C4-9DAC86832835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B39E2163-530B-4BD8-929F-2073DCEDA54C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B7A4AE7F-6058-4B18-9C35-4A8071FC6147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71C2D34C-66CB-4279-91ED-403017328499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2C11804-9ECC-41EB-8404-113F17C36C0F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6CDDA023-CC61-419C-90F0-17F44509810F}"/>
              </a:ext>
            </a:extLst>
          </p:cNvPr>
          <p:cNvGrpSpPr/>
          <p:nvPr/>
        </p:nvGrpSpPr>
        <p:grpSpPr>
          <a:xfrm>
            <a:off x="8904429" y="2177781"/>
            <a:ext cx="3561185" cy="791592"/>
            <a:chOff x="1866122" y="2287511"/>
            <a:chExt cx="3561185" cy="791592"/>
          </a:xfrm>
        </p:grpSpPr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A973DAB9-F6DF-4C23-8520-091EEAC25538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91CAE359-E0A4-4038-8A87-349DDF88126D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D665EAFC-57C6-43CB-9B91-AC66D73CAB92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BDCAAB8B-C37C-48AE-85BA-494289AF5D58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D9935762-1905-42B6-AF38-FB2FDD6E0421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1E45DDDB-5818-4586-B602-4409F1C27C68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1E3D1C6A-3A43-4B1E-9D34-9C25CFE5496F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91F3B066-911E-4527-9DCF-35A57202F576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34948482-019F-4EF6-802B-48C09843A2BA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9A4D68CD-32C0-4FD8-97FF-DE113DD82F43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BA182DF1-5DD8-44F8-AACC-482CBD4C0196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C5F7E2F8-6782-4E78-BDC0-4FF46C37B2E8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id="{1A95B907-7320-42A8-A343-E906545694EF}"/>
              </a:ext>
            </a:extLst>
          </p:cNvPr>
          <p:cNvGrpSpPr/>
          <p:nvPr/>
        </p:nvGrpSpPr>
        <p:grpSpPr>
          <a:xfrm>
            <a:off x="8871773" y="4305443"/>
            <a:ext cx="3561185" cy="791592"/>
            <a:chOff x="1866122" y="2287511"/>
            <a:chExt cx="3561185" cy="791592"/>
          </a:xfrm>
        </p:grpSpPr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39EA4700-16FA-4421-99A4-3142FBE9EBC3}"/>
                </a:ext>
              </a:extLst>
            </p:cNvPr>
            <p:cNvCxnSpPr/>
            <p:nvPr/>
          </p:nvCxnSpPr>
          <p:spPr>
            <a:xfrm>
              <a:off x="186612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E243D1A7-902D-4BF7-842B-2A1DC7F2A7F5}"/>
                </a:ext>
              </a:extLst>
            </p:cNvPr>
            <p:cNvCxnSpPr/>
            <p:nvPr/>
          </p:nvCxnSpPr>
          <p:spPr>
            <a:xfrm>
              <a:off x="277430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09ED43CF-226B-45E3-B6AD-7D6FF5F7DBF4}"/>
                </a:ext>
              </a:extLst>
            </p:cNvPr>
            <p:cNvCxnSpPr/>
            <p:nvPr/>
          </p:nvCxnSpPr>
          <p:spPr>
            <a:xfrm>
              <a:off x="368248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6D9F6288-A5B0-4FBA-94F7-E6D0235043D3}"/>
                </a:ext>
              </a:extLst>
            </p:cNvPr>
            <p:cNvCxnSpPr/>
            <p:nvPr/>
          </p:nvCxnSpPr>
          <p:spPr>
            <a:xfrm>
              <a:off x="4590662" y="3079103"/>
              <a:ext cx="8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BBD29E9E-82AD-4E59-97AA-CA7CFDEE67F4}"/>
                </a:ext>
              </a:extLst>
            </p:cNvPr>
            <p:cNvSpPr txBox="1"/>
            <p:nvPr/>
          </p:nvSpPr>
          <p:spPr>
            <a:xfrm>
              <a:off x="194888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D6242E4A-B357-48C1-A0A8-AFC50E7F295F}"/>
                </a:ext>
              </a:extLst>
            </p:cNvPr>
            <p:cNvSpPr txBox="1"/>
            <p:nvPr/>
          </p:nvSpPr>
          <p:spPr>
            <a:xfrm>
              <a:off x="376524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15027E43-091F-40E8-9BCE-4F09CAFE54C2}"/>
                </a:ext>
              </a:extLst>
            </p:cNvPr>
            <p:cNvSpPr txBox="1"/>
            <p:nvPr/>
          </p:nvSpPr>
          <p:spPr>
            <a:xfrm>
              <a:off x="285706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FB0FDA6C-E786-485E-BE79-5BEE1EB31B8B}"/>
                </a:ext>
              </a:extLst>
            </p:cNvPr>
            <p:cNvSpPr txBox="1"/>
            <p:nvPr/>
          </p:nvSpPr>
          <p:spPr>
            <a:xfrm>
              <a:off x="4673425" y="270588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6C8595C8-E867-4E3D-BC62-B528FB44D2D4}"/>
                </a:ext>
              </a:extLst>
            </p:cNvPr>
            <p:cNvCxnSpPr>
              <a:cxnSpLocks/>
            </p:cNvCxnSpPr>
            <p:nvPr/>
          </p:nvCxnSpPr>
          <p:spPr>
            <a:xfrm>
              <a:off x="186612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A2C361E5-7BF5-4D7C-B654-CC41E5EEFA02}"/>
                </a:ext>
              </a:extLst>
            </p:cNvPr>
            <p:cNvCxnSpPr>
              <a:cxnSpLocks/>
            </p:cNvCxnSpPr>
            <p:nvPr/>
          </p:nvCxnSpPr>
          <p:spPr>
            <a:xfrm>
              <a:off x="3682482" y="2662335"/>
              <a:ext cx="1744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462FA4CA-25A7-4965-A8C2-6AA6EF9E6313}"/>
                </a:ext>
              </a:extLst>
            </p:cNvPr>
            <p:cNvSpPr txBox="1"/>
            <p:nvPr/>
          </p:nvSpPr>
          <p:spPr>
            <a:xfrm>
              <a:off x="240729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A56F19CD-29F4-4F66-B0CB-141DDC4114C0}"/>
                </a:ext>
              </a:extLst>
            </p:cNvPr>
            <p:cNvSpPr txBox="1"/>
            <p:nvPr/>
          </p:nvSpPr>
          <p:spPr>
            <a:xfrm>
              <a:off x="4223657" y="2287511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07360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21C69F4-45E7-48D4-9D18-D04AE1EFAB21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nuclear p65 (left) and YY1 (right) for Fig. 2B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2DB7304-8120-428E-B518-06532D5ED5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0209" y="3541117"/>
            <a:ext cx="5813738" cy="271566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D62A8476-CE5D-486E-8B24-9607AB2778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06396" y="3528427"/>
            <a:ext cx="5813738" cy="274104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F59B41-13C4-4A05-8E6C-DC0F25E9069E}"/>
              </a:ext>
            </a:extLst>
          </p:cNvPr>
          <p:cNvSpPr txBox="1"/>
          <p:nvPr/>
        </p:nvSpPr>
        <p:spPr>
          <a:xfrm>
            <a:off x="1889841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nuclear 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FB08ED-83F8-46FB-96DE-7C436904E265}"/>
              </a:ext>
            </a:extLst>
          </p:cNvPr>
          <p:cNvSpPr txBox="1"/>
          <p:nvPr/>
        </p:nvSpPr>
        <p:spPr>
          <a:xfrm>
            <a:off x="8906028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nuclear YY1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BC4EB8-74B3-49D1-8E27-FC4B081A46B2}"/>
              </a:ext>
            </a:extLst>
          </p:cNvPr>
          <p:cNvSpPr txBox="1"/>
          <p:nvPr/>
        </p:nvSpPr>
        <p:spPr>
          <a:xfrm>
            <a:off x="281833" y="36193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EC53B19-0D1F-4EDC-AE3B-7FC18C7D8310}"/>
              </a:ext>
            </a:extLst>
          </p:cNvPr>
          <p:cNvSpPr txBox="1"/>
          <p:nvPr/>
        </p:nvSpPr>
        <p:spPr>
          <a:xfrm>
            <a:off x="281833" y="378409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794A88B-9324-4B37-88A4-D1ABCB091DF9}"/>
              </a:ext>
            </a:extLst>
          </p:cNvPr>
          <p:cNvSpPr txBox="1"/>
          <p:nvPr/>
        </p:nvSpPr>
        <p:spPr>
          <a:xfrm>
            <a:off x="281833" y="397739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57E197B-651D-4176-8DD6-E8B6408330D6}"/>
              </a:ext>
            </a:extLst>
          </p:cNvPr>
          <p:cNvSpPr txBox="1"/>
          <p:nvPr/>
        </p:nvSpPr>
        <p:spPr>
          <a:xfrm>
            <a:off x="281833" y="41728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46A1CCE-996C-4241-9FD1-939CBEE36236}"/>
              </a:ext>
            </a:extLst>
          </p:cNvPr>
          <p:cNvSpPr txBox="1"/>
          <p:nvPr/>
        </p:nvSpPr>
        <p:spPr>
          <a:xfrm>
            <a:off x="281833" y="453291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AC7A0AB-9331-4B55-B11D-2E687A2F0E06}"/>
              </a:ext>
            </a:extLst>
          </p:cNvPr>
          <p:cNvSpPr txBox="1"/>
          <p:nvPr/>
        </p:nvSpPr>
        <p:spPr>
          <a:xfrm>
            <a:off x="281833" y="489856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3BD80F4-1DC0-44E2-93D6-14C043D96118}"/>
              </a:ext>
            </a:extLst>
          </p:cNvPr>
          <p:cNvSpPr txBox="1"/>
          <p:nvPr/>
        </p:nvSpPr>
        <p:spPr>
          <a:xfrm>
            <a:off x="281833" y="545151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EB24EA65-12B6-4329-BF61-BCBF3CFE8C4A}"/>
              </a:ext>
            </a:extLst>
          </p:cNvPr>
          <p:cNvGrpSpPr/>
          <p:nvPr/>
        </p:nvGrpSpPr>
        <p:grpSpPr>
          <a:xfrm>
            <a:off x="1749860" y="4748587"/>
            <a:ext cx="667746" cy="396482"/>
            <a:chOff x="1688536" y="4910820"/>
            <a:chExt cx="667746" cy="396482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FF08F47B-875C-4E99-97FD-C7899EB722DC}"/>
                </a:ext>
              </a:extLst>
            </p:cNvPr>
            <p:cNvCxnSpPr>
              <a:cxnSpLocks/>
            </p:cNvCxnSpPr>
            <p:nvPr/>
          </p:nvCxnSpPr>
          <p:spPr>
            <a:xfrm>
              <a:off x="1688536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232F5873-B9DE-4D59-93CB-B16C4B385CDA}"/>
                </a:ext>
              </a:extLst>
            </p:cNvPr>
            <p:cNvSpPr txBox="1"/>
            <p:nvPr/>
          </p:nvSpPr>
          <p:spPr>
            <a:xfrm>
              <a:off x="169380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8C7EC2A9-08D7-4BC6-BCD1-B904887C179E}"/>
              </a:ext>
            </a:extLst>
          </p:cNvPr>
          <p:cNvGrpSpPr/>
          <p:nvPr/>
        </p:nvGrpSpPr>
        <p:grpSpPr>
          <a:xfrm>
            <a:off x="2494176" y="4748587"/>
            <a:ext cx="662474" cy="396482"/>
            <a:chOff x="2454753" y="4910820"/>
            <a:chExt cx="662474" cy="396482"/>
          </a:xfrm>
        </p:grpSpPr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0BEDCBF8-72F1-4A55-AFF7-AE90AD9A04CA}"/>
                </a:ext>
              </a:extLst>
            </p:cNvPr>
            <p:cNvSpPr txBox="1"/>
            <p:nvPr/>
          </p:nvSpPr>
          <p:spPr>
            <a:xfrm>
              <a:off x="2454753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7461213A-AE95-4520-8767-86A4DE4F1072}"/>
                </a:ext>
              </a:extLst>
            </p:cNvPr>
            <p:cNvCxnSpPr>
              <a:cxnSpLocks/>
            </p:cNvCxnSpPr>
            <p:nvPr/>
          </p:nvCxnSpPr>
          <p:spPr>
            <a:xfrm>
              <a:off x="2460868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79584837-1F7F-4620-BDAA-60D8EEEF16BA}"/>
              </a:ext>
            </a:extLst>
          </p:cNvPr>
          <p:cNvGrpSpPr/>
          <p:nvPr/>
        </p:nvGrpSpPr>
        <p:grpSpPr>
          <a:xfrm>
            <a:off x="3233220" y="4748587"/>
            <a:ext cx="662474" cy="396482"/>
            <a:chOff x="3223448" y="4910820"/>
            <a:chExt cx="662474" cy="396482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B52B693-C5D6-4A01-9573-480017A7F2C0}"/>
                </a:ext>
              </a:extLst>
            </p:cNvPr>
            <p:cNvSpPr txBox="1"/>
            <p:nvPr/>
          </p:nvSpPr>
          <p:spPr>
            <a:xfrm>
              <a:off x="322344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3CC1E53E-1E38-4E68-B3E7-9C624E0B2C7F}"/>
                </a:ext>
              </a:extLst>
            </p:cNvPr>
            <p:cNvCxnSpPr>
              <a:cxnSpLocks/>
            </p:cNvCxnSpPr>
            <p:nvPr/>
          </p:nvCxnSpPr>
          <p:spPr>
            <a:xfrm>
              <a:off x="3233200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2BA780D7-6BB7-4AD5-B3BD-D81CA7C6448E}"/>
              </a:ext>
            </a:extLst>
          </p:cNvPr>
          <p:cNvGrpSpPr/>
          <p:nvPr/>
        </p:nvGrpSpPr>
        <p:grpSpPr>
          <a:xfrm>
            <a:off x="3972264" y="4748587"/>
            <a:ext cx="667746" cy="396482"/>
            <a:chOff x="3979703" y="4910820"/>
            <a:chExt cx="667746" cy="396482"/>
          </a:xfrm>
        </p:grpSpPr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D80FD4FE-EB68-4364-B1AE-BE0B87ADA857}"/>
                </a:ext>
              </a:extLst>
            </p:cNvPr>
            <p:cNvCxnSpPr>
              <a:cxnSpLocks/>
            </p:cNvCxnSpPr>
            <p:nvPr/>
          </p:nvCxnSpPr>
          <p:spPr>
            <a:xfrm>
              <a:off x="3979703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0E672EC4-5EF5-430A-986F-71DC92F53D59}"/>
                </a:ext>
              </a:extLst>
            </p:cNvPr>
            <p:cNvSpPr txBox="1"/>
            <p:nvPr/>
          </p:nvSpPr>
          <p:spPr>
            <a:xfrm>
              <a:off x="398497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4E07CAF4-7007-45F2-9ECA-6C759FAAFCF2}"/>
              </a:ext>
            </a:extLst>
          </p:cNvPr>
          <p:cNvGrpSpPr/>
          <p:nvPr/>
        </p:nvGrpSpPr>
        <p:grpSpPr>
          <a:xfrm>
            <a:off x="4716580" y="4748587"/>
            <a:ext cx="662474" cy="396482"/>
            <a:chOff x="4745920" y="4910820"/>
            <a:chExt cx="662474" cy="396482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7C614F21-6663-4CAD-8EFF-6777FB5ECA9B}"/>
                </a:ext>
              </a:extLst>
            </p:cNvPr>
            <p:cNvSpPr txBox="1"/>
            <p:nvPr/>
          </p:nvSpPr>
          <p:spPr>
            <a:xfrm>
              <a:off x="4745920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9A17F1E8-496B-4131-B646-77C8B655A793}"/>
                </a:ext>
              </a:extLst>
            </p:cNvPr>
            <p:cNvCxnSpPr>
              <a:cxnSpLocks/>
            </p:cNvCxnSpPr>
            <p:nvPr/>
          </p:nvCxnSpPr>
          <p:spPr>
            <a:xfrm>
              <a:off x="4752035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7C55E7A5-6323-4096-9862-AC9BCEE280A5}"/>
              </a:ext>
            </a:extLst>
          </p:cNvPr>
          <p:cNvGrpSpPr/>
          <p:nvPr/>
        </p:nvGrpSpPr>
        <p:grpSpPr>
          <a:xfrm>
            <a:off x="5455623" y="4748587"/>
            <a:ext cx="662474" cy="396482"/>
            <a:chOff x="5514615" y="4910820"/>
            <a:chExt cx="662474" cy="396482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EBC8571-A47C-4CC5-B0C1-D9779F29414C}"/>
                </a:ext>
              </a:extLst>
            </p:cNvPr>
            <p:cNvSpPr txBox="1"/>
            <p:nvPr/>
          </p:nvSpPr>
          <p:spPr>
            <a:xfrm>
              <a:off x="551461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7D783586-0857-4311-98A5-8648EEC68FD1}"/>
                </a:ext>
              </a:extLst>
            </p:cNvPr>
            <p:cNvCxnSpPr>
              <a:cxnSpLocks/>
            </p:cNvCxnSpPr>
            <p:nvPr/>
          </p:nvCxnSpPr>
          <p:spPr>
            <a:xfrm>
              <a:off x="5524367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629DCD2-AB48-4AD3-A470-4E3556D873BB}"/>
              </a:ext>
            </a:extLst>
          </p:cNvPr>
          <p:cNvSpPr txBox="1"/>
          <p:nvPr/>
        </p:nvSpPr>
        <p:spPr>
          <a:xfrm>
            <a:off x="1703423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D66BE46-57E9-4B83-8FBB-26317F2C30EB}"/>
              </a:ext>
            </a:extLst>
          </p:cNvPr>
          <p:cNvSpPr txBox="1"/>
          <p:nvPr/>
        </p:nvSpPr>
        <p:spPr>
          <a:xfrm>
            <a:off x="2072997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808EC03-703E-4CA1-9B2A-AC5D9D7F0DDE}"/>
              </a:ext>
            </a:extLst>
          </p:cNvPr>
          <p:cNvSpPr txBox="1"/>
          <p:nvPr/>
        </p:nvSpPr>
        <p:spPr>
          <a:xfrm>
            <a:off x="2442571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72E2C79-BD5B-476E-8546-D436164A28ED}"/>
              </a:ext>
            </a:extLst>
          </p:cNvPr>
          <p:cNvSpPr txBox="1"/>
          <p:nvPr/>
        </p:nvSpPr>
        <p:spPr>
          <a:xfrm>
            <a:off x="2812145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5043875-B528-4B1A-99C1-FF7742CFED0B}"/>
              </a:ext>
            </a:extLst>
          </p:cNvPr>
          <p:cNvSpPr txBox="1"/>
          <p:nvPr/>
        </p:nvSpPr>
        <p:spPr>
          <a:xfrm>
            <a:off x="3181719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BC2839C-E919-4031-92C9-84ED83CBBA50}"/>
              </a:ext>
            </a:extLst>
          </p:cNvPr>
          <p:cNvSpPr txBox="1"/>
          <p:nvPr/>
        </p:nvSpPr>
        <p:spPr>
          <a:xfrm>
            <a:off x="3551293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BCE0152-8908-4E16-BDE9-2F07EBE147FE}"/>
              </a:ext>
            </a:extLst>
          </p:cNvPr>
          <p:cNvSpPr txBox="1"/>
          <p:nvPr/>
        </p:nvSpPr>
        <p:spPr>
          <a:xfrm>
            <a:off x="3920867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EE6FED4-BA88-4189-B08A-8FECF6F4C339}"/>
              </a:ext>
            </a:extLst>
          </p:cNvPr>
          <p:cNvSpPr txBox="1"/>
          <p:nvPr/>
        </p:nvSpPr>
        <p:spPr>
          <a:xfrm>
            <a:off x="4290441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833B3D5-6896-49C0-8847-12ED53A37B1A}"/>
              </a:ext>
            </a:extLst>
          </p:cNvPr>
          <p:cNvSpPr txBox="1"/>
          <p:nvPr/>
        </p:nvSpPr>
        <p:spPr>
          <a:xfrm>
            <a:off x="4660015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E63273-2525-42DB-B2C2-A87D3E764CE1}"/>
              </a:ext>
            </a:extLst>
          </p:cNvPr>
          <p:cNvSpPr txBox="1"/>
          <p:nvPr/>
        </p:nvSpPr>
        <p:spPr>
          <a:xfrm>
            <a:off x="5029589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4572C79-8E4D-41BF-93C5-51CB16B8711F}"/>
              </a:ext>
            </a:extLst>
          </p:cNvPr>
          <p:cNvSpPr txBox="1"/>
          <p:nvPr/>
        </p:nvSpPr>
        <p:spPr>
          <a:xfrm>
            <a:off x="5399163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0CC4E1D-74D6-48DC-A604-15785E2F07D1}"/>
              </a:ext>
            </a:extLst>
          </p:cNvPr>
          <p:cNvSpPr txBox="1"/>
          <p:nvPr/>
        </p:nvSpPr>
        <p:spPr>
          <a:xfrm>
            <a:off x="5768732" y="39365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D761283-25A3-4596-A1F1-DE2F23E9D594}"/>
              </a:ext>
            </a:extLst>
          </p:cNvPr>
          <p:cNvSpPr txBox="1"/>
          <p:nvPr/>
        </p:nvSpPr>
        <p:spPr>
          <a:xfrm>
            <a:off x="3099455" y="3550556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AY 11-708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90697338-6B1B-4289-9623-A28B1DC54057}"/>
              </a:ext>
            </a:extLst>
          </p:cNvPr>
          <p:cNvCxnSpPr>
            <a:cxnSpLocks/>
          </p:cNvCxnSpPr>
          <p:nvPr/>
        </p:nvCxnSpPr>
        <p:spPr>
          <a:xfrm>
            <a:off x="1701734" y="3949611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7AC7AE0-9B05-46FD-AD45-392CBD3B5640}"/>
              </a:ext>
            </a:extLst>
          </p:cNvPr>
          <p:cNvSpPr txBox="1"/>
          <p:nvPr/>
        </p:nvSpPr>
        <p:spPr>
          <a:xfrm>
            <a:off x="281833" y="574027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397BC19-DD6F-4BA8-BC2B-ABDF78D7A03E}"/>
              </a:ext>
            </a:extLst>
          </p:cNvPr>
          <p:cNvSpPr txBox="1"/>
          <p:nvPr/>
        </p:nvSpPr>
        <p:spPr>
          <a:xfrm>
            <a:off x="7300766" y="36113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3F1B442-5B79-4DF0-8FED-21AB70D65704}"/>
              </a:ext>
            </a:extLst>
          </p:cNvPr>
          <p:cNvSpPr txBox="1"/>
          <p:nvPr/>
        </p:nvSpPr>
        <p:spPr>
          <a:xfrm>
            <a:off x="7300766" y="377607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ECD9541-96A6-4CC6-9B73-59EDABE44E03}"/>
              </a:ext>
            </a:extLst>
          </p:cNvPr>
          <p:cNvSpPr txBox="1"/>
          <p:nvPr/>
        </p:nvSpPr>
        <p:spPr>
          <a:xfrm>
            <a:off x="7300766" y="396937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A6EE7EC-5660-4A2F-B9CF-70E72E360679}"/>
              </a:ext>
            </a:extLst>
          </p:cNvPr>
          <p:cNvSpPr txBox="1"/>
          <p:nvPr/>
        </p:nvSpPr>
        <p:spPr>
          <a:xfrm>
            <a:off x="7300766" y="41648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604E020F-8B52-4A64-9716-1999B87ABE45}"/>
              </a:ext>
            </a:extLst>
          </p:cNvPr>
          <p:cNvSpPr txBox="1"/>
          <p:nvPr/>
        </p:nvSpPr>
        <p:spPr>
          <a:xfrm>
            <a:off x="7300766" y="452489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B0D6796-792C-431F-9C9D-D86CB900BFCC}"/>
              </a:ext>
            </a:extLst>
          </p:cNvPr>
          <p:cNvSpPr txBox="1"/>
          <p:nvPr/>
        </p:nvSpPr>
        <p:spPr>
          <a:xfrm>
            <a:off x="7300766" y="489054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7EF2978-F4CB-4778-B38E-A40F720E209C}"/>
              </a:ext>
            </a:extLst>
          </p:cNvPr>
          <p:cNvSpPr txBox="1"/>
          <p:nvPr/>
        </p:nvSpPr>
        <p:spPr>
          <a:xfrm>
            <a:off x="7300766" y="544349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A4B351B-BE52-4E9D-8B85-A2EC56867D52}"/>
              </a:ext>
            </a:extLst>
          </p:cNvPr>
          <p:cNvSpPr txBox="1"/>
          <p:nvPr/>
        </p:nvSpPr>
        <p:spPr>
          <a:xfrm>
            <a:off x="7300766" y="573225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34A6E20B-FDAA-44B4-8527-59536DF117AB}"/>
              </a:ext>
            </a:extLst>
          </p:cNvPr>
          <p:cNvGrpSpPr/>
          <p:nvPr/>
        </p:nvGrpSpPr>
        <p:grpSpPr>
          <a:xfrm>
            <a:off x="8711263" y="4816905"/>
            <a:ext cx="667746" cy="396482"/>
            <a:chOff x="1688536" y="4910820"/>
            <a:chExt cx="667746" cy="396482"/>
          </a:xfrm>
        </p:grpSpPr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9077C7E3-9BE1-4769-9E4E-7C66EA64FF65}"/>
                </a:ext>
              </a:extLst>
            </p:cNvPr>
            <p:cNvCxnSpPr>
              <a:cxnSpLocks/>
            </p:cNvCxnSpPr>
            <p:nvPr/>
          </p:nvCxnSpPr>
          <p:spPr>
            <a:xfrm>
              <a:off x="1688536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81481B48-229E-4431-B72F-C48C396089B4}"/>
                </a:ext>
              </a:extLst>
            </p:cNvPr>
            <p:cNvSpPr txBox="1"/>
            <p:nvPr/>
          </p:nvSpPr>
          <p:spPr>
            <a:xfrm>
              <a:off x="169380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A18766AE-FFFD-4CE5-9FF2-B687CD0DAF2E}"/>
              </a:ext>
            </a:extLst>
          </p:cNvPr>
          <p:cNvGrpSpPr/>
          <p:nvPr/>
        </p:nvGrpSpPr>
        <p:grpSpPr>
          <a:xfrm>
            <a:off x="9455579" y="4816905"/>
            <a:ext cx="662474" cy="396482"/>
            <a:chOff x="2454753" y="4910820"/>
            <a:chExt cx="662474" cy="396482"/>
          </a:xfrm>
        </p:grpSpPr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36357D7F-577A-4890-BFBF-D3C969FDADBB}"/>
                </a:ext>
              </a:extLst>
            </p:cNvPr>
            <p:cNvSpPr txBox="1"/>
            <p:nvPr/>
          </p:nvSpPr>
          <p:spPr>
            <a:xfrm>
              <a:off x="2454753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308796BD-7076-471D-92ED-9E54A0EE33FA}"/>
                </a:ext>
              </a:extLst>
            </p:cNvPr>
            <p:cNvCxnSpPr>
              <a:cxnSpLocks/>
            </p:cNvCxnSpPr>
            <p:nvPr/>
          </p:nvCxnSpPr>
          <p:spPr>
            <a:xfrm>
              <a:off x="2460868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0614DDA4-9AA0-426C-B003-ADB28137E696}"/>
              </a:ext>
            </a:extLst>
          </p:cNvPr>
          <p:cNvGrpSpPr/>
          <p:nvPr/>
        </p:nvGrpSpPr>
        <p:grpSpPr>
          <a:xfrm>
            <a:off x="10194623" y="4816905"/>
            <a:ext cx="662474" cy="396482"/>
            <a:chOff x="3223448" y="4910820"/>
            <a:chExt cx="662474" cy="396482"/>
          </a:xfrm>
        </p:grpSpPr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BC113549-E90B-4CD7-AE0B-D5EB9BE8753F}"/>
                </a:ext>
              </a:extLst>
            </p:cNvPr>
            <p:cNvSpPr txBox="1"/>
            <p:nvPr/>
          </p:nvSpPr>
          <p:spPr>
            <a:xfrm>
              <a:off x="322344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70DE8E59-03EF-4663-B6EC-1DD7BB690A0E}"/>
                </a:ext>
              </a:extLst>
            </p:cNvPr>
            <p:cNvCxnSpPr>
              <a:cxnSpLocks/>
            </p:cNvCxnSpPr>
            <p:nvPr/>
          </p:nvCxnSpPr>
          <p:spPr>
            <a:xfrm>
              <a:off x="3233200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B191A25B-6BB5-4E3D-87E5-277562542B94}"/>
              </a:ext>
            </a:extLst>
          </p:cNvPr>
          <p:cNvGrpSpPr/>
          <p:nvPr/>
        </p:nvGrpSpPr>
        <p:grpSpPr>
          <a:xfrm>
            <a:off x="10933667" y="4816905"/>
            <a:ext cx="667746" cy="396482"/>
            <a:chOff x="3979703" y="4910820"/>
            <a:chExt cx="667746" cy="396482"/>
          </a:xfrm>
        </p:grpSpPr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E1F06751-CC5A-4E5E-85C7-92972EF68EA6}"/>
                </a:ext>
              </a:extLst>
            </p:cNvPr>
            <p:cNvCxnSpPr>
              <a:cxnSpLocks/>
            </p:cNvCxnSpPr>
            <p:nvPr/>
          </p:nvCxnSpPr>
          <p:spPr>
            <a:xfrm>
              <a:off x="3979703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9F49D645-9AFC-4B33-865F-F24D367B2A82}"/>
                </a:ext>
              </a:extLst>
            </p:cNvPr>
            <p:cNvSpPr txBox="1"/>
            <p:nvPr/>
          </p:nvSpPr>
          <p:spPr>
            <a:xfrm>
              <a:off x="398497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2F1C90DD-B92E-4092-976D-E058ECEB317F}"/>
              </a:ext>
            </a:extLst>
          </p:cNvPr>
          <p:cNvGrpSpPr/>
          <p:nvPr/>
        </p:nvGrpSpPr>
        <p:grpSpPr>
          <a:xfrm>
            <a:off x="11677983" y="4816905"/>
            <a:ext cx="662474" cy="396482"/>
            <a:chOff x="4745920" y="4910820"/>
            <a:chExt cx="662474" cy="396482"/>
          </a:xfrm>
        </p:grpSpPr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83D34323-B087-44F0-B494-1B32FD77381C}"/>
                </a:ext>
              </a:extLst>
            </p:cNvPr>
            <p:cNvSpPr txBox="1"/>
            <p:nvPr/>
          </p:nvSpPr>
          <p:spPr>
            <a:xfrm>
              <a:off x="4745920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6B003B59-AC00-4898-BB35-4CD4911732A4}"/>
                </a:ext>
              </a:extLst>
            </p:cNvPr>
            <p:cNvCxnSpPr>
              <a:cxnSpLocks/>
            </p:cNvCxnSpPr>
            <p:nvPr/>
          </p:nvCxnSpPr>
          <p:spPr>
            <a:xfrm>
              <a:off x="4752035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A4F0C825-6BA1-4BF8-B9D5-CF383303AFFB}"/>
              </a:ext>
            </a:extLst>
          </p:cNvPr>
          <p:cNvGrpSpPr/>
          <p:nvPr/>
        </p:nvGrpSpPr>
        <p:grpSpPr>
          <a:xfrm>
            <a:off x="12417026" y="4816905"/>
            <a:ext cx="662474" cy="396482"/>
            <a:chOff x="5514615" y="4910820"/>
            <a:chExt cx="662474" cy="396482"/>
          </a:xfrm>
        </p:grpSpPr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DFBE9526-8E95-4E21-A73D-0D66E2A2DADF}"/>
                </a:ext>
              </a:extLst>
            </p:cNvPr>
            <p:cNvSpPr txBox="1"/>
            <p:nvPr/>
          </p:nvSpPr>
          <p:spPr>
            <a:xfrm>
              <a:off x="551461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790F7792-A98A-4EA0-A753-F86EC99029C3}"/>
                </a:ext>
              </a:extLst>
            </p:cNvPr>
            <p:cNvCxnSpPr>
              <a:cxnSpLocks/>
            </p:cNvCxnSpPr>
            <p:nvPr/>
          </p:nvCxnSpPr>
          <p:spPr>
            <a:xfrm>
              <a:off x="5524367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04B9E894-387C-4918-9147-BF754EFC1BA8}"/>
              </a:ext>
            </a:extLst>
          </p:cNvPr>
          <p:cNvSpPr txBox="1"/>
          <p:nvPr/>
        </p:nvSpPr>
        <p:spPr>
          <a:xfrm>
            <a:off x="8664826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114CCAE-E7E9-4DB6-BB53-F012CA8D8AF8}"/>
              </a:ext>
            </a:extLst>
          </p:cNvPr>
          <p:cNvSpPr txBox="1"/>
          <p:nvPr/>
        </p:nvSpPr>
        <p:spPr>
          <a:xfrm>
            <a:off x="9034400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95B03DA4-4513-4C47-A42A-FE090AFC9C04}"/>
              </a:ext>
            </a:extLst>
          </p:cNvPr>
          <p:cNvSpPr txBox="1"/>
          <p:nvPr/>
        </p:nvSpPr>
        <p:spPr>
          <a:xfrm>
            <a:off x="9403974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42A4EB5F-9830-4785-A070-2C43766E38F6}"/>
              </a:ext>
            </a:extLst>
          </p:cNvPr>
          <p:cNvSpPr txBox="1"/>
          <p:nvPr/>
        </p:nvSpPr>
        <p:spPr>
          <a:xfrm>
            <a:off x="9773548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D28D3FAD-F56B-40FE-B643-92204B090E79}"/>
              </a:ext>
            </a:extLst>
          </p:cNvPr>
          <p:cNvSpPr txBox="1"/>
          <p:nvPr/>
        </p:nvSpPr>
        <p:spPr>
          <a:xfrm>
            <a:off x="10143122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0EF9C61F-418A-4732-AA89-C499AC5CFFC5}"/>
              </a:ext>
            </a:extLst>
          </p:cNvPr>
          <p:cNvSpPr txBox="1"/>
          <p:nvPr/>
        </p:nvSpPr>
        <p:spPr>
          <a:xfrm>
            <a:off x="10512696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14BB44F-67B9-47F6-8869-AFA671A162B7}"/>
              </a:ext>
            </a:extLst>
          </p:cNvPr>
          <p:cNvSpPr txBox="1"/>
          <p:nvPr/>
        </p:nvSpPr>
        <p:spPr>
          <a:xfrm>
            <a:off x="10882270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5E44051B-68C3-42DC-916A-3B64282DE7B0}"/>
              </a:ext>
            </a:extLst>
          </p:cNvPr>
          <p:cNvSpPr txBox="1"/>
          <p:nvPr/>
        </p:nvSpPr>
        <p:spPr>
          <a:xfrm>
            <a:off x="11251844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3DA1451-F4B0-4581-A5A0-1DAC09D56A38}"/>
              </a:ext>
            </a:extLst>
          </p:cNvPr>
          <p:cNvSpPr txBox="1"/>
          <p:nvPr/>
        </p:nvSpPr>
        <p:spPr>
          <a:xfrm>
            <a:off x="11621418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D4D616B-B565-4655-BE7F-F7FE30BC933F}"/>
              </a:ext>
            </a:extLst>
          </p:cNvPr>
          <p:cNvSpPr txBox="1"/>
          <p:nvPr/>
        </p:nvSpPr>
        <p:spPr>
          <a:xfrm>
            <a:off x="11990992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9CB66DB-23F4-4DDE-8165-92721174DA09}"/>
              </a:ext>
            </a:extLst>
          </p:cNvPr>
          <p:cNvSpPr txBox="1"/>
          <p:nvPr/>
        </p:nvSpPr>
        <p:spPr>
          <a:xfrm>
            <a:off x="12360566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EE3498F-1AA8-4479-AA8B-3041F519BB78}"/>
              </a:ext>
            </a:extLst>
          </p:cNvPr>
          <p:cNvSpPr txBox="1"/>
          <p:nvPr/>
        </p:nvSpPr>
        <p:spPr>
          <a:xfrm>
            <a:off x="12730135" y="400490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DCA83C1E-F13E-47D7-BD36-D289299DA5FF}"/>
              </a:ext>
            </a:extLst>
          </p:cNvPr>
          <p:cNvSpPr txBox="1"/>
          <p:nvPr/>
        </p:nvSpPr>
        <p:spPr>
          <a:xfrm>
            <a:off x="10060858" y="3618874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AY 11-708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F918C40F-8524-483F-B48B-632A1473273D}"/>
              </a:ext>
            </a:extLst>
          </p:cNvPr>
          <p:cNvCxnSpPr>
            <a:cxnSpLocks/>
          </p:cNvCxnSpPr>
          <p:nvPr/>
        </p:nvCxnSpPr>
        <p:spPr>
          <a:xfrm>
            <a:off x="8663137" y="4017929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294740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506B23E-0390-483E-9CFC-6432717B84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8056" y="3381211"/>
            <a:ext cx="5864514" cy="319788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A3D0B059-5E32-48EE-A818-35E3D32BB1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7738" y="3444031"/>
            <a:ext cx="5737576" cy="286794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21C69F4-45E7-48D4-9D18-D04AE1EFAB21}"/>
              </a:ext>
            </a:extLst>
          </p:cNvPr>
          <p:cNvSpPr txBox="1"/>
          <p:nvPr/>
        </p:nvSpPr>
        <p:spPr>
          <a:xfrm>
            <a:off x="1784555" y="8060354"/>
            <a:ext cx="123412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cytosolic p65 (left) and GAPDH (right) for Fig. 2B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F59B41-13C4-4A05-8E6C-DC0F25E9069E}"/>
              </a:ext>
            </a:extLst>
          </p:cNvPr>
          <p:cNvSpPr txBox="1"/>
          <p:nvPr/>
        </p:nvSpPr>
        <p:spPr>
          <a:xfrm>
            <a:off x="1889841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cytosolic 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FB08ED-83F8-46FB-96DE-7C436904E265}"/>
              </a:ext>
            </a:extLst>
          </p:cNvPr>
          <p:cNvSpPr txBox="1"/>
          <p:nvPr/>
        </p:nvSpPr>
        <p:spPr>
          <a:xfrm>
            <a:off x="8450827" y="2262464"/>
            <a:ext cx="472487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cytosolic GAPDH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BC4EB8-74B3-49D1-8E27-FC4B081A46B2}"/>
              </a:ext>
            </a:extLst>
          </p:cNvPr>
          <p:cNvSpPr txBox="1"/>
          <p:nvPr/>
        </p:nvSpPr>
        <p:spPr>
          <a:xfrm>
            <a:off x="352953" y="35685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EC53B19-0D1F-4EDC-AE3B-7FC18C7D8310}"/>
              </a:ext>
            </a:extLst>
          </p:cNvPr>
          <p:cNvSpPr txBox="1"/>
          <p:nvPr/>
        </p:nvSpPr>
        <p:spPr>
          <a:xfrm>
            <a:off x="352953" y="373329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794A88B-9324-4B37-88A4-D1ABCB091DF9}"/>
              </a:ext>
            </a:extLst>
          </p:cNvPr>
          <p:cNvSpPr txBox="1"/>
          <p:nvPr/>
        </p:nvSpPr>
        <p:spPr>
          <a:xfrm>
            <a:off x="352953" y="391643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57E197B-651D-4176-8DD6-E8B6408330D6}"/>
              </a:ext>
            </a:extLst>
          </p:cNvPr>
          <p:cNvSpPr txBox="1"/>
          <p:nvPr/>
        </p:nvSpPr>
        <p:spPr>
          <a:xfrm>
            <a:off x="352953" y="411189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46A1CCE-996C-4241-9FD1-939CBEE36236}"/>
              </a:ext>
            </a:extLst>
          </p:cNvPr>
          <p:cNvSpPr txBox="1"/>
          <p:nvPr/>
        </p:nvSpPr>
        <p:spPr>
          <a:xfrm>
            <a:off x="352953" y="449227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AC7A0AB-9331-4B55-B11D-2E687A2F0E06}"/>
              </a:ext>
            </a:extLst>
          </p:cNvPr>
          <p:cNvSpPr txBox="1"/>
          <p:nvPr/>
        </p:nvSpPr>
        <p:spPr>
          <a:xfrm>
            <a:off x="352953" y="489856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3BD80F4-1DC0-44E2-93D6-14C043D96118}"/>
              </a:ext>
            </a:extLst>
          </p:cNvPr>
          <p:cNvSpPr txBox="1"/>
          <p:nvPr/>
        </p:nvSpPr>
        <p:spPr>
          <a:xfrm>
            <a:off x="352953" y="545151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EB24EA65-12B6-4329-BF61-BCBF3CFE8C4A}"/>
              </a:ext>
            </a:extLst>
          </p:cNvPr>
          <p:cNvGrpSpPr/>
          <p:nvPr/>
        </p:nvGrpSpPr>
        <p:grpSpPr>
          <a:xfrm>
            <a:off x="1749860" y="4707947"/>
            <a:ext cx="667746" cy="396482"/>
            <a:chOff x="1688536" y="4910820"/>
            <a:chExt cx="667746" cy="396482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FF08F47B-875C-4E99-97FD-C7899EB722DC}"/>
                </a:ext>
              </a:extLst>
            </p:cNvPr>
            <p:cNvCxnSpPr>
              <a:cxnSpLocks/>
            </p:cNvCxnSpPr>
            <p:nvPr/>
          </p:nvCxnSpPr>
          <p:spPr>
            <a:xfrm>
              <a:off x="1688536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232F5873-B9DE-4D59-93CB-B16C4B385CDA}"/>
                </a:ext>
              </a:extLst>
            </p:cNvPr>
            <p:cNvSpPr txBox="1"/>
            <p:nvPr/>
          </p:nvSpPr>
          <p:spPr>
            <a:xfrm>
              <a:off x="169380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8C7EC2A9-08D7-4BC6-BCD1-B904887C179E}"/>
              </a:ext>
            </a:extLst>
          </p:cNvPr>
          <p:cNvGrpSpPr/>
          <p:nvPr/>
        </p:nvGrpSpPr>
        <p:grpSpPr>
          <a:xfrm>
            <a:off x="2494176" y="4707947"/>
            <a:ext cx="662474" cy="396482"/>
            <a:chOff x="2454753" y="4910820"/>
            <a:chExt cx="662474" cy="396482"/>
          </a:xfrm>
        </p:grpSpPr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0BEDCBF8-72F1-4A55-AFF7-AE90AD9A04CA}"/>
                </a:ext>
              </a:extLst>
            </p:cNvPr>
            <p:cNvSpPr txBox="1"/>
            <p:nvPr/>
          </p:nvSpPr>
          <p:spPr>
            <a:xfrm>
              <a:off x="2454753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7461213A-AE95-4520-8767-86A4DE4F1072}"/>
                </a:ext>
              </a:extLst>
            </p:cNvPr>
            <p:cNvCxnSpPr>
              <a:cxnSpLocks/>
            </p:cNvCxnSpPr>
            <p:nvPr/>
          </p:nvCxnSpPr>
          <p:spPr>
            <a:xfrm>
              <a:off x="2460868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79584837-1F7F-4620-BDAA-60D8EEEF16BA}"/>
              </a:ext>
            </a:extLst>
          </p:cNvPr>
          <p:cNvGrpSpPr/>
          <p:nvPr/>
        </p:nvGrpSpPr>
        <p:grpSpPr>
          <a:xfrm>
            <a:off x="3233220" y="4707947"/>
            <a:ext cx="662474" cy="396482"/>
            <a:chOff x="3223448" y="4910820"/>
            <a:chExt cx="662474" cy="396482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B52B693-C5D6-4A01-9573-480017A7F2C0}"/>
                </a:ext>
              </a:extLst>
            </p:cNvPr>
            <p:cNvSpPr txBox="1"/>
            <p:nvPr/>
          </p:nvSpPr>
          <p:spPr>
            <a:xfrm>
              <a:off x="322344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3CC1E53E-1E38-4E68-B3E7-9C624E0B2C7F}"/>
                </a:ext>
              </a:extLst>
            </p:cNvPr>
            <p:cNvCxnSpPr>
              <a:cxnSpLocks/>
            </p:cNvCxnSpPr>
            <p:nvPr/>
          </p:nvCxnSpPr>
          <p:spPr>
            <a:xfrm>
              <a:off x="3233200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2BA780D7-6BB7-4AD5-B3BD-D81CA7C6448E}"/>
              </a:ext>
            </a:extLst>
          </p:cNvPr>
          <p:cNvGrpSpPr/>
          <p:nvPr/>
        </p:nvGrpSpPr>
        <p:grpSpPr>
          <a:xfrm>
            <a:off x="3972264" y="4707947"/>
            <a:ext cx="667746" cy="396482"/>
            <a:chOff x="3979703" y="4910820"/>
            <a:chExt cx="667746" cy="396482"/>
          </a:xfrm>
        </p:grpSpPr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D80FD4FE-EB68-4364-B1AE-BE0B87ADA857}"/>
                </a:ext>
              </a:extLst>
            </p:cNvPr>
            <p:cNvCxnSpPr>
              <a:cxnSpLocks/>
            </p:cNvCxnSpPr>
            <p:nvPr/>
          </p:nvCxnSpPr>
          <p:spPr>
            <a:xfrm>
              <a:off x="3979703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0E672EC4-5EF5-430A-986F-71DC92F53D59}"/>
                </a:ext>
              </a:extLst>
            </p:cNvPr>
            <p:cNvSpPr txBox="1"/>
            <p:nvPr/>
          </p:nvSpPr>
          <p:spPr>
            <a:xfrm>
              <a:off x="398497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4E07CAF4-7007-45F2-9ECA-6C759FAAFCF2}"/>
              </a:ext>
            </a:extLst>
          </p:cNvPr>
          <p:cNvGrpSpPr/>
          <p:nvPr/>
        </p:nvGrpSpPr>
        <p:grpSpPr>
          <a:xfrm>
            <a:off x="4716580" y="4707947"/>
            <a:ext cx="662474" cy="396482"/>
            <a:chOff x="4745920" y="4910820"/>
            <a:chExt cx="662474" cy="396482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7C614F21-6663-4CAD-8EFF-6777FB5ECA9B}"/>
                </a:ext>
              </a:extLst>
            </p:cNvPr>
            <p:cNvSpPr txBox="1"/>
            <p:nvPr/>
          </p:nvSpPr>
          <p:spPr>
            <a:xfrm>
              <a:off x="4745920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9A17F1E8-496B-4131-B646-77C8B655A793}"/>
                </a:ext>
              </a:extLst>
            </p:cNvPr>
            <p:cNvCxnSpPr>
              <a:cxnSpLocks/>
            </p:cNvCxnSpPr>
            <p:nvPr/>
          </p:nvCxnSpPr>
          <p:spPr>
            <a:xfrm>
              <a:off x="4752035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7C55E7A5-6323-4096-9862-AC9BCEE280A5}"/>
              </a:ext>
            </a:extLst>
          </p:cNvPr>
          <p:cNvGrpSpPr/>
          <p:nvPr/>
        </p:nvGrpSpPr>
        <p:grpSpPr>
          <a:xfrm>
            <a:off x="5455623" y="4707947"/>
            <a:ext cx="662474" cy="396482"/>
            <a:chOff x="5514615" y="4910820"/>
            <a:chExt cx="662474" cy="396482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EBC8571-A47C-4CC5-B0C1-D9779F29414C}"/>
                </a:ext>
              </a:extLst>
            </p:cNvPr>
            <p:cNvSpPr txBox="1"/>
            <p:nvPr/>
          </p:nvSpPr>
          <p:spPr>
            <a:xfrm>
              <a:off x="551461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7D783586-0857-4311-98A5-8648EEC68FD1}"/>
                </a:ext>
              </a:extLst>
            </p:cNvPr>
            <p:cNvCxnSpPr>
              <a:cxnSpLocks/>
            </p:cNvCxnSpPr>
            <p:nvPr/>
          </p:nvCxnSpPr>
          <p:spPr>
            <a:xfrm>
              <a:off x="5524367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629DCD2-AB48-4AD3-A470-4E3556D873BB}"/>
              </a:ext>
            </a:extLst>
          </p:cNvPr>
          <p:cNvSpPr txBox="1"/>
          <p:nvPr/>
        </p:nvSpPr>
        <p:spPr>
          <a:xfrm>
            <a:off x="1703423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D66BE46-57E9-4B83-8FBB-26317F2C30EB}"/>
              </a:ext>
            </a:extLst>
          </p:cNvPr>
          <p:cNvSpPr txBox="1"/>
          <p:nvPr/>
        </p:nvSpPr>
        <p:spPr>
          <a:xfrm>
            <a:off x="2072997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808EC03-703E-4CA1-9B2A-AC5D9D7F0DDE}"/>
              </a:ext>
            </a:extLst>
          </p:cNvPr>
          <p:cNvSpPr txBox="1"/>
          <p:nvPr/>
        </p:nvSpPr>
        <p:spPr>
          <a:xfrm>
            <a:off x="2442571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72E2C79-BD5B-476E-8546-D436164A28ED}"/>
              </a:ext>
            </a:extLst>
          </p:cNvPr>
          <p:cNvSpPr txBox="1"/>
          <p:nvPr/>
        </p:nvSpPr>
        <p:spPr>
          <a:xfrm>
            <a:off x="2812145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5043875-B528-4B1A-99C1-FF7742CFED0B}"/>
              </a:ext>
            </a:extLst>
          </p:cNvPr>
          <p:cNvSpPr txBox="1"/>
          <p:nvPr/>
        </p:nvSpPr>
        <p:spPr>
          <a:xfrm>
            <a:off x="3181719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BC2839C-E919-4031-92C9-84ED83CBBA50}"/>
              </a:ext>
            </a:extLst>
          </p:cNvPr>
          <p:cNvSpPr txBox="1"/>
          <p:nvPr/>
        </p:nvSpPr>
        <p:spPr>
          <a:xfrm>
            <a:off x="3551293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BCE0152-8908-4E16-BDE9-2F07EBE147FE}"/>
              </a:ext>
            </a:extLst>
          </p:cNvPr>
          <p:cNvSpPr txBox="1"/>
          <p:nvPr/>
        </p:nvSpPr>
        <p:spPr>
          <a:xfrm>
            <a:off x="3920867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EE6FED4-BA88-4189-B08A-8FECF6F4C339}"/>
              </a:ext>
            </a:extLst>
          </p:cNvPr>
          <p:cNvSpPr txBox="1"/>
          <p:nvPr/>
        </p:nvSpPr>
        <p:spPr>
          <a:xfrm>
            <a:off x="4290441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833B3D5-6896-49C0-8847-12ED53A37B1A}"/>
              </a:ext>
            </a:extLst>
          </p:cNvPr>
          <p:cNvSpPr txBox="1"/>
          <p:nvPr/>
        </p:nvSpPr>
        <p:spPr>
          <a:xfrm>
            <a:off x="4660015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E63273-2525-42DB-B2C2-A87D3E764CE1}"/>
              </a:ext>
            </a:extLst>
          </p:cNvPr>
          <p:cNvSpPr txBox="1"/>
          <p:nvPr/>
        </p:nvSpPr>
        <p:spPr>
          <a:xfrm>
            <a:off x="5029589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4572C79-8E4D-41BF-93C5-51CB16B8711F}"/>
              </a:ext>
            </a:extLst>
          </p:cNvPr>
          <p:cNvSpPr txBox="1"/>
          <p:nvPr/>
        </p:nvSpPr>
        <p:spPr>
          <a:xfrm>
            <a:off x="5399163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0CC4E1D-74D6-48DC-A604-15785E2F07D1}"/>
              </a:ext>
            </a:extLst>
          </p:cNvPr>
          <p:cNvSpPr txBox="1"/>
          <p:nvPr/>
        </p:nvSpPr>
        <p:spPr>
          <a:xfrm>
            <a:off x="5768732" y="3885788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D761283-25A3-4596-A1F1-DE2F23E9D594}"/>
              </a:ext>
            </a:extLst>
          </p:cNvPr>
          <p:cNvSpPr txBox="1"/>
          <p:nvPr/>
        </p:nvSpPr>
        <p:spPr>
          <a:xfrm>
            <a:off x="3099455" y="3499756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AY 11-708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90697338-6B1B-4289-9623-A28B1DC54057}"/>
              </a:ext>
            </a:extLst>
          </p:cNvPr>
          <p:cNvCxnSpPr>
            <a:cxnSpLocks/>
          </p:cNvCxnSpPr>
          <p:nvPr/>
        </p:nvCxnSpPr>
        <p:spPr>
          <a:xfrm>
            <a:off x="1701734" y="3898811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7AC7AE0-9B05-46FD-AD45-392CBD3B5640}"/>
              </a:ext>
            </a:extLst>
          </p:cNvPr>
          <p:cNvSpPr txBox="1"/>
          <p:nvPr/>
        </p:nvSpPr>
        <p:spPr>
          <a:xfrm>
            <a:off x="352953" y="574027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397BC19-DD6F-4BA8-BC2B-ABDF78D7A03E}"/>
              </a:ext>
            </a:extLst>
          </p:cNvPr>
          <p:cNvSpPr txBox="1"/>
          <p:nvPr/>
        </p:nvSpPr>
        <p:spPr>
          <a:xfrm>
            <a:off x="7300766" y="343861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3F1B442-5B79-4DF0-8FED-21AB70D65704}"/>
              </a:ext>
            </a:extLst>
          </p:cNvPr>
          <p:cNvSpPr txBox="1"/>
          <p:nvPr/>
        </p:nvSpPr>
        <p:spPr>
          <a:xfrm>
            <a:off x="7300766" y="362367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ECD9541-96A6-4CC6-9B73-59EDABE44E03}"/>
              </a:ext>
            </a:extLst>
          </p:cNvPr>
          <p:cNvSpPr txBox="1"/>
          <p:nvPr/>
        </p:nvSpPr>
        <p:spPr>
          <a:xfrm>
            <a:off x="7300766" y="384745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A6EE7EC-5660-4A2F-B9CF-70E72E360679}"/>
              </a:ext>
            </a:extLst>
          </p:cNvPr>
          <p:cNvSpPr txBox="1"/>
          <p:nvPr/>
        </p:nvSpPr>
        <p:spPr>
          <a:xfrm>
            <a:off x="7300766" y="405307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604E020F-8B52-4A64-9716-1999B87ABE45}"/>
              </a:ext>
            </a:extLst>
          </p:cNvPr>
          <p:cNvSpPr txBox="1"/>
          <p:nvPr/>
        </p:nvSpPr>
        <p:spPr>
          <a:xfrm>
            <a:off x="7300766" y="448425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B0D6796-792C-431F-9C9D-D86CB900BFCC}"/>
              </a:ext>
            </a:extLst>
          </p:cNvPr>
          <p:cNvSpPr txBox="1"/>
          <p:nvPr/>
        </p:nvSpPr>
        <p:spPr>
          <a:xfrm>
            <a:off x="7300766" y="492102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7EF2978-F4CB-4778-B38E-A40F720E209C}"/>
              </a:ext>
            </a:extLst>
          </p:cNvPr>
          <p:cNvSpPr txBox="1"/>
          <p:nvPr/>
        </p:nvSpPr>
        <p:spPr>
          <a:xfrm>
            <a:off x="7300766" y="562637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A4B351B-BE52-4E9D-8B85-A2EC56867D52}"/>
              </a:ext>
            </a:extLst>
          </p:cNvPr>
          <p:cNvSpPr txBox="1"/>
          <p:nvPr/>
        </p:nvSpPr>
        <p:spPr>
          <a:xfrm>
            <a:off x="7300766" y="59151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34A6E20B-FDAA-44B4-8527-59536DF117AB}"/>
              </a:ext>
            </a:extLst>
          </p:cNvPr>
          <p:cNvGrpSpPr/>
          <p:nvPr/>
        </p:nvGrpSpPr>
        <p:grpSpPr>
          <a:xfrm>
            <a:off x="8823023" y="5517945"/>
            <a:ext cx="667746" cy="396482"/>
            <a:chOff x="1688536" y="4910820"/>
            <a:chExt cx="667746" cy="396482"/>
          </a:xfrm>
        </p:grpSpPr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9077C7E3-9BE1-4769-9E4E-7C66EA64FF65}"/>
                </a:ext>
              </a:extLst>
            </p:cNvPr>
            <p:cNvCxnSpPr>
              <a:cxnSpLocks/>
            </p:cNvCxnSpPr>
            <p:nvPr/>
          </p:nvCxnSpPr>
          <p:spPr>
            <a:xfrm>
              <a:off x="1688536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81481B48-229E-4431-B72F-C48C396089B4}"/>
                </a:ext>
              </a:extLst>
            </p:cNvPr>
            <p:cNvSpPr txBox="1"/>
            <p:nvPr/>
          </p:nvSpPr>
          <p:spPr>
            <a:xfrm>
              <a:off x="169380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A18766AE-FFFD-4CE5-9FF2-B687CD0DAF2E}"/>
              </a:ext>
            </a:extLst>
          </p:cNvPr>
          <p:cNvGrpSpPr/>
          <p:nvPr/>
        </p:nvGrpSpPr>
        <p:grpSpPr>
          <a:xfrm>
            <a:off x="9567339" y="5517945"/>
            <a:ext cx="662474" cy="396482"/>
            <a:chOff x="2454753" y="4910820"/>
            <a:chExt cx="662474" cy="396482"/>
          </a:xfrm>
        </p:grpSpPr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36357D7F-577A-4890-BFBF-D3C969FDADBB}"/>
                </a:ext>
              </a:extLst>
            </p:cNvPr>
            <p:cNvSpPr txBox="1"/>
            <p:nvPr/>
          </p:nvSpPr>
          <p:spPr>
            <a:xfrm>
              <a:off x="2454753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308796BD-7076-471D-92ED-9E54A0EE33FA}"/>
                </a:ext>
              </a:extLst>
            </p:cNvPr>
            <p:cNvCxnSpPr>
              <a:cxnSpLocks/>
            </p:cNvCxnSpPr>
            <p:nvPr/>
          </p:nvCxnSpPr>
          <p:spPr>
            <a:xfrm>
              <a:off x="2460868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0614DDA4-9AA0-426C-B003-ADB28137E696}"/>
              </a:ext>
            </a:extLst>
          </p:cNvPr>
          <p:cNvGrpSpPr/>
          <p:nvPr/>
        </p:nvGrpSpPr>
        <p:grpSpPr>
          <a:xfrm>
            <a:off x="10306383" y="5517945"/>
            <a:ext cx="662474" cy="396482"/>
            <a:chOff x="3223448" y="4910820"/>
            <a:chExt cx="662474" cy="396482"/>
          </a:xfrm>
        </p:grpSpPr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BC113549-E90B-4CD7-AE0B-D5EB9BE8753F}"/>
                </a:ext>
              </a:extLst>
            </p:cNvPr>
            <p:cNvSpPr txBox="1"/>
            <p:nvPr/>
          </p:nvSpPr>
          <p:spPr>
            <a:xfrm>
              <a:off x="3223448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70DE8E59-03EF-4663-B6EC-1DD7BB690A0E}"/>
                </a:ext>
              </a:extLst>
            </p:cNvPr>
            <p:cNvCxnSpPr>
              <a:cxnSpLocks/>
            </p:cNvCxnSpPr>
            <p:nvPr/>
          </p:nvCxnSpPr>
          <p:spPr>
            <a:xfrm>
              <a:off x="3233200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B191A25B-6BB5-4E3D-87E5-277562542B94}"/>
              </a:ext>
            </a:extLst>
          </p:cNvPr>
          <p:cNvGrpSpPr/>
          <p:nvPr/>
        </p:nvGrpSpPr>
        <p:grpSpPr>
          <a:xfrm>
            <a:off x="11045427" y="5517945"/>
            <a:ext cx="667746" cy="396482"/>
            <a:chOff x="3979703" y="4910820"/>
            <a:chExt cx="667746" cy="396482"/>
          </a:xfrm>
        </p:grpSpPr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E1F06751-CC5A-4E5E-85C7-92972EF68EA6}"/>
                </a:ext>
              </a:extLst>
            </p:cNvPr>
            <p:cNvCxnSpPr>
              <a:cxnSpLocks/>
            </p:cNvCxnSpPr>
            <p:nvPr/>
          </p:nvCxnSpPr>
          <p:spPr>
            <a:xfrm>
              <a:off x="3979703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9F49D645-9AFC-4B33-865F-F24D367B2A82}"/>
                </a:ext>
              </a:extLst>
            </p:cNvPr>
            <p:cNvSpPr txBox="1"/>
            <p:nvPr/>
          </p:nvSpPr>
          <p:spPr>
            <a:xfrm>
              <a:off x="398497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2F1C90DD-B92E-4092-976D-E058ECEB317F}"/>
              </a:ext>
            </a:extLst>
          </p:cNvPr>
          <p:cNvGrpSpPr/>
          <p:nvPr/>
        </p:nvGrpSpPr>
        <p:grpSpPr>
          <a:xfrm>
            <a:off x="11789743" y="5517945"/>
            <a:ext cx="662474" cy="396482"/>
            <a:chOff x="4745920" y="4910820"/>
            <a:chExt cx="662474" cy="396482"/>
          </a:xfrm>
        </p:grpSpPr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83D34323-B087-44F0-B494-1B32FD77381C}"/>
                </a:ext>
              </a:extLst>
            </p:cNvPr>
            <p:cNvSpPr txBox="1"/>
            <p:nvPr/>
          </p:nvSpPr>
          <p:spPr>
            <a:xfrm>
              <a:off x="4745920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6B003B59-AC00-4898-BB35-4CD4911732A4}"/>
                </a:ext>
              </a:extLst>
            </p:cNvPr>
            <p:cNvCxnSpPr>
              <a:cxnSpLocks/>
            </p:cNvCxnSpPr>
            <p:nvPr/>
          </p:nvCxnSpPr>
          <p:spPr>
            <a:xfrm>
              <a:off x="4752035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A4F0C825-6BA1-4BF8-B9D5-CF383303AFFB}"/>
              </a:ext>
            </a:extLst>
          </p:cNvPr>
          <p:cNvGrpSpPr/>
          <p:nvPr/>
        </p:nvGrpSpPr>
        <p:grpSpPr>
          <a:xfrm>
            <a:off x="12528786" y="5517945"/>
            <a:ext cx="662474" cy="396482"/>
            <a:chOff x="5514615" y="4910820"/>
            <a:chExt cx="662474" cy="396482"/>
          </a:xfrm>
        </p:grpSpPr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DFBE9526-8E95-4E21-A73D-0D66E2A2DADF}"/>
                </a:ext>
              </a:extLst>
            </p:cNvPr>
            <p:cNvSpPr txBox="1"/>
            <p:nvPr/>
          </p:nvSpPr>
          <p:spPr>
            <a:xfrm>
              <a:off x="5514615" y="4937970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790F7792-A98A-4EA0-A753-F86EC99029C3}"/>
                </a:ext>
              </a:extLst>
            </p:cNvPr>
            <p:cNvCxnSpPr>
              <a:cxnSpLocks/>
            </p:cNvCxnSpPr>
            <p:nvPr/>
          </p:nvCxnSpPr>
          <p:spPr>
            <a:xfrm>
              <a:off x="5524367" y="4910820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04B9E894-387C-4918-9147-BF754EFC1BA8}"/>
              </a:ext>
            </a:extLst>
          </p:cNvPr>
          <p:cNvSpPr txBox="1"/>
          <p:nvPr/>
        </p:nvSpPr>
        <p:spPr>
          <a:xfrm>
            <a:off x="8776586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114CCAE-E7E9-4DB6-BB53-F012CA8D8AF8}"/>
              </a:ext>
            </a:extLst>
          </p:cNvPr>
          <p:cNvSpPr txBox="1"/>
          <p:nvPr/>
        </p:nvSpPr>
        <p:spPr>
          <a:xfrm>
            <a:off x="9146160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95B03DA4-4513-4C47-A42A-FE090AFC9C04}"/>
              </a:ext>
            </a:extLst>
          </p:cNvPr>
          <p:cNvSpPr txBox="1"/>
          <p:nvPr/>
        </p:nvSpPr>
        <p:spPr>
          <a:xfrm>
            <a:off x="9515734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42A4EB5F-9830-4785-A070-2C43766E38F6}"/>
              </a:ext>
            </a:extLst>
          </p:cNvPr>
          <p:cNvSpPr txBox="1"/>
          <p:nvPr/>
        </p:nvSpPr>
        <p:spPr>
          <a:xfrm>
            <a:off x="9885308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D28D3FAD-F56B-40FE-B643-92204B090E79}"/>
              </a:ext>
            </a:extLst>
          </p:cNvPr>
          <p:cNvSpPr txBox="1"/>
          <p:nvPr/>
        </p:nvSpPr>
        <p:spPr>
          <a:xfrm>
            <a:off x="10254882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0EF9C61F-418A-4732-AA89-C499AC5CFFC5}"/>
              </a:ext>
            </a:extLst>
          </p:cNvPr>
          <p:cNvSpPr txBox="1"/>
          <p:nvPr/>
        </p:nvSpPr>
        <p:spPr>
          <a:xfrm>
            <a:off x="10624456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14BB44F-67B9-47F6-8869-AFA671A162B7}"/>
              </a:ext>
            </a:extLst>
          </p:cNvPr>
          <p:cNvSpPr txBox="1"/>
          <p:nvPr/>
        </p:nvSpPr>
        <p:spPr>
          <a:xfrm>
            <a:off x="10994030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5E44051B-68C3-42DC-916A-3B64282DE7B0}"/>
              </a:ext>
            </a:extLst>
          </p:cNvPr>
          <p:cNvSpPr txBox="1"/>
          <p:nvPr/>
        </p:nvSpPr>
        <p:spPr>
          <a:xfrm>
            <a:off x="11363604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3DA1451-F4B0-4581-A5A0-1DAC09D56A38}"/>
              </a:ext>
            </a:extLst>
          </p:cNvPr>
          <p:cNvSpPr txBox="1"/>
          <p:nvPr/>
        </p:nvSpPr>
        <p:spPr>
          <a:xfrm>
            <a:off x="11733178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D4D616B-B565-4655-BE7F-F7FE30BC933F}"/>
              </a:ext>
            </a:extLst>
          </p:cNvPr>
          <p:cNvSpPr txBox="1"/>
          <p:nvPr/>
        </p:nvSpPr>
        <p:spPr>
          <a:xfrm>
            <a:off x="12102752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9CB66DB-23F4-4DDE-8165-92721174DA09}"/>
              </a:ext>
            </a:extLst>
          </p:cNvPr>
          <p:cNvSpPr txBox="1"/>
          <p:nvPr/>
        </p:nvSpPr>
        <p:spPr>
          <a:xfrm>
            <a:off x="12472326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EE3498F-1AA8-4479-AA8B-3041F519BB78}"/>
              </a:ext>
            </a:extLst>
          </p:cNvPr>
          <p:cNvSpPr txBox="1"/>
          <p:nvPr/>
        </p:nvSpPr>
        <p:spPr>
          <a:xfrm>
            <a:off x="12841895" y="4705946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DCA83C1E-F13E-47D7-BD36-D289299DA5FF}"/>
              </a:ext>
            </a:extLst>
          </p:cNvPr>
          <p:cNvSpPr txBox="1"/>
          <p:nvPr/>
        </p:nvSpPr>
        <p:spPr>
          <a:xfrm>
            <a:off x="10172618" y="4319914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AY 11-708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F918C40F-8524-483F-B48B-632A1473273D}"/>
              </a:ext>
            </a:extLst>
          </p:cNvPr>
          <p:cNvCxnSpPr>
            <a:cxnSpLocks/>
          </p:cNvCxnSpPr>
          <p:nvPr/>
        </p:nvCxnSpPr>
        <p:spPr>
          <a:xfrm>
            <a:off x="8774897" y="4718969"/>
            <a:ext cx="4479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54DE4567-1BEF-4FBE-B74F-37C8F53962A6}"/>
              </a:ext>
            </a:extLst>
          </p:cNvPr>
          <p:cNvSpPr txBox="1"/>
          <p:nvPr/>
        </p:nvSpPr>
        <p:spPr>
          <a:xfrm>
            <a:off x="7300766" y="618945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59388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732D3D2-6FAA-4612-B3E2-2AD6A25F1E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2043" y="3515701"/>
            <a:ext cx="5839126" cy="25380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F3C4FED4-9C9F-4E65-9B4B-115AE14E5E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057" y="3515701"/>
            <a:ext cx="5788350" cy="258876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 (left) and GAPDH (right) for Fig. 4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787424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816655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6237" y="342954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6237" y="3618343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6237" y="38276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6237" y="40552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6237" y="443935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6237" y="481302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6237" y="538202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3FBE975-AF04-4BED-ACD1-612461832CB0}"/>
              </a:ext>
            </a:extLst>
          </p:cNvPr>
          <p:cNvGrpSpPr/>
          <p:nvPr/>
        </p:nvGrpSpPr>
        <p:grpSpPr>
          <a:xfrm>
            <a:off x="1472339" y="3963309"/>
            <a:ext cx="4556496" cy="1875250"/>
            <a:chOff x="1472339" y="2866029"/>
            <a:chExt cx="4556496" cy="1875250"/>
          </a:xfrm>
        </p:grpSpPr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930BCDD1-8BD2-420F-8022-38BC6DAC3995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8DB08DA-8BC2-4079-B74B-78E34C46D7D4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EBC005D-728C-4765-92C1-7555ECDE3DD3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F63C9915-DD95-4BE2-BA40-050168C26B37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CC3360FB-6378-44BD-BE1E-FFB4307ACFE8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5AF4E111-1046-4B5D-B083-852A877B61DC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F757E676-466F-4C68-BA64-96E519C24AB9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00B446D-FAC8-4C68-A18D-CA3AABF944A3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69A756A8-47FE-49C7-9ECF-C100F57F2833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03806D9-DA7B-4D33-8BF5-16EF3DFEFFD6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498F2056-603B-4370-9D03-BFE58F131D69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8397F63F-2E0A-4286-873E-06FCA8A8E0CE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0CC8F7B-3395-4DD4-B558-8133C975E068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B374298-D6D1-46C3-AF10-6BA669CEF78D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B5085D0E-CC07-4424-B5B9-E56B2A658A65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EFD6F01-ACFF-4F01-8906-78AD3699F4F1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807B44B6-B15E-4217-8B87-0588E4D0AEC2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65A70F0-984E-4CD5-B23D-E9C1D92ECAAF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8B5444F-C162-4E25-89E5-478E0B15CE44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89B49A12-4E36-4D74-8A57-48FB9D4FC629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21C75ADD-B8B1-464C-9EF6-13EC4F0418B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B74D098D-E88A-4DCC-B329-05F2D89390A8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E4AA5CE8-403E-47DB-9FAC-557470E3338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2C2F929-F94B-49B9-A7E1-446C3759CB3D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33EECE32-DB0D-4938-A986-B02AE92C3486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ABD180EB-FBA7-4BBF-A9A7-D0EA57B7171D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7456919" y="342382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7456919" y="361261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7456919" y="382196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7456919" y="404951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7456919" y="443363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7456919" y="480730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7456919" y="537629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グループ化 122">
            <a:extLst>
              <a:ext uri="{FF2B5EF4-FFF2-40B4-BE49-F238E27FC236}">
                <a16:creationId xmlns:a16="http://schemas.microsoft.com/office/drawing/2014/main" id="{CDB682E0-0B19-4207-8F2C-31E2C5B45E9A}"/>
              </a:ext>
            </a:extLst>
          </p:cNvPr>
          <p:cNvGrpSpPr/>
          <p:nvPr/>
        </p:nvGrpSpPr>
        <p:grpSpPr>
          <a:xfrm>
            <a:off x="8841085" y="3930357"/>
            <a:ext cx="4556496" cy="1875250"/>
            <a:chOff x="1472339" y="2866029"/>
            <a:chExt cx="4556496" cy="1875250"/>
          </a:xfrm>
        </p:grpSpPr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D193AEDF-029F-40DD-8769-E8B3A23C8FEB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ADE955E1-7738-421C-A24B-9E5D19E02385}"/>
                </a:ext>
              </a:extLst>
            </p:cNvPr>
            <p:cNvSpPr txBox="1"/>
            <p:nvPr/>
          </p:nvSpPr>
          <p:spPr>
            <a:xfrm>
              <a:off x="150800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ED36547A-D9CB-4908-86EE-8821F4091B9F}"/>
                </a:ext>
              </a:extLst>
            </p:cNvPr>
            <p:cNvSpPr txBox="1"/>
            <p:nvPr/>
          </p:nvSpPr>
          <p:spPr>
            <a:xfrm>
              <a:off x="3037646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0BEE150-C6EC-4D80-A379-0D759EA9DADF}"/>
                </a:ext>
              </a:extLst>
            </p:cNvPr>
            <p:cNvSpPr txBox="1"/>
            <p:nvPr/>
          </p:nvSpPr>
          <p:spPr>
            <a:xfrm>
              <a:off x="2268951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5271F0C8-405B-4596-B8D4-3479F9714E2E}"/>
                </a:ext>
              </a:extLst>
            </p:cNvPr>
            <p:cNvCxnSpPr>
              <a:cxnSpLocks/>
            </p:cNvCxnSpPr>
            <p:nvPr/>
          </p:nvCxnSpPr>
          <p:spPr>
            <a:xfrm>
              <a:off x="2275066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B0FD5E9B-5D5D-4891-AC3D-3B9FF254E14E}"/>
                </a:ext>
              </a:extLst>
            </p:cNvPr>
            <p:cNvCxnSpPr>
              <a:cxnSpLocks/>
            </p:cNvCxnSpPr>
            <p:nvPr/>
          </p:nvCxnSpPr>
          <p:spPr>
            <a:xfrm>
              <a:off x="3047398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55030C48-459C-424A-973E-130CCE24316C}"/>
                </a:ext>
              </a:extLst>
            </p:cNvPr>
            <p:cNvCxnSpPr>
              <a:cxnSpLocks/>
            </p:cNvCxnSpPr>
            <p:nvPr/>
          </p:nvCxnSpPr>
          <p:spPr>
            <a:xfrm>
              <a:off x="3793901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109E9920-5005-4B67-9F14-768046F6163F}"/>
                </a:ext>
              </a:extLst>
            </p:cNvPr>
            <p:cNvSpPr txBox="1"/>
            <p:nvPr/>
          </p:nvSpPr>
          <p:spPr>
            <a:xfrm>
              <a:off x="379917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b="1" baseline="-1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C7997C1A-ED28-47CD-B6B3-59C2033A2DEC}"/>
                </a:ext>
              </a:extLst>
            </p:cNvPr>
            <p:cNvSpPr txBox="1"/>
            <p:nvPr/>
          </p:nvSpPr>
          <p:spPr>
            <a:xfrm>
              <a:off x="5328813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BCBCA5D7-7313-40C5-AD3D-5CFA71296F7E}"/>
                </a:ext>
              </a:extLst>
            </p:cNvPr>
            <p:cNvSpPr txBox="1"/>
            <p:nvPr/>
          </p:nvSpPr>
          <p:spPr>
            <a:xfrm>
              <a:off x="4560118" y="4371947"/>
              <a:ext cx="662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8DA281B4-F597-49FD-A7CB-1F4FA6289904}"/>
                </a:ext>
              </a:extLst>
            </p:cNvPr>
            <p:cNvCxnSpPr>
              <a:cxnSpLocks/>
            </p:cNvCxnSpPr>
            <p:nvPr/>
          </p:nvCxnSpPr>
          <p:spPr>
            <a:xfrm>
              <a:off x="4566233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1FF9CCB3-CDB9-47DA-B43A-6F6C4EF73E4F}"/>
                </a:ext>
              </a:extLst>
            </p:cNvPr>
            <p:cNvCxnSpPr>
              <a:cxnSpLocks/>
            </p:cNvCxnSpPr>
            <p:nvPr/>
          </p:nvCxnSpPr>
          <p:spPr>
            <a:xfrm>
              <a:off x="5338565" y="4344797"/>
              <a:ext cx="64378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DF769565-1F83-4EEC-AF94-F89FD886BEC4}"/>
                </a:ext>
              </a:extLst>
            </p:cNvPr>
            <p:cNvSpPr txBox="1"/>
            <p:nvPr/>
          </p:nvSpPr>
          <p:spPr>
            <a:xfrm>
              <a:off x="147233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C6846242-7174-493F-B4FF-7FA0028D1021}"/>
                </a:ext>
              </a:extLst>
            </p:cNvPr>
            <p:cNvSpPr txBox="1"/>
            <p:nvPr/>
          </p:nvSpPr>
          <p:spPr>
            <a:xfrm>
              <a:off x="184993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FE429405-FDCE-417D-BE5A-A9752EED2247}"/>
                </a:ext>
              </a:extLst>
            </p:cNvPr>
            <p:cNvSpPr txBox="1"/>
            <p:nvPr/>
          </p:nvSpPr>
          <p:spPr>
            <a:xfrm>
              <a:off x="222752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3FE56025-1DA4-47DF-AA1A-DDDC258654F3}"/>
                </a:ext>
              </a:extLst>
            </p:cNvPr>
            <p:cNvSpPr txBox="1"/>
            <p:nvPr/>
          </p:nvSpPr>
          <p:spPr>
            <a:xfrm>
              <a:off x="260512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9911C374-898B-44DC-9B27-6B9BC8843D68}"/>
                </a:ext>
              </a:extLst>
            </p:cNvPr>
            <p:cNvSpPr txBox="1"/>
            <p:nvPr/>
          </p:nvSpPr>
          <p:spPr>
            <a:xfrm>
              <a:off x="298271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679A45F6-1418-4175-B04A-ED618AE867C9}"/>
                </a:ext>
              </a:extLst>
            </p:cNvPr>
            <p:cNvSpPr txBox="1"/>
            <p:nvPr/>
          </p:nvSpPr>
          <p:spPr>
            <a:xfrm>
              <a:off x="336031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CE48CE38-C395-4096-BB15-DE35D317E82A}"/>
                </a:ext>
              </a:extLst>
            </p:cNvPr>
            <p:cNvSpPr txBox="1"/>
            <p:nvPr/>
          </p:nvSpPr>
          <p:spPr>
            <a:xfrm>
              <a:off x="373790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444C2E32-18F9-49FC-8C37-72E6F14D9E4A}"/>
                </a:ext>
              </a:extLst>
            </p:cNvPr>
            <p:cNvSpPr txBox="1"/>
            <p:nvPr/>
          </p:nvSpPr>
          <p:spPr>
            <a:xfrm>
              <a:off x="411550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737B88B6-608C-4590-917B-81058ABC3893}"/>
                </a:ext>
              </a:extLst>
            </p:cNvPr>
            <p:cNvSpPr txBox="1"/>
            <p:nvPr/>
          </p:nvSpPr>
          <p:spPr>
            <a:xfrm>
              <a:off x="449309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40C77F98-4AE3-40EA-B6C7-A7A929B34806}"/>
                </a:ext>
              </a:extLst>
            </p:cNvPr>
            <p:cNvSpPr txBox="1"/>
            <p:nvPr/>
          </p:nvSpPr>
          <p:spPr>
            <a:xfrm>
              <a:off x="4870694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7E6E5A41-B9C8-495E-9110-70BD66F546D8}"/>
                </a:ext>
              </a:extLst>
            </p:cNvPr>
            <p:cNvSpPr txBox="1"/>
            <p:nvPr/>
          </p:nvSpPr>
          <p:spPr>
            <a:xfrm>
              <a:off x="5248289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－</a:t>
              </a: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1E18AD95-CF07-4F50-8D33-440B46F9D58B}"/>
                </a:ext>
              </a:extLst>
            </p:cNvPr>
            <p:cNvSpPr txBox="1"/>
            <p:nvPr/>
          </p:nvSpPr>
          <p:spPr>
            <a:xfrm>
              <a:off x="5625880" y="3252061"/>
              <a:ext cx="4029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dirty="0">
                  <a:latin typeface="ＭＳ ゴシック" panose="020B0609070205080204" pitchFamily="49" charset="-128"/>
                  <a:ea typeface="ＭＳ ゴシック" panose="020B0609070205080204" pitchFamily="49" charset="-128"/>
                </a:rPr>
                <a:t>＋</a:t>
              </a: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6C5112BD-2A35-427B-AB0D-9E77AA89B990}"/>
                </a:ext>
              </a:extLst>
            </p:cNvPr>
            <p:cNvSpPr txBox="1"/>
            <p:nvPr/>
          </p:nvSpPr>
          <p:spPr>
            <a:xfrm>
              <a:off x="2900455" y="2866029"/>
              <a:ext cx="16841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LPS-RS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02290F62-C024-4243-A447-D393E1312F53}"/>
                </a:ext>
              </a:extLst>
            </p:cNvPr>
            <p:cNvCxnSpPr>
              <a:cxnSpLocks/>
            </p:cNvCxnSpPr>
            <p:nvPr/>
          </p:nvCxnSpPr>
          <p:spPr>
            <a:xfrm>
              <a:off x="1502734" y="3265084"/>
              <a:ext cx="44796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671542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22B577D-6C17-4A86-BF78-6FE5461E95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131" y="3478129"/>
            <a:ext cx="3731964" cy="263952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E5F63-2DF6-4ECB-A9AC-1007107BAFC0}"/>
              </a:ext>
            </a:extLst>
          </p:cNvPr>
          <p:cNvSpPr txBox="1"/>
          <p:nvPr/>
        </p:nvSpPr>
        <p:spPr>
          <a:xfrm>
            <a:off x="3211551" y="8060354"/>
            <a:ext cx="109142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 (left) and p65 (right) for Fig. 4C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AC2FBD5-116E-458C-B1A8-C77C3082BDCA}"/>
              </a:ext>
            </a:extLst>
          </p:cNvPr>
          <p:cNvSpPr txBox="1"/>
          <p:nvPr/>
        </p:nvSpPr>
        <p:spPr>
          <a:xfrm>
            <a:off x="1787424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1444101-5447-42FF-898D-01409B91D667}"/>
              </a:ext>
            </a:extLst>
          </p:cNvPr>
          <p:cNvSpPr txBox="1"/>
          <p:nvPr/>
        </p:nvSpPr>
        <p:spPr>
          <a:xfrm>
            <a:off x="8816655" y="2262464"/>
            <a:ext cx="38144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2072AB63-0638-49C7-AA6E-20057C249850}"/>
              </a:ext>
            </a:extLst>
          </p:cNvPr>
          <p:cNvSpPr txBox="1"/>
          <p:nvPr/>
        </p:nvSpPr>
        <p:spPr>
          <a:xfrm>
            <a:off x="1181639" y="349665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8DD2923D-53D5-4C38-9C16-5BB155693368}"/>
              </a:ext>
            </a:extLst>
          </p:cNvPr>
          <p:cNvSpPr txBox="1"/>
          <p:nvPr/>
        </p:nvSpPr>
        <p:spPr>
          <a:xfrm>
            <a:off x="1181639" y="368545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B19FD979-4792-4675-A5D5-BDA56823D295}"/>
              </a:ext>
            </a:extLst>
          </p:cNvPr>
          <p:cNvSpPr txBox="1"/>
          <p:nvPr/>
        </p:nvSpPr>
        <p:spPr>
          <a:xfrm>
            <a:off x="1181639" y="389480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F8F47AF-6C9E-4405-9983-B778FFDC0124}"/>
              </a:ext>
            </a:extLst>
          </p:cNvPr>
          <p:cNvSpPr txBox="1"/>
          <p:nvPr/>
        </p:nvSpPr>
        <p:spPr>
          <a:xfrm>
            <a:off x="1181639" y="412234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3345FC3-6C3C-4D54-8ECB-AA302CEC679D}"/>
              </a:ext>
            </a:extLst>
          </p:cNvPr>
          <p:cNvSpPr txBox="1"/>
          <p:nvPr/>
        </p:nvSpPr>
        <p:spPr>
          <a:xfrm>
            <a:off x="1181639" y="450646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D2E40D5D-4120-4370-8835-1018A9240EAD}"/>
              </a:ext>
            </a:extLst>
          </p:cNvPr>
          <p:cNvSpPr txBox="1"/>
          <p:nvPr/>
        </p:nvSpPr>
        <p:spPr>
          <a:xfrm>
            <a:off x="1181639" y="4880140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311121CA-BFA1-4967-9869-9A39088A5A0C}"/>
              </a:ext>
            </a:extLst>
          </p:cNvPr>
          <p:cNvSpPr txBox="1"/>
          <p:nvPr/>
        </p:nvSpPr>
        <p:spPr>
          <a:xfrm>
            <a:off x="1181639" y="5449134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7" name="直線コネクタ 236">
            <a:extLst>
              <a:ext uri="{FF2B5EF4-FFF2-40B4-BE49-F238E27FC236}">
                <a16:creationId xmlns:a16="http://schemas.microsoft.com/office/drawing/2014/main" id="{930BCDD1-8BD2-420F-8022-38BC6DAC3995}"/>
              </a:ext>
            </a:extLst>
          </p:cNvPr>
          <p:cNvCxnSpPr>
            <a:cxnSpLocks/>
          </p:cNvCxnSpPr>
          <p:nvPr/>
        </p:nvCxnSpPr>
        <p:spPr>
          <a:xfrm>
            <a:off x="2595261" y="466854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78DB08DA-8BC2-4079-B74B-78E34C46D7D4}"/>
              </a:ext>
            </a:extLst>
          </p:cNvPr>
          <p:cNvSpPr txBox="1"/>
          <p:nvPr/>
        </p:nvSpPr>
        <p:spPr>
          <a:xfrm>
            <a:off x="2600533" y="469569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1" lang="en-US" altLang="ja-JP" b="1" baseline="-1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5EBC005D-728C-4765-92C1-7555ECDE3DD3}"/>
              </a:ext>
            </a:extLst>
          </p:cNvPr>
          <p:cNvSpPr txBox="1"/>
          <p:nvPr/>
        </p:nvSpPr>
        <p:spPr>
          <a:xfrm>
            <a:off x="4198412" y="469569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F63C9915-DD95-4BE2-BA40-050168C26B37}"/>
              </a:ext>
            </a:extLst>
          </p:cNvPr>
          <p:cNvSpPr txBox="1"/>
          <p:nvPr/>
        </p:nvSpPr>
        <p:spPr>
          <a:xfrm>
            <a:off x="3375126" y="4695698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CC3360FB-6378-44BD-BE1E-FFB4307ACFE8}"/>
              </a:ext>
            </a:extLst>
          </p:cNvPr>
          <p:cNvCxnSpPr>
            <a:cxnSpLocks/>
          </p:cNvCxnSpPr>
          <p:nvPr/>
        </p:nvCxnSpPr>
        <p:spPr>
          <a:xfrm>
            <a:off x="3381241" y="466854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5AF4E111-1046-4B5D-B083-852A877B61DC}"/>
              </a:ext>
            </a:extLst>
          </p:cNvPr>
          <p:cNvCxnSpPr>
            <a:cxnSpLocks/>
          </p:cNvCxnSpPr>
          <p:nvPr/>
        </p:nvCxnSpPr>
        <p:spPr>
          <a:xfrm>
            <a:off x="4208164" y="4668548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CC8F7B-3395-4DD4-B558-8133C975E068}"/>
              </a:ext>
            </a:extLst>
          </p:cNvPr>
          <p:cNvSpPr txBox="1"/>
          <p:nvPr/>
        </p:nvSpPr>
        <p:spPr>
          <a:xfrm>
            <a:off x="2523924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EB374298-D6D1-46C3-AF10-6BA669CEF78D}"/>
              </a:ext>
            </a:extLst>
          </p:cNvPr>
          <p:cNvSpPr txBox="1"/>
          <p:nvPr/>
        </p:nvSpPr>
        <p:spPr>
          <a:xfrm>
            <a:off x="2916531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5085D0E-CC07-4424-B5B9-E56B2A658A65}"/>
              </a:ext>
            </a:extLst>
          </p:cNvPr>
          <p:cNvSpPr txBox="1"/>
          <p:nvPr/>
        </p:nvSpPr>
        <p:spPr>
          <a:xfrm>
            <a:off x="3309138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EFD6F01-ACFF-4F01-8906-78AD3699F4F1}"/>
              </a:ext>
            </a:extLst>
          </p:cNvPr>
          <p:cNvSpPr txBox="1"/>
          <p:nvPr/>
        </p:nvSpPr>
        <p:spPr>
          <a:xfrm>
            <a:off x="3701745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07B44B6-B15E-4217-8B87-0588E4D0AEC2}"/>
              </a:ext>
            </a:extLst>
          </p:cNvPr>
          <p:cNvSpPr txBox="1"/>
          <p:nvPr/>
        </p:nvSpPr>
        <p:spPr>
          <a:xfrm>
            <a:off x="4094352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765A70F0-984E-4CD5-B23D-E9C1D92ECAAF}"/>
              </a:ext>
            </a:extLst>
          </p:cNvPr>
          <p:cNvSpPr txBox="1"/>
          <p:nvPr/>
        </p:nvSpPr>
        <p:spPr>
          <a:xfrm>
            <a:off x="4486961" y="3835119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3EECE32-DB0D-4938-A986-B02AE92C3486}"/>
              </a:ext>
            </a:extLst>
          </p:cNvPr>
          <p:cNvSpPr txBox="1"/>
          <p:nvPr/>
        </p:nvSpPr>
        <p:spPr>
          <a:xfrm>
            <a:off x="2830704" y="3449087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-R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ABD180EB-FBA7-4BBF-A9A7-D0EA57B7171D}"/>
              </a:ext>
            </a:extLst>
          </p:cNvPr>
          <p:cNvCxnSpPr>
            <a:cxnSpLocks/>
          </p:cNvCxnSpPr>
          <p:nvPr/>
        </p:nvCxnSpPr>
        <p:spPr>
          <a:xfrm>
            <a:off x="2574789" y="3848142"/>
            <a:ext cx="21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7CE6DD5-8B72-4574-A505-F4DD8DE402E0}"/>
              </a:ext>
            </a:extLst>
          </p:cNvPr>
          <p:cNvSpPr txBox="1"/>
          <p:nvPr/>
        </p:nvSpPr>
        <p:spPr>
          <a:xfrm>
            <a:off x="8212292" y="3463578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647FAD1-752E-4AA0-85F7-9E19C9925591}"/>
              </a:ext>
            </a:extLst>
          </p:cNvPr>
          <p:cNvSpPr txBox="1"/>
          <p:nvPr/>
        </p:nvSpPr>
        <p:spPr>
          <a:xfrm>
            <a:off x="8212292" y="3652376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7E3F5A1-7DEC-4B08-BAA2-5D11A5934BF0}"/>
              </a:ext>
            </a:extLst>
          </p:cNvPr>
          <p:cNvSpPr txBox="1"/>
          <p:nvPr/>
        </p:nvSpPr>
        <p:spPr>
          <a:xfrm>
            <a:off x="8212292" y="3861722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4290068-2C2B-4A8A-9C79-190398D098AC}"/>
              </a:ext>
            </a:extLst>
          </p:cNvPr>
          <p:cNvSpPr txBox="1"/>
          <p:nvPr/>
        </p:nvSpPr>
        <p:spPr>
          <a:xfrm>
            <a:off x="8212292" y="4089267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8B27022-9D1E-4A16-8F93-A15F135B2BA9}"/>
              </a:ext>
            </a:extLst>
          </p:cNvPr>
          <p:cNvSpPr txBox="1"/>
          <p:nvPr/>
        </p:nvSpPr>
        <p:spPr>
          <a:xfrm>
            <a:off x="8212292" y="4473389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101F7FA-8347-4944-A64C-51E92A402C93}"/>
              </a:ext>
            </a:extLst>
          </p:cNvPr>
          <p:cNvSpPr txBox="1"/>
          <p:nvPr/>
        </p:nvSpPr>
        <p:spPr>
          <a:xfrm>
            <a:off x="8212292" y="4847061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B2AD3F6-EDD5-4DDD-9595-622D7EEA4CDF}"/>
              </a:ext>
            </a:extLst>
          </p:cNvPr>
          <p:cNvSpPr txBox="1"/>
          <p:nvPr/>
        </p:nvSpPr>
        <p:spPr>
          <a:xfrm>
            <a:off x="8212292" y="5416055"/>
            <a:ext cx="6374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425412B-DEEA-4FAD-BEB3-969F0EE546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94190" y="3478129"/>
            <a:ext cx="3757350" cy="2639520"/>
          </a:xfrm>
          <a:prstGeom prst="rect">
            <a:avLst/>
          </a:prstGeom>
        </p:spPr>
      </p:pic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7BB6321B-2EA5-4FA6-BF4A-B121DF31CD1A}"/>
              </a:ext>
            </a:extLst>
          </p:cNvPr>
          <p:cNvCxnSpPr>
            <a:cxnSpLocks/>
          </p:cNvCxnSpPr>
          <p:nvPr/>
        </p:nvCxnSpPr>
        <p:spPr>
          <a:xfrm>
            <a:off x="9678548" y="4648670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27B8B8C-BF26-4E1B-A5E0-9F89084481A7}"/>
              </a:ext>
            </a:extLst>
          </p:cNvPr>
          <p:cNvSpPr txBox="1"/>
          <p:nvPr/>
        </p:nvSpPr>
        <p:spPr>
          <a:xfrm>
            <a:off x="9683820" y="4675820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1" lang="en-US" altLang="ja-JP" b="1" baseline="-1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39816403-E30A-42CD-9B66-FB756FE233A0}"/>
              </a:ext>
            </a:extLst>
          </p:cNvPr>
          <p:cNvSpPr txBox="1"/>
          <p:nvPr/>
        </p:nvSpPr>
        <p:spPr>
          <a:xfrm>
            <a:off x="11281699" y="4675820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1A135619-560F-42B9-B5FD-49ABFC9FE147}"/>
              </a:ext>
            </a:extLst>
          </p:cNvPr>
          <p:cNvSpPr txBox="1"/>
          <p:nvPr/>
        </p:nvSpPr>
        <p:spPr>
          <a:xfrm>
            <a:off x="10458413" y="4675820"/>
            <a:ext cx="662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A02062E1-E7FE-493B-82D7-DF8CA2B2661A}"/>
              </a:ext>
            </a:extLst>
          </p:cNvPr>
          <p:cNvCxnSpPr>
            <a:cxnSpLocks/>
          </p:cNvCxnSpPr>
          <p:nvPr/>
        </p:nvCxnSpPr>
        <p:spPr>
          <a:xfrm>
            <a:off x="10464528" y="4648670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B7C4B608-974B-4946-B849-F0537E17A5FE}"/>
              </a:ext>
            </a:extLst>
          </p:cNvPr>
          <p:cNvCxnSpPr>
            <a:cxnSpLocks/>
          </p:cNvCxnSpPr>
          <p:nvPr/>
        </p:nvCxnSpPr>
        <p:spPr>
          <a:xfrm>
            <a:off x="11291451" y="4648670"/>
            <a:ext cx="643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AD18E81C-408F-491F-9467-069BB586C423}"/>
              </a:ext>
            </a:extLst>
          </p:cNvPr>
          <p:cNvSpPr txBox="1"/>
          <p:nvPr/>
        </p:nvSpPr>
        <p:spPr>
          <a:xfrm>
            <a:off x="9607211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16D6A516-250B-4F6A-8855-424A448520F1}"/>
              </a:ext>
            </a:extLst>
          </p:cNvPr>
          <p:cNvSpPr txBox="1"/>
          <p:nvPr/>
        </p:nvSpPr>
        <p:spPr>
          <a:xfrm>
            <a:off x="9999818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1963B0A6-7B3B-41B0-AB47-B51F2C092987}"/>
              </a:ext>
            </a:extLst>
          </p:cNvPr>
          <p:cNvSpPr txBox="1"/>
          <p:nvPr/>
        </p:nvSpPr>
        <p:spPr>
          <a:xfrm>
            <a:off x="10392425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40BCC659-2518-4C72-9EBE-E1FF064AED40}"/>
              </a:ext>
            </a:extLst>
          </p:cNvPr>
          <p:cNvSpPr txBox="1"/>
          <p:nvPr/>
        </p:nvSpPr>
        <p:spPr>
          <a:xfrm>
            <a:off x="10785032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69CB4AE3-29CD-4340-A8C6-3F9E4A57EAC4}"/>
              </a:ext>
            </a:extLst>
          </p:cNvPr>
          <p:cNvSpPr txBox="1"/>
          <p:nvPr/>
        </p:nvSpPr>
        <p:spPr>
          <a:xfrm>
            <a:off x="11177639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－</a:t>
            </a: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2FF3A15B-A762-46D0-81F8-29BCF8EB13C4}"/>
              </a:ext>
            </a:extLst>
          </p:cNvPr>
          <p:cNvSpPr txBox="1"/>
          <p:nvPr/>
        </p:nvSpPr>
        <p:spPr>
          <a:xfrm>
            <a:off x="11570248" y="3815241"/>
            <a:ext cx="402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＋</a:t>
            </a: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2D4C7B68-9AE8-47ED-A0F7-88CA99BD6CCB}"/>
              </a:ext>
            </a:extLst>
          </p:cNvPr>
          <p:cNvSpPr txBox="1"/>
          <p:nvPr/>
        </p:nvSpPr>
        <p:spPr>
          <a:xfrm>
            <a:off x="9913991" y="3429209"/>
            <a:ext cx="1684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PS-R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948AF135-0011-4BB2-B7ED-A6C815C545FE}"/>
              </a:ext>
            </a:extLst>
          </p:cNvPr>
          <p:cNvCxnSpPr>
            <a:cxnSpLocks/>
          </p:cNvCxnSpPr>
          <p:nvPr/>
        </p:nvCxnSpPr>
        <p:spPr>
          <a:xfrm>
            <a:off x="9658076" y="3828264"/>
            <a:ext cx="21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11771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6</TotalTime>
  <Words>1159</Words>
  <Application>Microsoft Office PowerPoint</Application>
  <PresentationFormat>ユーザー設定</PresentationFormat>
  <Paragraphs>883</Paragraphs>
  <Slides>1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7</vt:i4>
      </vt:variant>
    </vt:vector>
  </HeadingPairs>
  <TitlesOfParts>
    <vt:vector size="22" baseType="lpstr">
      <vt:lpstr>ＭＳ 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</dc:creator>
  <cp:lastModifiedBy>Ken</cp:lastModifiedBy>
  <cp:revision>188</cp:revision>
  <dcterms:created xsi:type="dcterms:W3CDTF">2020-06-17T04:14:36Z</dcterms:created>
  <dcterms:modified xsi:type="dcterms:W3CDTF">2020-12-26T01:27:15Z</dcterms:modified>
</cp:coreProperties>
</file>